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6" autoAdjust="0"/>
    <p:restoredTop sz="94660"/>
  </p:normalViewPr>
  <p:slideViewPr>
    <p:cSldViewPr snapToGrid="0" showGuides="1">
      <p:cViewPr varScale="1">
        <p:scale>
          <a:sx n="76" d="100"/>
          <a:sy n="76" d="100"/>
        </p:scale>
        <p:origin x="152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__.xlsx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dirty="0" smtClean="0"/>
              <a:t>5-9</a:t>
            </a:r>
            <a:r>
              <a:rPr lang="en-US" altLang="ja-JP" baseline="0" dirty="0" smtClean="0"/>
              <a:t> years old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8.7473392710982284E-2"/>
          <c:y val="0.1018241469816273"/>
          <c:w val="0.89320434268031346"/>
          <c:h val="0.74557830271216097"/>
        </c:manualLayout>
      </c:layout>
      <c:lineChart>
        <c:grouping val="standard"/>
        <c:varyColors val="0"/>
        <c:ser>
          <c:idx val="1"/>
          <c:order val="1"/>
          <c:tx>
            <c:strRef>
              <c:f>Sheet1!$C$1</c:f>
              <c:strCache>
                <c:ptCount val="1"/>
                <c:pt idx="0">
                  <c:v>The number of influenza cases per week</c:v>
                </c:pt>
              </c:strCache>
            </c:strRef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numRef>
              <c:f>Sheet1!$A$2:$A$314</c:f>
              <c:numCache>
                <c:formatCode>General</c:formatCode>
                <c:ptCount val="31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1</c:v>
                </c:pt>
                <c:pt idx="53">
                  <c:v>2</c:v>
                </c:pt>
                <c:pt idx="54">
                  <c:v>3</c:v>
                </c:pt>
                <c:pt idx="55">
                  <c:v>4</c:v>
                </c:pt>
                <c:pt idx="56">
                  <c:v>5</c:v>
                </c:pt>
                <c:pt idx="57">
                  <c:v>6</c:v>
                </c:pt>
                <c:pt idx="58">
                  <c:v>7</c:v>
                </c:pt>
                <c:pt idx="59">
                  <c:v>8</c:v>
                </c:pt>
                <c:pt idx="60">
                  <c:v>9</c:v>
                </c:pt>
                <c:pt idx="61">
                  <c:v>10</c:v>
                </c:pt>
                <c:pt idx="62">
                  <c:v>11</c:v>
                </c:pt>
                <c:pt idx="63">
                  <c:v>12</c:v>
                </c:pt>
                <c:pt idx="64">
                  <c:v>13</c:v>
                </c:pt>
                <c:pt idx="65">
                  <c:v>14</c:v>
                </c:pt>
                <c:pt idx="66">
                  <c:v>15</c:v>
                </c:pt>
                <c:pt idx="67">
                  <c:v>16</c:v>
                </c:pt>
                <c:pt idx="68">
                  <c:v>17</c:v>
                </c:pt>
                <c:pt idx="69">
                  <c:v>18</c:v>
                </c:pt>
                <c:pt idx="70">
                  <c:v>19</c:v>
                </c:pt>
                <c:pt idx="71">
                  <c:v>20</c:v>
                </c:pt>
                <c:pt idx="72">
                  <c:v>21</c:v>
                </c:pt>
                <c:pt idx="73">
                  <c:v>22</c:v>
                </c:pt>
                <c:pt idx="74">
                  <c:v>23</c:v>
                </c:pt>
                <c:pt idx="75">
                  <c:v>24</c:v>
                </c:pt>
                <c:pt idx="76">
                  <c:v>25</c:v>
                </c:pt>
                <c:pt idx="77">
                  <c:v>26</c:v>
                </c:pt>
                <c:pt idx="78">
                  <c:v>27</c:v>
                </c:pt>
                <c:pt idx="79">
                  <c:v>28</c:v>
                </c:pt>
                <c:pt idx="80">
                  <c:v>29</c:v>
                </c:pt>
                <c:pt idx="81">
                  <c:v>30</c:v>
                </c:pt>
                <c:pt idx="82">
                  <c:v>31</c:v>
                </c:pt>
                <c:pt idx="83">
                  <c:v>32</c:v>
                </c:pt>
                <c:pt idx="84">
                  <c:v>33</c:v>
                </c:pt>
                <c:pt idx="85">
                  <c:v>34</c:v>
                </c:pt>
                <c:pt idx="86">
                  <c:v>35</c:v>
                </c:pt>
                <c:pt idx="87">
                  <c:v>36</c:v>
                </c:pt>
                <c:pt idx="88">
                  <c:v>37</c:v>
                </c:pt>
                <c:pt idx="89">
                  <c:v>38</c:v>
                </c:pt>
                <c:pt idx="90">
                  <c:v>39</c:v>
                </c:pt>
                <c:pt idx="91">
                  <c:v>40</c:v>
                </c:pt>
                <c:pt idx="92">
                  <c:v>41</c:v>
                </c:pt>
                <c:pt idx="93">
                  <c:v>42</c:v>
                </c:pt>
                <c:pt idx="94">
                  <c:v>43</c:v>
                </c:pt>
                <c:pt idx="95">
                  <c:v>44</c:v>
                </c:pt>
                <c:pt idx="96">
                  <c:v>45</c:v>
                </c:pt>
                <c:pt idx="97">
                  <c:v>46</c:v>
                </c:pt>
                <c:pt idx="98">
                  <c:v>47</c:v>
                </c:pt>
                <c:pt idx="99">
                  <c:v>48</c:v>
                </c:pt>
                <c:pt idx="100">
                  <c:v>49</c:v>
                </c:pt>
                <c:pt idx="101">
                  <c:v>50</c:v>
                </c:pt>
                <c:pt idx="102">
                  <c:v>51</c:v>
                </c:pt>
                <c:pt idx="103">
                  <c:v>52</c:v>
                </c:pt>
                <c:pt idx="104">
                  <c:v>1</c:v>
                </c:pt>
                <c:pt idx="105">
                  <c:v>2</c:v>
                </c:pt>
                <c:pt idx="106">
                  <c:v>3</c:v>
                </c:pt>
                <c:pt idx="107">
                  <c:v>4</c:v>
                </c:pt>
                <c:pt idx="108">
                  <c:v>5</c:v>
                </c:pt>
                <c:pt idx="109">
                  <c:v>6</c:v>
                </c:pt>
                <c:pt idx="110">
                  <c:v>7</c:v>
                </c:pt>
                <c:pt idx="111">
                  <c:v>8</c:v>
                </c:pt>
                <c:pt idx="112">
                  <c:v>9</c:v>
                </c:pt>
                <c:pt idx="113">
                  <c:v>10</c:v>
                </c:pt>
                <c:pt idx="114">
                  <c:v>11</c:v>
                </c:pt>
                <c:pt idx="115">
                  <c:v>12</c:v>
                </c:pt>
                <c:pt idx="116">
                  <c:v>13</c:v>
                </c:pt>
                <c:pt idx="117">
                  <c:v>14</c:v>
                </c:pt>
                <c:pt idx="118">
                  <c:v>15</c:v>
                </c:pt>
                <c:pt idx="119">
                  <c:v>16</c:v>
                </c:pt>
                <c:pt idx="120">
                  <c:v>17</c:v>
                </c:pt>
                <c:pt idx="121">
                  <c:v>18</c:v>
                </c:pt>
                <c:pt idx="122">
                  <c:v>19</c:v>
                </c:pt>
                <c:pt idx="123">
                  <c:v>20</c:v>
                </c:pt>
                <c:pt idx="124">
                  <c:v>21</c:v>
                </c:pt>
                <c:pt idx="125">
                  <c:v>22</c:v>
                </c:pt>
                <c:pt idx="126">
                  <c:v>23</c:v>
                </c:pt>
                <c:pt idx="127">
                  <c:v>24</c:v>
                </c:pt>
                <c:pt idx="128">
                  <c:v>25</c:v>
                </c:pt>
                <c:pt idx="129">
                  <c:v>26</c:v>
                </c:pt>
                <c:pt idx="130">
                  <c:v>27</c:v>
                </c:pt>
                <c:pt idx="131">
                  <c:v>28</c:v>
                </c:pt>
                <c:pt idx="132">
                  <c:v>29</c:v>
                </c:pt>
                <c:pt idx="133">
                  <c:v>30</c:v>
                </c:pt>
                <c:pt idx="134">
                  <c:v>31</c:v>
                </c:pt>
                <c:pt idx="135">
                  <c:v>32</c:v>
                </c:pt>
                <c:pt idx="136">
                  <c:v>33</c:v>
                </c:pt>
                <c:pt idx="137">
                  <c:v>34</c:v>
                </c:pt>
                <c:pt idx="138">
                  <c:v>35</c:v>
                </c:pt>
                <c:pt idx="139">
                  <c:v>36</c:v>
                </c:pt>
                <c:pt idx="140">
                  <c:v>37</c:v>
                </c:pt>
                <c:pt idx="141">
                  <c:v>38</c:v>
                </c:pt>
                <c:pt idx="142">
                  <c:v>39</c:v>
                </c:pt>
                <c:pt idx="143">
                  <c:v>40</c:v>
                </c:pt>
                <c:pt idx="144">
                  <c:v>41</c:v>
                </c:pt>
                <c:pt idx="145">
                  <c:v>42</c:v>
                </c:pt>
                <c:pt idx="146">
                  <c:v>43</c:v>
                </c:pt>
                <c:pt idx="147">
                  <c:v>44</c:v>
                </c:pt>
                <c:pt idx="148">
                  <c:v>45</c:v>
                </c:pt>
                <c:pt idx="149">
                  <c:v>46</c:v>
                </c:pt>
                <c:pt idx="150">
                  <c:v>47</c:v>
                </c:pt>
                <c:pt idx="151">
                  <c:v>48</c:v>
                </c:pt>
                <c:pt idx="152">
                  <c:v>49</c:v>
                </c:pt>
                <c:pt idx="153">
                  <c:v>50</c:v>
                </c:pt>
                <c:pt idx="154">
                  <c:v>51</c:v>
                </c:pt>
                <c:pt idx="155">
                  <c:v>52</c:v>
                </c:pt>
                <c:pt idx="156">
                  <c:v>1</c:v>
                </c:pt>
                <c:pt idx="157">
                  <c:v>2</c:v>
                </c:pt>
                <c:pt idx="158">
                  <c:v>3</c:v>
                </c:pt>
                <c:pt idx="159">
                  <c:v>4</c:v>
                </c:pt>
                <c:pt idx="160">
                  <c:v>5</c:v>
                </c:pt>
                <c:pt idx="161">
                  <c:v>6</c:v>
                </c:pt>
                <c:pt idx="162">
                  <c:v>7</c:v>
                </c:pt>
                <c:pt idx="163">
                  <c:v>8</c:v>
                </c:pt>
                <c:pt idx="164">
                  <c:v>9</c:v>
                </c:pt>
                <c:pt idx="165">
                  <c:v>10</c:v>
                </c:pt>
                <c:pt idx="166">
                  <c:v>11</c:v>
                </c:pt>
                <c:pt idx="167">
                  <c:v>12</c:v>
                </c:pt>
                <c:pt idx="168">
                  <c:v>13</c:v>
                </c:pt>
                <c:pt idx="169">
                  <c:v>14</c:v>
                </c:pt>
                <c:pt idx="170">
                  <c:v>15</c:v>
                </c:pt>
                <c:pt idx="171">
                  <c:v>16</c:v>
                </c:pt>
                <c:pt idx="172">
                  <c:v>17</c:v>
                </c:pt>
                <c:pt idx="173">
                  <c:v>18</c:v>
                </c:pt>
                <c:pt idx="174">
                  <c:v>19</c:v>
                </c:pt>
                <c:pt idx="175">
                  <c:v>20</c:v>
                </c:pt>
                <c:pt idx="176">
                  <c:v>21</c:v>
                </c:pt>
                <c:pt idx="177">
                  <c:v>22</c:v>
                </c:pt>
                <c:pt idx="178">
                  <c:v>23</c:v>
                </c:pt>
                <c:pt idx="179">
                  <c:v>24</c:v>
                </c:pt>
                <c:pt idx="180">
                  <c:v>25</c:v>
                </c:pt>
                <c:pt idx="181">
                  <c:v>26</c:v>
                </c:pt>
                <c:pt idx="182">
                  <c:v>27</c:v>
                </c:pt>
                <c:pt idx="183">
                  <c:v>28</c:v>
                </c:pt>
                <c:pt idx="184">
                  <c:v>29</c:v>
                </c:pt>
                <c:pt idx="185">
                  <c:v>30</c:v>
                </c:pt>
                <c:pt idx="186">
                  <c:v>31</c:v>
                </c:pt>
                <c:pt idx="187">
                  <c:v>32</c:v>
                </c:pt>
                <c:pt idx="188">
                  <c:v>33</c:v>
                </c:pt>
                <c:pt idx="189">
                  <c:v>34</c:v>
                </c:pt>
                <c:pt idx="190">
                  <c:v>35</c:v>
                </c:pt>
                <c:pt idx="191">
                  <c:v>36</c:v>
                </c:pt>
                <c:pt idx="192">
                  <c:v>37</c:v>
                </c:pt>
                <c:pt idx="193">
                  <c:v>38</c:v>
                </c:pt>
                <c:pt idx="194">
                  <c:v>39</c:v>
                </c:pt>
                <c:pt idx="195">
                  <c:v>40</c:v>
                </c:pt>
                <c:pt idx="196">
                  <c:v>41</c:v>
                </c:pt>
                <c:pt idx="197">
                  <c:v>42</c:v>
                </c:pt>
                <c:pt idx="198">
                  <c:v>43</c:v>
                </c:pt>
                <c:pt idx="199">
                  <c:v>44</c:v>
                </c:pt>
                <c:pt idx="200">
                  <c:v>45</c:v>
                </c:pt>
                <c:pt idx="201">
                  <c:v>46</c:v>
                </c:pt>
                <c:pt idx="202">
                  <c:v>47</c:v>
                </c:pt>
                <c:pt idx="203">
                  <c:v>48</c:v>
                </c:pt>
                <c:pt idx="204">
                  <c:v>49</c:v>
                </c:pt>
                <c:pt idx="205">
                  <c:v>50</c:v>
                </c:pt>
                <c:pt idx="206">
                  <c:v>51</c:v>
                </c:pt>
                <c:pt idx="207">
                  <c:v>52</c:v>
                </c:pt>
                <c:pt idx="208">
                  <c:v>53</c:v>
                </c:pt>
                <c:pt idx="209">
                  <c:v>1</c:v>
                </c:pt>
                <c:pt idx="210">
                  <c:v>2</c:v>
                </c:pt>
                <c:pt idx="211">
                  <c:v>3</c:v>
                </c:pt>
                <c:pt idx="212">
                  <c:v>4</c:v>
                </c:pt>
                <c:pt idx="213">
                  <c:v>5</c:v>
                </c:pt>
                <c:pt idx="214">
                  <c:v>6</c:v>
                </c:pt>
                <c:pt idx="215">
                  <c:v>7</c:v>
                </c:pt>
                <c:pt idx="216">
                  <c:v>8</c:v>
                </c:pt>
                <c:pt idx="217">
                  <c:v>9</c:v>
                </c:pt>
                <c:pt idx="218">
                  <c:v>10</c:v>
                </c:pt>
                <c:pt idx="219">
                  <c:v>11</c:v>
                </c:pt>
                <c:pt idx="220">
                  <c:v>12</c:v>
                </c:pt>
                <c:pt idx="221">
                  <c:v>13</c:v>
                </c:pt>
                <c:pt idx="222">
                  <c:v>14</c:v>
                </c:pt>
                <c:pt idx="223">
                  <c:v>15</c:v>
                </c:pt>
                <c:pt idx="224">
                  <c:v>16</c:v>
                </c:pt>
                <c:pt idx="225">
                  <c:v>17</c:v>
                </c:pt>
                <c:pt idx="226">
                  <c:v>18</c:v>
                </c:pt>
                <c:pt idx="227">
                  <c:v>19</c:v>
                </c:pt>
                <c:pt idx="228">
                  <c:v>20</c:v>
                </c:pt>
                <c:pt idx="229">
                  <c:v>21</c:v>
                </c:pt>
                <c:pt idx="230">
                  <c:v>22</c:v>
                </c:pt>
                <c:pt idx="231">
                  <c:v>23</c:v>
                </c:pt>
                <c:pt idx="232">
                  <c:v>24</c:v>
                </c:pt>
                <c:pt idx="233">
                  <c:v>25</c:v>
                </c:pt>
                <c:pt idx="234">
                  <c:v>26</c:v>
                </c:pt>
                <c:pt idx="235">
                  <c:v>27</c:v>
                </c:pt>
                <c:pt idx="236">
                  <c:v>28</c:v>
                </c:pt>
                <c:pt idx="237">
                  <c:v>29</c:v>
                </c:pt>
                <c:pt idx="238">
                  <c:v>30</c:v>
                </c:pt>
                <c:pt idx="239">
                  <c:v>31</c:v>
                </c:pt>
                <c:pt idx="240">
                  <c:v>32</c:v>
                </c:pt>
                <c:pt idx="241">
                  <c:v>33</c:v>
                </c:pt>
                <c:pt idx="242">
                  <c:v>34</c:v>
                </c:pt>
                <c:pt idx="243">
                  <c:v>35</c:v>
                </c:pt>
                <c:pt idx="244">
                  <c:v>36</c:v>
                </c:pt>
                <c:pt idx="245">
                  <c:v>37</c:v>
                </c:pt>
                <c:pt idx="246">
                  <c:v>38</c:v>
                </c:pt>
                <c:pt idx="247">
                  <c:v>39</c:v>
                </c:pt>
                <c:pt idx="248">
                  <c:v>40</c:v>
                </c:pt>
                <c:pt idx="249">
                  <c:v>41</c:v>
                </c:pt>
                <c:pt idx="250">
                  <c:v>42</c:v>
                </c:pt>
                <c:pt idx="251">
                  <c:v>43</c:v>
                </c:pt>
                <c:pt idx="252">
                  <c:v>44</c:v>
                </c:pt>
                <c:pt idx="253">
                  <c:v>45</c:v>
                </c:pt>
                <c:pt idx="254">
                  <c:v>46</c:v>
                </c:pt>
                <c:pt idx="255">
                  <c:v>47</c:v>
                </c:pt>
                <c:pt idx="256">
                  <c:v>48</c:v>
                </c:pt>
                <c:pt idx="257">
                  <c:v>49</c:v>
                </c:pt>
                <c:pt idx="258">
                  <c:v>50</c:v>
                </c:pt>
                <c:pt idx="259">
                  <c:v>51</c:v>
                </c:pt>
                <c:pt idx="260">
                  <c:v>52</c:v>
                </c:pt>
                <c:pt idx="261">
                  <c:v>1</c:v>
                </c:pt>
                <c:pt idx="262">
                  <c:v>2</c:v>
                </c:pt>
                <c:pt idx="263">
                  <c:v>3</c:v>
                </c:pt>
                <c:pt idx="264">
                  <c:v>4</c:v>
                </c:pt>
                <c:pt idx="265">
                  <c:v>5</c:v>
                </c:pt>
                <c:pt idx="266">
                  <c:v>6</c:v>
                </c:pt>
                <c:pt idx="267">
                  <c:v>7</c:v>
                </c:pt>
                <c:pt idx="268">
                  <c:v>8</c:v>
                </c:pt>
                <c:pt idx="269">
                  <c:v>9</c:v>
                </c:pt>
                <c:pt idx="270">
                  <c:v>10</c:v>
                </c:pt>
                <c:pt idx="271">
                  <c:v>11</c:v>
                </c:pt>
                <c:pt idx="272">
                  <c:v>12</c:v>
                </c:pt>
                <c:pt idx="273">
                  <c:v>13</c:v>
                </c:pt>
                <c:pt idx="274">
                  <c:v>14</c:v>
                </c:pt>
                <c:pt idx="275">
                  <c:v>15</c:v>
                </c:pt>
                <c:pt idx="276">
                  <c:v>16</c:v>
                </c:pt>
                <c:pt idx="277">
                  <c:v>17</c:v>
                </c:pt>
                <c:pt idx="278">
                  <c:v>18</c:v>
                </c:pt>
                <c:pt idx="279">
                  <c:v>19</c:v>
                </c:pt>
                <c:pt idx="280">
                  <c:v>20</c:v>
                </c:pt>
                <c:pt idx="281">
                  <c:v>21</c:v>
                </c:pt>
                <c:pt idx="282">
                  <c:v>22</c:v>
                </c:pt>
                <c:pt idx="283">
                  <c:v>23</c:v>
                </c:pt>
                <c:pt idx="284">
                  <c:v>24</c:v>
                </c:pt>
                <c:pt idx="285">
                  <c:v>25</c:v>
                </c:pt>
                <c:pt idx="286">
                  <c:v>26</c:v>
                </c:pt>
                <c:pt idx="287">
                  <c:v>27</c:v>
                </c:pt>
                <c:pt idx="288">
                  <c:v>28</c:v>
                </c:pt>
                <c:pt idx="289">
                  <c:v>29</c:v>
                </c:pt>
                <c:pt idx="290">
                  <c:v>30</c:v>
                </c:pt>
                <c:pt idx="291">
                  <c:v>31</c:v>
                </c:pt>
                <c:pt idx="292">
                  <c:v>32</c:v>
                </c:pt>
                <c:pt idx="293">
                  <c:v>33</c:v>
                </c:pt>
                <c:pt idx="294">
                  <c:v>34</c:v>
                </c:pt>
                <c:pt idx="295">
                  <c:v>35</c:v>
                </c:pt>
                <c:pt idx="296">
                  <c:v>36</c:v>
                </c:pt>
                <c:pt idx="297">
                  <c:v>37</c:v>
                </c:pt>
                <c:pt idx="298">
                  <c:v>38</c:v>
                </c:pt>
                <c:pt idx="299">
                  <c:v>39</c:v>
                </c:pt>
                <c:pt idx="300">
                  <c:v>40</c:v>
                </c:pt>
                <c:pt idx="301">
                  <c:v>41</c:v>
                </c:pt>
                <c:pt idx="302">
                  <c:v>42</c:v>
                </c:pt>
                <c:pt idx="303">
                  <c:v>43</c:v>
                </c:pt>
                <c:pt idx="304">
                  <c:v>44</c:v>
                </c:pt>
                <c:pt idx="305">
                  <c:v>45</c:v>
                </c:pt>
                <c:pt idx="306">
                  <c:v>46</c:v>
                </c:pt>
                <c:pt idx="307">
                  <c:v>47</c:v>
                </c:pt>
                <c:pt idx="308">
                  <c:v>48</c:v>
                </c:pt>
                <c:pt idx="309">
                  <c:v>49</c:v>
                </c:pt>
                <c:pt idx="310">
                  <c:v>50</c:v>
                </c:pt>
                <c:pt idx="311">
                  <c:v>51</c:v>
                </c:pt>
                <c:pt idx="312">
                  <c:v>52</c:v>
                </c:pt>
              </c:numCache>
            </c:numRef>
          </c:cat>
          <c:val>
            <c:numRef>
              <c:f>Sheet1!$C$2:$C$314</c:f>
              <c:numCache>
                <c:formatCode>General</c:formatCode>
                <c:ptCount val="313"/>
                <c:pt idx="0">
                  <c:v>311</c:v>
                </c:pt>
                <c:pt idx="1">
                  <c:v>853</c:v>
                </c:pt>
                <c:pt idx="2">
                  <c:v>3472</c:v>
                </c:pt>
                <c:pt idx="3">
                  <c:v>5335</c:v>
                </c:pt>
                <c:pt idx="4">
                  <c:v>5089</c:v>
                </c:pt>
                <c:pt idx="5">
                  <c:v>3517</c:v>
                </c:pt>
                <c:pt idx="6">
                  <c:v>2841</c:v>
                </c:pt>
                <c:pt idx="7">
                  <c:v>2430</c:v>
                </c:pt>
                <c:pt idx="8">
                  <c:v>2484</c:v>
                </c:pt>
                <c:pt idx="9">
                  <c:v>2571</c:v>
                </c:pt>
                <c:pt idx="10">
                  <c:v>2147</c:v>
                </c:pt>
                <c:pt idx="11">
                  <c:v>1816</c:v>
                </c:pt>
                <c:pt idx="12">
                  <c:v>1066</c:v>
                </c:pt>
                <c:pt idx="13">
                  <c:v>531</c:v>
                </c:pt>
                <c:pt idx="14">
                  <c:v>366</c:v>
                </c:pt>
                <c:pt idx="15">
                  <c:v>314</c:v>
                </c:pt>
                <c:pt idx="16">
                  <c:v>224</c:v>
                </c:pt>
                <c:pt idx="17">
                  <c:v>59</c:v>
                </c:pt>
                <c:pt idx="18">
                  <c:v>30</c:v>
                </c:pt>
                <c:pt idx="19">
                  <c:v>12</c:v>
                </c:pt>
                <c:pt idx="20">
                  <c:v>12</c:v>
                </c:pt>
                <c:pt idx="21">
                  <c:v>3</c:v>
                </c:pt>
                <c:pt idx="22">
                  <c:v>3</c:v>
                </c:pt>
                <c:pt idx="23">
                  <c:v>1</c:v>
                </c:pt>
                <c:pt idx="24">
                  <c:v>2</c:v>
                </c:pt>
                <c:pt idx="25">
                  <c:v>3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1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1</c:v>
                </c:pt>
                <c:pt idx="35">
                  <c:v>2</c:v>
                </c:pt>
                <c:pt idx="36">
                  <c:v>4</c:v>
                </c:pt>
                <c:pt idx="37">
                  <c:v>0</c:v>
                </c:pt>
                <c:pt idx="38">
                  <c:v>0</c:v>
                </c:pt>
                <c:pt idx="39">
                  <c:v>1</c:v>
                </c:pt>
                <c:pt idx="40">
                  <c:v>2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2</c:v>
                </c:pt>
                <c:pt idx="46">
                  <c:v>5</c:v>
                </c:pt>
                <c:pt idx="47">
                  <c:v>14</c:v>
                </c:pt>
                <c:pt idx="48">
                  <c:v>24</c:v>
                </c:pt>
                <c:pt idx="49">
                  <c:v>86</c:v>
                </c:pt>
                <c:pt idx="50">
                  <c:v>87</c:v>
                </c:pt>
                <c:pt idx="51">
                  <c:v>49</c:v>
                </c:pt>
                <c:pt idx="52">
                  <c:v>44</c:v>
                </c:pt>
                <c:pt idx="53">
                  <c:v>279</c:v>
                </c:pt>
                <c:pt idx="54">
                  <c:v>809</c:v>
                </c:pt>
                <c:pt idx="55">
                  <c:v>1974</c:v>
                </c:pt>
                <c:pt idx="56">
                  <c:v>2373</c:v>
                </c:pt>
                <c:pt idx="57">
                  <c:v>1935</c:v>
                </c:pt>
                <c:pt idx="58">
                  <c:v>1187</c:v>
                </c:pt>
                <c:pt idx="59">
                  <c:v>1169</c:v>
                </c:pt>
                <c:pt idx="60">
                  <c:v>1124</c:v>
                </c:pt>
                <c:pt idx="61">
                  <c:v>917</c:v>
                </c:pt>
                <c:pt idx="62">
                  <c:v>776</c:v>
                </c:pt>
                <c:pt idx="63">
                  <c:v>614</c:v>
                </c:pt>
                <c:pt idx="64">
                  <c:v>437</c:v>
                </c:pt>
                <c:pt idx="65">
                  <c:v>236</c:v>
                </c:pt>
                <c:pt idx="66">
                  <c:v>175</c:v>
                </c:pt>
                <c:pt idx="67">
                  <c:v>377</c:v>
                </c:pt>
                <c:pt idx="68">
                  <c:v>361</c:v>
                </c:pt>
                <c:pt idx="69">
                  <c:v>286</c:v>
                </c:pt>
                <c:pt idx="70">
                  <c:v>241</c:v>
                </c:pt>
                <c:pt idx="71">
                  <c:v>266</c:v>
                </c:pt>
                <c:pt idx="72">
                  <c:v>148</c:v>
                </c:pt>
                <c:pt idx="73">
                  <c:v>65</c:v>
                </c:pt>
                <c:pt idx="74">
                  <c:v>29</c:v>
                </c:pt>
                <c:pt idx="75">
                  <c:v>8</c:v>
                </c:pt>
                <c:pt idx="76">
                  <c:v>9</c:v>
                </c:pt>
                <c:pt idx="77">
                  <c:v>0</c:v>
                </c:pt>
                <c:pt idx="78">
                  <c:v>2</c:v>
                </c:pt>
                <c:pt idx="79">
                  <c:v>3</c:v>
                </c:pt>
                <c:pt idx="80">
                  <c:v>2</c:v>
                </c:pt>
                <c:pt idx="81">
                  <c:v>1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2</c:v>
                </c:pt>
                <c:pt idx="90">
                  <c:v>0</c:v>
                </c:pt>
                <c:pt idx="91">
                  <c:v>0</c:v>
                </c:pt>
                <c:pt idx="92">
                  <c:v>1</c:v>
                </c:pt>
                <c:pt idx="93">
                  <c:v>2</c:v>
                </c:pt>
                <c:pt idx="94">
                  <c:v>1</c:v>
                </c:pt>
                <c:pt idx="95">
                  <c:v>2</c:v>
                </c:pt>
                <c:pt idx="96">
                  <c:v>0</c:v>
                </c:pt>
                <c:pt idx="97">
                  <c:v>6</c:v>
                </c:pt>
                <c:pt idx="98">
                  <c:v>6</c:v>
                </c:pt>
                <c:pt idx="99">
                  <c:v>33</c:v>
                </c:pt>
                <c:pt idx="100">
                  <c:v>44</c:v>
                </c:pt>
                <c:pt idx="101">
                  <c:v>39</c:v>
                </c:pt>
                <c:pt idx="102">
                  <c:v>94</c:v>
                </c:pt>
                <c:pt idx="103">
                  <c:v>115</c:v>
                </c:pt>
                <c:pt idx="104">
                  <c:v>66</c:v>
                </c:pt>
                <c:pt idx="105">
                  <c:v>442</c:v>
                </c:pt>
                <c:pt idx="106">
                  <c:v>1243</c:v>
                </c:pt>
                <c:pt idx="107">
                  <c:v>2479</c:v>
                </c:pt>
                <c:pt idx="108">
                  <c:v>3051</c:v>
                </c:pt>
                <c:pt idx="109">
                  <c:v>2382</c:v>
                </c:pt>
                <c:pt idx="110">
                  <c:v>2131</c:v>
                </c:pt>
                <c:pt idx="111">
                  <c:v>2011</c:v>
                </c:pt>
                <c:pt idx="112">
                  <c:v>2667</c:v>
                </c:pt>
                <c:pt idx="113">
                  <c:v>2270</c:v>
                </c:pt>
                <c:pt idx="114">
                  <c:v>2390</c:v>
                </c:pt>
                <c:pt idx="115">
                  <c:v>1823</c:v>
                </c:pt>
                <c:pt idx="116">
                  <c:v>980</c:v>
                </c:pt>
                <c:pt idx="117">
                  <c:v>392</c:v>
                </c:pt>
                <c:pt idx="118">
                  <c:v>241</c:v>
                </c:pt>
                <c:pt idx="119">
                  <c:v>289</c:v>
                </c:pt>
                <c:pt idx="120">
                  <c:v>210</c:v>
                </c:pt>
                <c:pt idx="121">
                  <c:v>138</c:v>
                </c:pt>
                <c:pt idx="122">
                  <c:v>60</c:v>
                </c:pt>
                <c:pt idx="123">
                  <c:v>34</c:v>
                </c:pt>
                <c:pt idx="124">
                  <c:v>38</c:v>
                </c:pt>
                <c:pt idx="125">
                  <c:v>21</c:v>
                </c:pt>
                <c:pt idx="126">
                  <c:v>11</c:v>
                </c:pt>
                <c:pt idx="127">
                  <c:v>3</c:v>
                </c:pt>
                <c:pt idx="128">
                  <c:v>3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2</c:v>
                </c:pt>
                <c:pt idx="135">
                  <c:v>2</c:v>
                </c:pt>
                <c:pt idx="136">
                  <c:v>0</c:v>
                </c:pt>
                <c:pt idx="137">
                  <c:v>1</c:v>
                </c:pt>
                <c:pt idx="138">
                  <c:v>2</c:v>
                </c:pt>
                <c:pt idx="139">
                  <c:v>2</c:v>
                </c:pt>
                <c:pt idx="140">
                  <c:v>10</c:v>
                </c:pt>
                <c:pt idx="141">
                  <c:v>1</c:v>
                </c:pt>
                <c:pt idx="142">
                  <c:v>3</c:v>
                </c:pt>
                <c:pt idx="143">
                  <c:v>4</c:v>
                </c:pt>
                <c:pt idx="144">
                  <c:v>2</c:v>
                </c:pt>
                <c:pt idx="145">
                  <c:v>4</c:v>
                </c:pt>
                <c:pt idx="146">
                  <c:v>15</c:v>
                </c:pt>
                <c:pt idx="147">
                  <c:v>15</c:v>
                </c:pt>
                <c:pt idx="148">
                  <c:v>22</c:v>
                </c:pt>
                <c:pt idx="149">
                  <c:v>18</c:v>
                </c:pt>
                <c:pt idx="150">
                  <c:v>95</c:v>
                </c:pt>
                <c:pt idx="151">
                  <c:v>157</c:v>
                </c:pt>
                <c:pt idx="152">
                  <c:v>290</c:v>
                </c:pt>
                <c:pt idx="153">
                  <c:v>831</c:v>
                </c:pt>
                <c:pt idx="154">
                  <c:v>1925</c:v>
                </c:pt>
                <c:pt idx="155">
                  <c:v>3468</c:v>
                </c:pt>
                <c:pt idx="156">
                  <c:v>961</c:v>
                </c:pt>
                <c:pt idx="157">
                  <c:v>1718</c:v>
                </c:pt>
                <c:pt idx="158">
                  <c:v>2390</c:v>
                </c:pt>
                <c:pt idx="159">
                  <c:v>2999</c:v>
                </c:pt>
                <c:pt idx="160">
                  <c:v>2219</c:v>
                </c:pt>
                <c:pt idx="161">
                  <c:v>1418</c:v>
                </c:pt>
                <c:pt idx="162">
                  <c:v>808</c:v>
                </c:pt>
                <c:pt idx="163">
                  <c:v>474</c:v>
                </c:pt>
                <c:pt idx="164">
                  <c:v>351</c:v>
                </c:pt>
                <c:pt idx="165">
                  <c:v>344</c:v>
                </c:pt>
                <c:pt idx="166">
                  <c:v>319</c:v>
                </c:pt>
                <c:pt idx="167">
                  <c:v>326</c:v>
                </c:pt>
                <c:pt idx="168">
                  <c:v>208</c:v>
                </c:pt>
                <c:pt idx="169">
                  <c:v>166</c:v>
                </c:pt>
                <c:pt idx="170">
                  <c:v>118</c:v>
                </c:pt>
                <c:pt idx="171">
                  <c:v>156</c:v>
                </c:pt>
                <c:pt idx="172">
                  <c:v>155</c:v>
                </c:pt>
                <c:pt idx="173">
                  <c:v>107</c:v>
                </c:pt>
                <c:pt idx="174">
                  <c:v>46</c:v>
                </c:pt>
                <c:pt idx="175">
                  <c:v>29</c:v>
                </c:pt>
                <c:pt idx="176">
                  <c:v>25</c:v>
                </c:pt>
                <c:pt idx="177">
                  <c:v>14</c:v>
                </c:pt>
                <c:pt idx="178">
                  <c:v>6</c:v>
                </c:pt>
                <c:pt idx="179">
                  <c:v>7</c:v>
                </c:pt>
                <c:pt idx="180">
                  <c:v>2</c:v>
                </c:pt>
                <c:pt idx="181">
                  <c:v>2</c:v>
                </c:pt>
                <c:pt idx="182">
                  <c:v>2</c:v>
                </c:pt>
                <c:pt idx="183">
                  <c:v>1</c:v>
                </c:pt>
                <c:pt idx="184">
                  <c:v>3</c:v>
                </c:pt>
                <c:pt idx="185">
                  <c:v>0</c:v>
                </c:pt>
                <c:pt idx="186">
                  <c:v>2</c:v>
                </c:pt>
                <c:pt idx="187">
                  <c:v>1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3</c:v>
                </c:pt>
                <c:pt idx="192">
                  <c:v>0</c:v>
                </c:pt>
                <c:pt idx="193">
                  <c:v>0</c:v>
                </c:pt>
                <c:pt idx="194">
                  <c:v>2</c:v>
                </c:pt>
                <c:pt idx="195">
                  <c:v>0</c:v>
                </c:pt>
                <c:pt idx="196">
                  <c:v>4</c:v>
                </c:pt>
                <c:pt idx="197">
                  <c:v>1</c:v>
                </c:pt>
                <c:pt idx="198">
                  <c:v>5</c:v>
                </c:pt>
                <c:pt idx="199">
                  <c:v>2</c:v>
                </c:pt>
                <c:pt idx="200">
                  <c:v>5</c:v>
                </c:pt>
                <c:pt idx="201">
                  <c:v>7</c:v>
                </c:pt>
                <c:pt idx="202">
                  <c:v>2</c:v>
                </c:pt>
                <c:pt idx="203">
                  <c:v>10</c:v>
                </c:pt>
                <c:pt idx="204">
                  <c:v>10</c:v>
                </c:pt>
                <c:pt idx="205">
                  <c:v>18</c:v>
                </c:pt>
                <c:pt idx="206">
                  <c:v>36</c:v>
                </c:pt>
                <c:pt idx="207">
                  <c:v>47</c:v>
                </c:pt>
                <c:pt idx="208">
                  <c:v>35</c:v>
                </c:pt>
                <c:pt idx="209">
                  <c:v>100</c:v>
                </c:pt>
                <c:pt idx="210">
                  <c:v>256</c:v>
                </c:pt>
                <c:pt idx="211">
                  <c:v>1041</c:v>
                </c:pt>
                <c:pt idx="212">
                  <c:v>2561</c:v>
                </c:pt>
                <c:pt idx="213">
                  <c:v>3808</c:v>
                </c:pt>
                <c:pt idx="214">
                  <c:v>4637</c:v>
                </c:pt>
                <c:pt idx="215">
                  <c:v>4336</c:v>
                </c:pt>
                <c:pt idx="216">
                  <c:v>4615</c:v>
                </c:pt>
                <c:pt idx="217">
                  <c:v>4413</c:v>
                </c:pt>
                <c:pt idx="218">
                  <c:v>3072</c:v>
                </c:pt>
                <c:pt idx="219">
                  <c:v>1853</c:v>
                </c:pt>
                <c:pt idx="220">
                  <c:v>966</c:v>
                </c:pt>
                <c:pt idx="221">
                  <c:v>554</c:v>
                </c:pt>
                <c:pt idx="222">
                  <c:v>305</c:v>
                </c:pt>
                <c:pt idx="223">
                  <c:v>150</c:v>
                </c:pt>
                <c:pt idx="224">
                  <c:v>137</c:v>
                </c:pt>
                <c:pt idx="225">
                  <c:v>64</c:v>
                </c:pt>
                <c:pt idx="226">
                  <c:v>18</c:v>
                </c:pt>
                <c:pt idx="227">
                  <c:v>6</c:v>
                </c:pt>
                <c:pt idx="228">
                  <c:v>3</c:v>
                </c:pt>
                <c:pt idx="229">
                  <c:v>0</c:v>
                </c:pt>
                <c:pt idx="230">
                  <c:v>1</c:v>
                </c:pt>
                <c:pt idx="231">
                  <c:v>0</c:v>
                </c:pt>
                <c:pt idx="232">
                  <c:v>2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4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1</c:v>
                </c:pt>
                <c:pt idx="244">
                  <c:v>1</c:v>
                </c:pt>
                <c:pt idx="245">
                  <c:v>1</c:v>
                </c:pt>
                <c:pt idx="246">
                  <c:v>1</c:v>
                </c:pt>
                <c:pt idx="247">
                  <c:v>1</c:v>
                </c:pt>
                <c:pt idx="248">
                  <c:v>6</c:v>
                </c:pt>
                <c:pt idx="249">
                  <c:v>5</c:v>
                </c:pt>
                <c:pt idx="250">
                  <c:v>14</c:v>
                </c:pt>
                <c:pt idx="251">
                  <c:v>5</c:v>
                </c:pt>
                <c:pt idx="252">
                  <c:v>13</c:v>
                </c:pt>
                <c:pt idx="253">
                  <c:v>40</c:v>
                </c:pt>
                <c:pt idx="254">
                  <c:v>71</c:v>
                </c:pt>
                <c:pt idx="255">
                  <c:v>130</c:v>
                </c:pt>
                <c:pt idx="256">
                  <c:v>181</c:v>
                </c:pt>
                <c:pt idx="257">
                  <c:v>203</c:v>
                </c:pt>
                <c:pt idx="258">
                  <c:v>284</c:v>
                </c:pt>
                <c:pt idx="259">
                  <c:v>423</c:v>
                </c:pt>
                <c:pt idx="260">
                  <c:v>306</c:v>
                </c:pt>
                <c:pt idx="261">
                  <c:v>384</c:v>
                </c:pt>
                <c:pt idx="262">
                  <c:v>860</c:v>
                </c:pt>
                <c:pt idx="263">
                  <c:v>2350</c:v>
                </c:pt>
                <c:pt idx="264">
                  <c:v>4044</c:v>
                </c:pt>
                <c:pt idx="265">
                  <c:v>3982</c:v>
                </c:pt>
                <c:pt idx="266">
                  <c:v>2667</c:v>
                </c:pt>
                <c:pt idx="267">
                  <c:v>1911</c:v>
                </c:pt>
                <c:pt idx="268">
                  <c:v>1073</c:v>
                </c:pt>
                <c:pt idx="269">
                  <c:v>711</c:v>
                </c:pt>
                <c:pt idx="270">
                  <c:v>511</c:v>
                </c:pt>
                <c:pt idx="271">
                  <c:v>374</c:v>
                </c:pt>
                <c:pt idx="272">
                  <c:v>244</c:v>
                </c:pt>
                <c:pt idx="273">
                  <c:v>203</c:v>
                </c:pt>
                <c:pt idx="274">
                  <c:v>132</c:v>
                </c:pt>
                <c:pt idx="275">
                  <c:v>151</c:v>
                </c:pt>
                <c:pt idx="276">
                  <c:v>167</c:v>
                </c:pt>
                <c:pt idx="277">
                  <c:v>167</c:v>
                </c:pt>
                <c:pt idx="278">
                  <c:v>141</c:v>
                </c:pt>
                <c:pt idx="279">
                  <c:v>62</c:v>
                </c:pt>
                <c:pt idx="280">
                  <c:v>28</c:v>
                </c:pt>
                <c:pt idx="281">
                  <c:v>25</c:v>
                </c:pt>
                <c:pt idx="282">
                  <c:v>18</c:v>
                </c:pt>
                <c:pt idx="283">
                  <c:v>10</c:v>
                </c:pt>
                <c:pt idx="284">
                  <c:v>11</c:v>
                </c:pt>
                <c:pt idx="285">
                  <c:v>16</c:v>
                </c:pt>
                <c:pt idx="286">
                  <c:v>2</c:v>
                </c:pt>
                <c:pt idx="287">
                  <c:v>1</c:v>
                </c:pt>
                <c:pt idx="288">
                  <c:v>6</c:v>
                </c:pt>
                <c:pt idx="289">
                  <c:v>4</c:v>
                </c:pt>
                <c:pt idx="290">
                  <c:v>0</c:v>
                </c:pt>
                <c:pt idx="291">
                  <c:v>4</c:v>
                </c:pt>
                <c:pt idx="292">
                  <c:v>3</c:v>
                </c:pt>
                <c:pt idx="293">
                  <c:v>4</c:v>
                </c:pt>
                <c:pt idx="294">
                  <c:v>7</c:v>
                </c:pt>
                <c:pt idx="295">
                  <c:v>17</c:v>
                </c:pt>
                <c:pt idx="296">
                  <c:v>7</c:v>
                </c:pt>
                <c:pt idx="297">
                  <c:v>8</c:v>
                </c:pt>
                <c:pt idx="298">
                  <c:v>4</c:v>
                </c:pt>
                <c:pt idx="299">
                  <c:v>11</c:v>
                </c:pt>
                <c:pt idx="300">
                  <c:v>18</c:v>
                </c:pt>
                <c:pt idx="301">
                  <c:v>9</c:v>
                </c:pt>
                <c:pt idx="302">
                  <c:v>14</c:v>
                </c:pt>
                <c:pt idx="303">
                  <c:v>22</c:v>
                </c:pt>
                <c:pt idx="304">
                  <c:v>32</c:v>
                </c:pt>
                <c:pt idx="305">
                  <c:v>29</c:v>
                </c:pt>
                <c:pt idx="306">
                  <c:v>45</c:v>
                </c:pt>
                <c:pt idx="307">
                  <c:v>75</c:v>
                </c:pt>
                <c:pt idx="308">
                  <c:v>203</c:v>
                </c:pt>
                <c:pt idx="309">
                  <c:v>331</c:v>
                </c:pt>
                <c:pt idx="310">
                  <c:v>684</c:v>
                </c:pt>
                <c:pt idx="311">
                  <c:v>1220</c:v>
                </c:pt>
                <c:pt idx="312">
                  <c:v>117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B3D-4EC0-A8D6-5E64F831BF17}"/>
            </c:ext>
          </c:extLst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The predict number of influenza patients calculated from regression model</c:v>
                </c:pt>
              </c:strCache>
            </c:strRef>
          </c:tx>
          <c:spPr>
            <a:ln w="28575" cap="rnd">
              <a:solidFill>
                <a:srgbClr val="00206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002060"/>
              </a:solidFill>
              <a:ln w="9525">
                <a:solidFill>
                  <a:srgbClr val="002060"/>
                </a:solidFill>
              </a:ln>
              <a:effectLst/>
            </c:spPr>
          </c:marker>
          <c:cat>
            <c:numRef>
              <c:f>Sheet1!$A$2:$A$314</c:f>
              <c:numCache>
                <c:formatCode>General</c:formatCode>
                <c:ptCount val="313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  <c:pt idx="36">
                  <c:v>37</c:v>
                </c:pt>
                <c:pt idx="37">
                  <c:v>38</c:v>
                </c:pt>
                <c:pt idx="38">
                  <c:v>39</c:v>
                </c:pt>
                <c:pt idx="39">
                  <c:v>40</c:v>
                </c:pt>
                <c:pt idx="40">
                  <c:v>41</c:v>
                </c:pt>
                <c:pt idx="41">
                  <c:v>42</c:v>
                </c:pt>
                <c:pt idx="42">
                  <c:v>43</c:v>
                </c:pt>
                <c:pt idx="43">
                  <c:v>44</c:v>
                </c:pt>
                <c:pt idx="44">
                  <c:v>45</c:v>
                </c:pt>
                <c:pt idx="45">
                  <c:v>46</c:v>
                </c:pt>
                <c:pt idx="46">
                  <c:v>47</c:v>
                </c:pt>
                <c:pt idx="47">
                  <c:v>48</c:v>
                </c:pt>
                <c:pt idx="48">
                  <c:v>49</c:v>
                </c:pt>
                <c:pt idx="49">
                  <c:v>50</c:v>
                </c:pt>
                <c:pt idx="50">
                  <c:v>51</c:v>
                </c:pt>
                <c:pt idx="51">
                  <c:v>52</c:v>
                </c:pt>
                <c:pt idx="52">
                  <c:v>1</c:v>
                </c:pt>
                <c:pt idx="53">
                  <c:v>2</c:v>
                </c:pt>
                <c:pt idx="54">
                  <c:v>3</c:v>
                </c:pt>
                <c:pt idx="55">
                  <c:v>4</c:v>
                </c:pt>
                <c:pt idx="56">
                  <c:v>5</c:v>
                </c:pt>
                <c:pt idx="57">
                  <c:v>6</c:v>
                </c:pt>
                <c:pt idx="58">
                  <c:v>7</c:v>
                </c:pt>
                <c:pt idx="59">
                  <c:v>8</c:v>
                </c:pt>
                <c:pt idx="60">
                  <c:v>9</c:v>
                </c:pt>
                <c:pt idx="61">
                  <c:v>10</c:v>
                </c:pt>
                <c:pt idx="62">
                  <c:v>11</c:v>
                </c:pt>
                <c:pt idx="63">
                  <c:v>12</c:v>
                </c:pt>
                <c:pt idx="64">
                  <c:v>13</c:v>
                </c:pt>
                <c:pt idx="65">
                  <c:v>14</c:v>
                </c:pt>
                <c:pt idx="66">
                  <c:v>15</c:v>
                </c:pt>
                <c:pt idx="67">
                  <c:v>16</c:v>
                </c:pt>
                <c:pt idx="68">
                  <c:v>17</c:v>
                </c:pt>
                <c:pt idx="69">
                  <c:v>18</c:v>
                </c:pt>
                <c:pt idx="70">
                  <c:v>19</c:v>
                </c:pt>
                <c:pt idx="71">
                  <c:v>20</c:v>
                </c:pt>
                <c:pt idx="72">
                  <c:v>21</c:v>
                </c:pt>
                <c:pt idx="73">
                  <c:v>22</c:v>
                </c:pt>
                <c:pt idx="74">
                  <c:v>23</c:v>
                </c:pt>
                <c:pt idx="75">
                  <c:v>24</c:v>
                </c:pt>
                <c:pt idx="76">
                  <c:v>25</c:v>
                </c:pt>
                <c:pt idx="77">
                  <c:v>26</c:v>
                </c:pt>
                <c:pt idx="78">
                  <c:v>27</c:v>
                </c:pt>
                <c:pt idx="79">
                  <c:v>28</c:v>
                </c:pt>
                <c:pt idx="80">
                  <c:v>29</c:v>
                </c:pt>
                <c:pt idx="81">
                  <c:v>30</c:v>
                </c:pt>
                <c:pt idx="82">
                  <c:v>31</c:v>
                </c:pt>
                <c:pt idx="83">
                  <c:v>32</c:v>
                </c:pt>
                <c:pt idx="84">
                  <c:v>33</c:v>
                </c:pt>
                <c:pt idx="85">
                  <c:v>34</c:v>
                </c:pt>
                <c:pt idx="86">
                  <c:v>35</c:v>
                </c:pt>
                <c:pt idx="87">
                  <c:v>36</c:v>
                </c:pt>
                <c:pt idx="88">
                  <c:v>37</c:v>
                </c:pt>
                <c:pt idx="89">
                  <c:v>38</c:v>
                </c:pt>
                <c:pt idx="90">
                  <c:v>39</c:v>
                </c:pt>
                <c:pt idx="91">
                  <c:v>40</c:v>
                </c:pt>
                <c:pt idx="92">
                  <c:v>41</c:v>
                </c:pt>
                <c:pt idx="93">
                  <c:v>42</c:v>
                </c:pt>
                <c:pt idx="94">
                  <c:v>43</c:v>
                </c:pt>
                <c:pt idx="95">
                  <c:v>44</c:v>
                </c:pt>
                <c:pt idx="96">
                  <c:v>45</c:v>
                </c:pt>
                <c:pt idx="97">
                  <c:v>46</c:v>
                </c:pt>
                <c:pt idx="98">
                  <c:v>47</c:v>
                </c:pt>
                <c:pt idx="99">
                  <c:v>48</c:v>
                </c:pt>
                <c:pt idx="100">
                  <c:v>49</c:v>
                </c:pt>
                <c:pt idx="101">
                  <c:v>50</c:v>
                </c:pt>
                <c:pt idx="102">
                  <c:v>51</c:v>
                </c:pt>
                <c:pt idx="103">
                  <c:v>52</c:v>
                </c:pt>
                <c:pt idx="104">
                  <c:v>1</c:v>
                </c:pt>
                <c:pt idx="105">
                  <c:v>2</c:v>
                </c:pt>
                <c:pt idx="106">
                  <c:v>3</c:v>
                </c:pt>
                <c:pt idx="107">
                  <c:v>4</c:v>
                </c:pt>
                <c:pt idx="108">
                  <c:v>5</c:v>
                </c:pt>
                <c:pt idx="109">
                  <c:v>6</c:v>
                </c:pt>
                <c:pt idx="110">
                  <c:v>7</c:v>
                </c:pt>
                <c:pt idx="111">
                  <c:v>8</c:v>
                </c:pt>
                <c:pt idx="112">
                  <c:v>9</c:v>
                </c:pt>
                <c:pt idx="113">
                  <c:v>10</c:v>
                </c:pt>
                <c:pt idx="114">
                  <c:v>11</c:v>
                </c:pt>
                <c:pt idx="115">
                  <c:v>12</c:v>
                </c:pt>
                <c:pt idx="116">
                  <c:v>13</c:v>
                </c:pt>
                <c:pt idx="117">
                  <c:v>14</c:v>
                </c:pt>
                <c:pt idx="118">
                  <c:v>15</c:v>
                </c:pt>
                <c:pt idx="119">
                  <c:v>16</c:v>
                </c:pt>
                <c:pt idx="120">
                  <c:v>17</c:v>
                </c:pt>
                <c:pt idx="121">
                  <c:v>18</c:v>
                </c:pt>
                <c:pt idx="122">
                  <c:v>19</c:v>
                </c:pt>
                <c:pt idx="123">
                  <c:v>20</c:v>
                </c:pt>
                <c:pt idx="124">
                  <c:v>21</c:v>
                </c:pt>
                <c:pt idx="125">
                  <c:v>22</c:v>
                </c:pt>
                <c:pt idx="126">
                  <c:v>23</c:v>
                </c:pt>
                <c:pt idx="127">
                  <c:v>24</c:v>
                </c:pt>
                <c:pt idx="128">
                  <c:v>25</c:v>
                </c:pt>
                <c:pt idx="129">
                  <c:v>26</c:v>
                </c:pt>
                <c:pt idx="130">
                  <c:v>27</c:v>
                </c:pt>
                <c:pt idx="131">
                  <c:v>28</c:v>
                </c:pt>
                <c:pt idx="132">
                  <c:v>29</c:v>
                </c:pt>
                <c:pt idx="133">
                  <c:v>30</c:v>
                </c:pt>
                <c:pt idx="134">
                  <c:v>31</c:v>
                </c:pt>
                <c:pt idx="135">
                  <c:v>32</c:v>
                </c:pt>
                <c:pt idx="136">
                  <c:v>33</c:v>
                </c:pt>
                <c:pt idx="137">
                  <c:v>34</c:v>
                </c:pt>
                <c:pt idx="138">
                  <c:v>35</c:v>
                </c:pt>
                <c:pt idx="139">
                  <c:v>36</c:v>
                </c:pt>
                <c:pt idx="140">
                  <c:v>37</c:v>
                </c:pt>
                <c:pt idx="141">
                  <c:v>38</c:v>
                </c:pt>
                <c:pt idx="142">
                  <c:v>39</c:v>
                </c:pt>
                <c:pt idx="143">
                  <c:v>40</c:v>
                </c:pt>
                <c:pt idx="144">
                  <c:v>41</c:v>
                </c:pt>
                <c:pt idx="145">
                  <c:v>42</c:v>
                </c:pt>
                <c:pt idx="146">
                  <c:v>43</c:v>
                </c:pt>
                <c:pt idx="147">
                  <c:v>44</c:v>
                </c:pt>
                <c:pt idx="148">
                  <c:v>45</c:v>
                </c:pt>
                <c:pt idx="149">
                  <c:v>46</c:v>
                </c:pt>
                <c:pt idx="150">
                  <c:v>47</c:v>
                </c:pt>
                <c:pt idx="151">
                  <c:v>48</c:v>
                </c:pt>
                <c:pt idx="152">
                  <c:v>49</c:v>
                </c:pt>
                <c:pt idx="153">
                  <c:v>50</c:v>
                </c:pt>
                <c:pt idx="154">
                  <c:v>51</c:v>
                </c:pt>
                <c:pt idx="155">
                  <c:v>52</c:v>
                </c:pt>
                <c:pt idx="156">
                  <c:v>1</c:v>
                </c:pt>
                <c:pt idx="157">
                  <c:v>2</c:v>
                </c:pt>
                <c:pt idx="158">
                  <c:v>3</c:v>
                </c:pt>
                <c:pt idx="159">
                  <c:v>4</c:v>
                </c:pt>
                <c:pt idx="160">
                  <c:v>5</c:v>
                </c:pt>
                <c:pt idx="161">
                  <c:v>6</c:v>
                </c:pt>
                <c:pt idx="162">
                  <c:v>7</c:v>
                </c:pt>
                <c:pt idx="163">
                  <c:v>8</c:v>
                </c:pt>
                <c:pt idx="164">
                  <c:v>9</c:v>
                </c:pt>
                <c:pt idx="165">
                  <c:v>10</c:v>
                </c:pt>
                <c:pt idx="166">
                  <c:v>11</c:v>
                </c:pt>
                <c:pt idx="167">
                  <c:v>12</c:v>
                </c:pt>
                <c:pt idx="168">
                  <c:v>13</c:v>
                </c:pt>
                <c:pt idx="169">
                  <c:v>14</c:v>
                </c:pt>
                <c:pt idx="170">
                  <c:v>15</c:v>
                </c:pt>
                <c:pt idx="171">
                  <c:v>16</c:v>
                </c:pt>
                <c:pt idx="172">
                  <c:v>17</c:v>
                </c:pt>
                <c:pt idx="173">
                  <c:v>18</c:v>
                </c:pt>
                <c:pt idx="174">
                  <c:v>19</c:v>
                </c:pt>
                <c:pt idx="175">
                  <c:v>20</c:v>
                </c:pt>
                <c:pt idx="176">
                  <c:v>21</c:v>
                </c:pt>
                <c:pt idx="177">
                  <c:v>22</c:v>
                </c:pt>
                <c:pt idx="178">
                  <c:v>23</c:v>
                </c:pt>
                <c:pt idx="179">
                  <c:v>24</c:v>
                </c:pt>
                <c:pt idx="180">
                  <c:v>25</c:v>
                </c:pt>
                <c:pt idx="181">
                  <c:v>26</c:v>
                </c:pt>
                <c:pt idx="182">
                  <c:v>27</c:v>
                </c:pt>
                <c:pt idx="183">
                  <c:v>28</c:v>
                </c:pt>
                <c:pt idx="184">
                  <c:v>29</c:v>
                </c:pt>
                <c:pt idx="185">
                  <c:v>30</c:v>
                </c:pt>
                <c:pt idx="186">
                  <c:v>31</c:v>
                </c:pt>
                <c:pt idx="187">
                  <c:v>32</c:v>
                </c:pt>
                <c:pt idx="188">
                  <c:v>33</c:v>
                </c:pt>
                <c:pt idx="189">
                  <c:v>34</c:v>
                </c:pt>
                <c:pt idx="190">
                  <c:v>35</c:v>
                </c:pt>
                <c:pt idx="191">
                  <c:v>36</c:v>
                </c:pt>
                <c:pt idx="192">
                  <c:v>37</c:v>
                </c:pt>
                <c:pt idx="193">
                  <c:v>38</c:v>
                </c:pt>
                <c:pt idx="194">
                  <c:v>39</c:v>
                </c:pt>
                <c:pt idx="195">
                  <c:v>40</c:v>
                </c:pt>
                <c:pt idx="196">
                  <c:v>41</c:v>
                </c:pt>
                <c:pt idx="197">
                  <c:v>42</c:v>
                </c:pt>
                <c:pt idx="198">
                  <c:v>43</c:v>
                </c:pt>
                <c:pt idx="199">
                  <c:v>44</c:v>
                </c:pt>
                <c:pt idx="200">
                  <c:v>45</c:v>
                </c:pt>
                <c:pt idx="201">
                  <c:v>46</c:v>
                </c:pt>
                <c:pt idx="202">
                  <c:v>47</c:v>
                </c:pt>
                <c:pt idx="203">
                  <c:v>48</c:v>
                </c:pt>
                <c:pt idx="204">
                  <c:v>49</c:v>
                </c:pt>
                <c:pt idx="205">
                  <c:v>50</c:v>
                </c:pt>
                <c:pt idx="206">
                  <c:v>51</c:v>
                </c:pt>
                <c:pt idx="207">
                  <c:v>52</c:v>
                </c:pt>
                <c:pt idx="208">
                  <c:v>53</c:v>
                </c:pt>
                <c:pt idx="209">
                  <c:v>1</c:v>
                </c:pt>
                <c:pt idx="210">
                  <c:v>2</c:v>
                </c:pt>
                <c:pt idx="211">
                  <c:v>3</c:v>
                </c:pt>
                <c:pt idx="212">
                  <c:v>4</c:v>
                </c:pt>
                <c:pt idx="213">
                  <c:v>5</c:v>
                </c:pt>
                <c:pt idx="214">
                  <c:v>6</c:v>
                </c:pt>
                <c:pt idx="215">
                  <c:v>7</c:v>
                </c:pt>
                <c:pt idx="216">
                  <c:v>8</c:v>
                </c:pt>
                <c:pt idx="217">
                  <c:v>9</c:v>
                </c:pt>
                <c:pt idx="218">
                  <c:v>10</c:v>
                </c:pt>
                <c:pt idx="219">
                  <c:v>11</c:v>
                </c:pt>
                <c:pt idx="220">
                  <c:v>12</c:v>
                </c:pt>
                <c:pt idx="221">
                  <c:v>13</c:v>
                </c:pt>
                <c:pt idx="222">
                  <c:v>14</c:v>
                </c:pt>
                <c:pt idx="223">
                  <c:v>15</c:v>
                </c:pt>
                <c:pt idx="224">
                  <c:v>16</c:v>
                </c:pt>
                <c:pt idx="225">
                  <c:v>17</c:v>
                </c:pt>
                <c:pt idx="226">
                  <c:v>18</c:v>
                </c:pt>
                <c:pt idx="227">
                  <c:v>19</c:v>
                </c:pt>
                <c:pt idx="228">
                  <c:v>20</c:v>
                </c:pt>
                <c:pt idx="229">
                  <c:v>21</c:v>
                </c:pt>
                <c:pt idx="230">
                  <c:v>22</c:v>
                </c:pt>
                <c:pt idx="231">
                  <c:v>23</c:v>
                </c:pt>
                <c:pt idx="232">
                  <c:v>24</c:v>
                </c:pt>
                <c:pt idx="233">
                  <c:v>25</c:v>
                </c:pt>
                <c:pt idx="234">
                  <c:v>26</c:v>
                </c:pt>
                <c:pt idx="235">
                  <c:v>27</c:v>
                </c:pt>
                <c:pt idx="236">
                  <c:v>28</c:v>
                </c:pt>
                <c:pt idx="237">
                  <c:v>29</c:v>
                </c:pt>
                <c:pt idx="238">
                  <c:v>30</c:v>
                </c:pt>
                <c:pt idx="239">
                  <c:v>31</c:v>
                </c:pt>
                <c:pt idx="240">
                  <c:v>32</c:v>
                </c:pt>
                <c:pt idx="241">
                  <c:v>33</c:v>
                </c:pt>
                <c:pt idx="242">
                  <c:v>34</c:v>
                </c:pt>
                <c:pt idx="243">
                  <c:v>35</c:v>
                </c:pt>
                <c:pt idx="244">
                  <c:v>36</c:v>
                </c:pt>
                <c:pt idx="245">
                  <c:v>37</c:v>
                </c:pt>
                <c:pt idx="246">
                  <c:v>38</c:v>
                </c:pt>
                <c:pt idx="247">
                  <c:v>39</c:v>
                </c:pt>
                <c:pt idx="248">
                  <c:v>40</c:v>
                </c:pt>
                <c:pt idx="249">
                  <c:v>41</c:v>
                </c:pt>
                <c:pt idx="250">
                  <c:v>42</c:v>
                </c:pt>
                <c:pt idx="251">
                  <c:v>43</c:v>
                </c:pt>
                <c:pt idx="252">
                  <c:v>44</c:v>
                </c:pt>
                <c:pt idx="253">
                  <c:v>45</c:v>
                </c:pt>
                <c:pt idx="254">
                  <c:v>46</c:v>
                </c:pt>
                <c:pt idx="255">
                  <c:v>47</c:v>
                </c:pt>
                <c:pt idx="256">
                  <c:v>48</c:v>
                </c:pt>
                <c:pt idx="257">
                  <c:v>49</c:v>
                </c:pt>
                <c:pt idx="258">
                  <c:v>50</c:v>
                </c:pt>
                <c:pt idx="259">
                  <c:v>51</c:v>
                </c:pt>
                <c:pt idx="260">
                  <c:v>52</c:v>
                </c:pt>
                <c:pt idx="261">
                  <c:v>1</c:v>
                </c:pt>
                <c:pt idx="262">
                  <c:v>2</c:v>
                </c:pt>
                <c:pt idx="263">
                  <c:v>3</c:v>
                </c:pt>
                <c:pt idx="264">
                  <c:v>4</c:v>
                </c:pt>
                <c:pt idx="265">
                  <c:v>5</c:v>
                </c:pt>
                <c:pt idx="266">
                  <c:v>6</c:v>
                </c:pt>
                <c:pt idx="267">
                  <c:v>7</c:v>
                </c:pt>
                <c:pt idx="268">
                  <c:v>8</c:v>
                </c:pt>
                <c:pt idx="269">
                  <c:v>9</c:v>
                </c:pt>
                <c:pt idx="270">
                  <c:v>10</c:v>
                </c:pt>
                <c:pt idx="271">
                  <c:v>11</c:v>
                </c:pt>
                <c:pt idx="272">
                  <c:v>12</c:v>
                </c:pt>
                <c:pt idx="273">
                  <c:v>13</c:v>
                </c:pt>
                <c:pt idx="274">
                  <c:v>14</c:v>
                </c:pt>
                <c:pt idx="275">
                  <c:v>15</c:v>
                </c:pt>
                <c:pt idx="276">
                  <c:v>16</c:v>
                </c:pt>
                <c:pt idx="277">
                  <c:v>17</c:v>
                </c:pt>
                <c:pt idx="278">
                  <c:v>18</c:v>
                </c:pt>
                <c:pt idx="279">
                  <c:v>19</c:v>
                </c:pt>
                <c:pt idx="280">
                  <c:v>20</c:v>
                </c:pt>
                <c:pt idx="281">
                  <c:v>21</c:v>
                </c:pt>
                <c:pt idx="282">
                  <c:v>22</c:v>
                </c:pt>
                <c:pt idx="283">
                  <c:v>23</c:v>
                </c:pt>
                <c:pt idx="284">
                  <c:v>24</c:v>
                </c:pt>
                <c:pt idx="285">
                  <c:v>25</c:v>
                </c:pt>
                <c:pt idx="286">
                  <c:v>26</c:v>
                </c:pt>
                <c:pt idx="287">
                  <c:v>27</c:v>
                </c:pt>
                <c:pt idx="288">
                  <c:v>28</c:v>
                </c:pt>
                <c:pt idx="289">
                  <c:v>29</c:v>
                </c:pt>
                <c:pt idx="290">
                  <c:v>30</c:v>
                </c:pt>
                <c:pt idx="291">
                  <c:v>31</c:v>
                </c:pt>
                <c:pt idx="292">
                  <c:v>32</c:v>
                </c:pt>
                <c:pt idx="293">
                  <c:v>33</c:v>
                </c:pt>
                <c:pt idx="294">
                  <c:v>34</c:v>
                </c:pt>
                <c:pt idx="295">
                  <c:v>35</c:v>
                </c:pt>
                <c:pt idx="296">
                  <c:v>36</c:v>
                </c:pt>
                <c:pt idx="297">
                  <c:v>37</c:v>
                </c:pt>
                <c:pt idx="298">
                  <c:v>38</c:v>
                </c:pt>
                <c:pt idx="299">
                  <c:v>39</c:v>
                </c:pt>
                <c:pt idx="300">
                  <c:v>40</c:v>
                </c:pt>
                <c:pt idx="301">
                  <c:v>41</c:v>
                </c:pt>
                <c:pt idx="302">
                  <c:v>42</c:v>
                </c:pt>
                <c:pt idx="303">
                  <c:v>43</c:v>
                </c:pt>
                <c:pt idx="304">
                  <c:v>44</c:v>
                </c:pt>
                <c:pt idx="305">
                  <c:v>45</c:v>
                </c:pt>
                <c:pt idx="306">
                  <c:v>46</c:v>
                </c:pt>
                <c:pt idx="307">
                  <c:v>47</c:v>
                </c:pt>
                <c:pt idx="308">
                  <c:v>48</c:v>
                </c:pt>
                <c:pt idx="309">
                  <c:v>49</c:v>
                </c:pt>
                <c:pt idx="310">
                  <c:v>50</c:v>
                </c:pt>
                <c:pt idx="311">
                  <c:v>51</c:v>
                </c:pt>
                <c:pt idx="312">
                  <c:v>52</c:v>
                </c:pt>
              </c:numCache>
            </c:numRef>
          </c:cat>
          <c:val>
            <c:numRef>
              <c:f>Sheet1!$E$2:$E$314</c:f>
              <c:numCache>
                <c:formatCode>General</c:formatCode>
                <c:ptCount val="313"/>
                <c:pt idx="0">
                  <c:v>257.79888558104682</c:v>
                </c:pt>
                <c:pt idx="1">
                  <c:v>1132.0574048468347</c:v>
                </c:pt>
                <c:pt idx="2">
                  <c:v>3871.0734795582453</c:v>
                </c:pt>
                <c:pt idx="3">
                  <c:v>4991.8406927510478</c:v>
                </c:pt>
                <c:pt idx="4">
                  <c:v>4413.8022461747205</c:v>
                </c:pt>
                <c:pt idx="5">
                  <c:v>4661.0935010969297</c:v>
                </c:pt>
                <c:pt idx="6">
                  <c:v>2851.6434637412226</c:v>
                </c:pt>
                <c:pt idx="7">
                  <c:v>2746.1302455007376</c:v>
                </c:pt>
                <c:pt idx="8">
                  <c:v>3214.3475263353266</c:v>
                </c:pt>
                <c:pt idx="9">
                  <c:v>2721.1607647665278</c:v>
                </c:pt>
                <c:pt idx="10">
                  <c:v>2292.6467489495071</c:v>
                </c:pt>
                <c:pt idx="11">
                  <c:v>1763.1506439520181</c:v>
                </c:pt>
                <c:pt idx="12">
                  <c:v>1291.3726799597594</c:v>
                </c:pt>
                <c:pt idx="13">
                  <c:v>353.98979252876944</c:v>
                </c:pt>
                <c:pt idx="14">
                  <c:v>484.01395002500618</c:v>
                </c:pt>
                <c:pt idx="15">
                  <c:v>569.97217583700899</c:v>
                </c:pt>
                <c:pt idx="16">
                  <c:v>179.10255914524802</c:v>
                </c:pt>
                <c:pt idx="17">
                  <c:v>373.20555157372939</c:v>
                </c:pt>
                <c:pt idx="18">
                  <c:v>-32.264999999999986</c:v>
                </c:pt>
                <c:pt idx="19">
                  <c:v>58.458180884688261</c:v>
                </c:pt>
                <c:pt idx="20">
                  <c:v>144.23214420296546</c:v>
                </c:pt>
                <c:pt idx="21">
                  <c:v>-93.195173313346032</c:v>
                </c:pt>
                <c:pt idx="22">
                  <c:v>-57.571855797034615</c:v>
                </c:pt>
                <c:pt idx="23">
                  <c:v>-33.686070839694736</c:v>
                </c:pt>
                <c:pt idx="24">
                  <c:v>65.657404172852509</c:v>
                </c:pt>
                <c:pt idx="25">
                  <c:v>267.27704745097822</c:v>
                </c:pt>
                <c:pt idx="26">
                  <c:v>-275.90012838611909</c:v>
                </c:pt>
                <c:pt idx="27">
                  <c:v>-225.39206511803144</c:v>
                </c:pt>
                <c:pt idx="28">
                  <c:v>466.30520562119818</c:v>
                </c:pt>
                <c:pt idx="29">
                  <c:v>198.86824987443998</c:v>
                </c:pt>
                <c:pt idx="30">
                  <c:v>158.28941494219478</c:v>
                </c:pt>
                <c:pt idx="31">
                  <c:v>-34.469566716943348</c:v>
                </c:pt>
                <c:pt idx="32">
                  <c:v>39.70525744595912</c:v>
                </c:pt>
                <c:pt idx="33">
                  <c:v>15.531881709238618</c:v>
                </c:pt>
                <c:pt idx="34">
                  <c:v>-42.618134107783732</c:v>
                </c:pt>
                <c:pt idx="35">
                  <c:v>101.84991839096135</c:v>
                </c:pt>
                <c:pt idx="36">
                  <c:v>188.33714167912584</c:v>
                </c:pt>
                <c:pt idx="37">
                  <c:v>-37.68512586227979</c:v>
                </c:pt>
                <c:pt idx="38">
                  <c:v>-21.995855797035048</c:v>
                </c:pt>
                <c:pt idx="39">
                  <c:v>-133.53301076943109</c:v>
                </c:pt>
                <c:pt idx="40">
                  <c:v>21.581404172851435</c:v>
                </c:pt>
                <c:pt idx="41">
                  <c:v>20.032196701710134</c:v>
                </c:pt>
                <c:pt idx="42">
                  <c:v>-137.46160912033082</c:v>
                </c:pt>
                <c:pt idx="43">
                  <c:v>110.01658505762819</c:v>
                </c:pt>
                <c:pt idx="44">
                  <c:v>47.93860087465027</c:v>
                </c:pt>
                <c:pt idx="45">
                  <c:v>81.608511694181644</c:v>
                </c:pt>
                <c:pt idx="46">
                  <c:v>-103.93752498754135</c:v>
                </c:pt>
                <c:pt idx="47">
                  <c:v>-194.80779252894712</c:v>
                </c:pt>
                <c:pt idx="48">
                  <c:v>-119.30486336855346</c:v>
                </c:pt>
                <c:pt idx="49">
                  <c:v>-9.834585057805441</c:v>
                </c:pt>
                <c:pt idx="50">
                  <c:v>219.28038650597361</c:v>
                </c:pt>
                <c:pt idx="51">
                  <c:v>256.52455477155195</c:v>
                </c:pt>
                <c:pt idx="52">
                  <c:v>-61.521114418953118</c:v>
                </c:pt>
                <c:pt idx="53">
                  <c:v>450.84140484683468</c:v>
                </c:pt>
                <c:pt idx="54">
                  <c:v>1018.4814795582453</c:v>
                </c:pt>
                <c:pt idx="55">
                  <c:v>2543.7206927510479</c:v>
                </c:pt>
                <c:pt idx="56">
                  <c:v>2710.7622461747205</c:v>
                </c:pt>
                <c:pt idx="57">
                  <c:v>2191.6855010969289</c:v>
                </c:pt>
                <c:pt idx="58">
                  <c:v>2170.4274637412227</c:v>
                </c:pt>
                <c:pt idx="59">
                  <c:v>1298.5462455007378</c:v>
                </c:pt>
                <c:pt idx="60">
                  <c:v>1191.9875263353269</c:v>
                </c:pt>
                <c:pt idx="61">
                  <c:v>1422.5927647665283</c:v>
                </c:pt>
                <c:pt idx="62">
                  <c:v>1100.518748949507</c:v>
                </c:pt>
                <c:pt idx="63">
                  <c:v>741.32664395201823</c:v>
                </c:pt>
                <c:pt idx="64">
                  <c:v>418.56467995975942</c:v>
                </c:pt>
                <c:pt idx="65">
                  <c:v>311.41379252876942</c:v>
                </c:pt>
                <c:pt idx="66">
                  <c:v>185.98195002500614</c:v>
                </c:pt>
                <c:pt idx="67">
                  <c:v>122.92417583700896</c:v>
                </c:pt>
                <c:pt idx="68">
                  <c:v>434.55855914524807</c:v>
                </c:pt>
                <c:pt idx="69">
                  <c:v>202.90155157372928</c:v>
                </c:pt>
                <c:pt idx="70">
                  <c:v>138.03899999999999</c:v>
                </c:pt>
                <c:pt idx="71">
                  <c:v>122.32218088468829</c:v>
                </c:pt>
                <c:pt idx="72">
                  <c:v>229.38414420296539</c:v>
                </c:pt>
                <c:pt idx="73">
                  <c:v>-178.34717331334608</c:v>
                </c:pt>
                <c:pt idx="74">
                  <c:v>27.580144202965371</c:v>
                </c:pt>
                <c:pt idx="75">
                  <c:v>-54.974070839694747</c:v>
                </c:pt>
                <c:pt idx="76">
                  <c:v>-147.22259582714742</c:v>
                </c:pt>
                <c:pt idx="77">
                  <c:v>54.397047450978192</c:v>
                </c:pt>
                <c:pt idx="78">
                  <c:v>0.84387161388093546</c:v>
                </c:pt>
                <c:pt idx="79">
                  <c:v>498.39993488196859</c:v>
                </c:pt>
                <c:pt idx="80">
                  <c:v>-87.182794378801532</c:v>
                </c:pt>
                <c:pt idx="81">
                  <c:v>-163.02775012556009</c:v>
                </c:pt>
                <c:pt idx="82">
                  <c:v>9.2734149421948189</c:v>
                </c:pt>
                <c:pt idx="83">
                  <c:v>-204.77356671694332</c:v>
                </c:pt>
                <c:pt idx="84">
                  <c:v>252.58525744595912</c:v>
                </c:pt>
                <c:pt idx="85">
                  <c:v>-69.620118290761368</c:v>
                </c:pt>
                <c:pt idx="86">
                  <c:v>-63.906134107783743</c:v>
                </c:pt>
                <c:pt idx="87">
                  <c:v>-111.03008160903865</c:v>
                </c:pt>
                <c:pt idx="88">
                  <c:v>-258.71085832087419</c:v>
                </c:pt>
                <c:pt idx="89">
                  <c:v>132.6188741377203</c:v>
                </c:pt>
                <c:pt idx="90">
                  <c:v>-171.01185579703503</c:v>
                </c:pt>
                <c:pt idx="91">
                  <c:v>15.482989230568947</c:v>
                </c:pt>
                <c:pt idx="92">
                  <c:v>-297.73859582714863</c:v>
                </c:pt>
                <c:pt idx="93">
                  <c:v>-192.84780329828988</c:v>
                </c:pt>
                <c:pt idx="94">
                  <c:v>-73.597609120330858</c:v>
                </c:pt>
                <c:pt idx="95">
                  <c:v>-251.87941494237182</c:v>
                </c:pt>
                <c:pt idx="96">
                  <c:v>-58.501399125349728</c:v>
                </c:pt>
                <c:pt idx="97">
                  <c:v>-237.71148830581839</c:v>
                </c:pt>
                <c:pt idx="98">
                  <c:v>-210.37752498754134</c:v>
                </c:pt>
                <c:pt idx="99">
                  <c:v>145.80020747105289</c:v>
                </c:pt>
                <c:pt idx="100">
                  <c:v>93.575136631446483</c:v>
                </c:pt>
                <c:pt idx="101">
                  <c:v>32.741414942194524</c:v>
                </c:pt>
                <c:pt idx="102">
                  <c:v>134.12838650597368</c:v>
                </c:pt>
                <c:pt idx="103">
                  <c:v>171.37255477155202</c:v>
                </c:pt>
                <c:pt idx="104">
                  <c:v>-82.809114418953129</c:v>
                </c:pt>
                <c:pt idx="105">
                  <c:v>472.12940484683469</c:v>
                </c:pt>
                <c:pt idx="106">
                  <c:v>1337.8014795582453</c:v>
                </c:pt>
                <c:pt idx="107">
                  <c:v>3097.2086927510481</c:v>
                </c:pt>
                <c:pt idx="108">
                  <c:v>3285.5382461747204</c:v>
                </c:pt>
                <c:pt idx="109">
                  <c:v>1744.6375010969291</c:v>
                </c:pt>
                <c:pt idx="110">
                  <c:v>2063.9874637412227</c:v>
                </c:pt>
                <c:pt idx="111">
                  <c:v>1809.4582455007378</c:v>
                </c:pt>
                <c:pt idx="112">
                  <c:v>1958.3555263353269</c:v>
                </c:pt>
                <c:pt idx="113">
                  <c:v>1890.9287647665283</c:v>
                </c:pt>
                <c:pt idx="114">
                  <c:v>1781.7347489495069</c:v>
                </c:pt>
                <c:pt idx="115">
                  <c:v>1252.2386439520183</c:v>
                </c:pt>
                <c:pt idx="116">
                  <c:v>588.86867995975945</c:v>
                </c:pt>
                <c:pt idx="117">
                  <c:v>204.97379252876942</c:v>
                </c:pt>
                <c:pt idx="118">
                  <c:v>185.98195002500614</c:v>
                </c:pt>
                <c:pt idx="119">
                  <c:v>399.66817583700902</c:v>
                </c:pt>
                <c:pt idx="120">
                  <c:v>72.662559145248082</c:v>
                </c:pt>
                <c:pt idx="121">
                  <c:v>-201.5704484262707</c:v>
                </c:pt>
                <c:pt idx="122">
                  <c:v>138.03899999999999</c:v>
                </c:pt>
                <c:pt idx="123">
                  <c:v>37.170180884688307</c:v>
                </c:pt>
                <c:pt idx="124">
                  <c:v>-89.935855797034606</c:v>
                </c:pt>
                <c:pt idx="125">
                  <c:v>289.98882668665402</c:v>
                </c:pt>
                <c:pt idx="126">
                  <c:v>27.580144202965371</c:v>
                </c:pt>
                <c:pt idx="127">
                  <c:v>30.177929160305183</c:v>
                </c:pt>
                <c:pt idx="128">
                  <c:v>108.23340417285253</c:v>
                </c:pt>
                <c:pt idx="129">
                  <c:v>-137.19495254902179</c:v>
                </c:pt>
                <c:pt idx="130">
                  <c:v>149.8598716138809</c:v>
                </c:pt>
                <c:pt idx="131">
                  <c:v>-118.95206511803138</c:v>
                </c:pt>
                <c:pt idx="132">
                  <c:v>-172.33479437880158</c:v>
                </c:pt>
                <c:pt idx="133">
                  <c:v>71.140249874439917</c:v>
                </c:pt>
                <c:pt idx="134">
                  <c:v>-182.31858505780517</c:v>
                </c:pt>
                <c:pt idx="135">
                  <c:v>-98.33356671694338</c:v>
                </c:pt>
                <c:pt idx="136">
                  <c:v>-258.32674255404095</c:v>
                </c:pt>
                <c:pt idx="137">
                  <c:v>-90.908118290761379</c:v>
                </c:pt>
                <c:pt idx="138">
                  <c:v>-4.2134107783709851E-2</c:v>
                </c:pt>
                <c:pt idx="139">
                  <c:v>-89.742081609038692</c:v>
                </c:pt>
                <c:pt idx="140">
                  <c:v>209.62514167912585</c:v>
                </c:pt>
                <c:pt idx="141">
                  <c:v>-122.83712586227972</c:v>
                </c:pt>
                <c:pt idx="142">
                  <c:v>-21.995855797035048</c:v>
                </c:pt>
                <c:pt idx="143">
                  <c:v>-5.805010769431064</c:v>
                </c:pt>
                <c:pt idx="144">
                  <c:v>-212.58659582714864</c:v>
                </c:pt>
                <c:pt idx="145">
                  <c:v>105.18419670171018</c:v>
                </c:pt>
                <c:pt idx="146">
                  <c:v>-73.597609120330858</c:v>
                </c:pt>
                <c:pt idx="147">
                  <c:v>-60.287414942371839</c:v>
                </c:pt>
                <c:pt idx="148">
                  <c:v>26.650600874650259</c:v>
                </c:pt>
                <c:pt idx="149">
                  <c:v>-67.407488305818376</c:v>
                </c:pt>
                <c:pt idx="150">
                  <c:v>87.65447501245869</c:v>
                </c:pt>
                <c:pt idx="151">
                  <c:v>422.54420747105291</c:v>
                </c:pt>
                <c:pt idx="152">
                  <c:v>349.03113663144649</c:v>
                </c:pt>
                <c:pt idx="153">
                  <c:v>735.24541494219466</c:v>
                </c:pt>
                <c:pt idx="154">
                  <c:v>1134.6643865059739</c:v>
                </c:pt>
                <c:pt idx="155">
                  <c:v>2470.4765547715519</c:v>
                </c:pt>
                <c:pt idx="156">
                  <c:v>2067.2788855810468</c:v>
                </c:pt>
                <c:pt idx="157">
                  <c:v>1110.7694048468347</c:v>
                </c:pt>
                <c:pt idx="158">
                  <c:v>2317.0494795582454</c:v>
                </c:pt>
                <c:pt idx="159">
                  <c:v>2948.1926927510476</c:v>
                </c:pt>
                <c:pt idx="160">
                  <c:v>2795.9142461747206</c:v>
                </c:pt>
                <c:pt idx="161">
                  <c:v>1297.5895010969291</c:v>
                </c:pt>
                <c:pt idx="162">
                  <c:v>1361.4834637412227</c:v>
                </c:pt>
                <c:pt idx="163">
                  <c:v>1490.1382455007379</c:v>
                </c:pt>
                <c:pt idx="164">
                  <c:v>1128.1235263353269</c:v>
                </c:pt>
                <c:pt idx="165">
                  <c:v>847.81676476652819</c:v>
                </c:pt>
                <c:pt idx="166">
                  <c:v>398.01474894950695</c:v>
                </c:pt>
                <c:pt idx="167">
                  <c:v>422.00664395201812</c:v>
                </c:pt>
                <c:pt idx="168">
                  <c:v>397.27667995975941</c:v>
                </c:pt>
                <c:pt idx="169">
                  <c:v>162.3977925287694</c:v>
                </c:pt>
                <c:pt idx="170">
                  <c:v>15.677950025006112</c:v>
                </c:pt>
                <c:pt idx="171">
                  <c:v>37.772175837008973</c:v>
                </c:pt>
                <c:pt idx="172">
                  <c:v>115.2385591452481</c:v>
                </c:pt>
                <c:pt idx="173">
                  <c:v>-52.554448426270739</c:v>
                </c:pt>
                <c:pt idx="174">
                  <c:v>180.61500000000001</c:v>
                </c:pt>
                <c:pt idx="175">
                  <c:v>79.746180884688272</c:v>
                </c:pt>
                <c:pt idx="176">
                  <c:v>-68.647855797034595</c:v>
                </c:pt>
                <c:pt idx="177">
                  <c:v>289.98882668665402</c:v>
                </c:pt>
                <c:pt idx="178">
                  <c:v>48.868144202965382</c:v>
                </c:pt>
                <c:pt idx="179">
                  <c:v>30.177929160305183</c:v>
                </c:pt>
                <c:pt idx="180">
                  <c:v>-147.22259582714742</c:v>
                </c:pt>
                <c:pt idx="181">
                  <c:v>-158.4829525490218</c:v>
                </c:pt>
                <c:pt idx="182">
                  <c:v>-105.59612838611912</c:v>
                </c:pt>
                <c:pt idx="183">
                  <c:v>51.351934881968589</c:v>
                </c:pt>
                <c:pt idx="184">
                  <c:v>-321.35079437880165</c:v>
                </c:pt>
                <c:pt idx="185">
                  <c:v>411.74824987443986</c:v>
                </c:pt>
                <c:pt idx="186">
                  <c:v>94.425414942194749</c:v>
                </c:pt>
                <c:pt idx="187">
                  <c:v>8.1064332830566741</c:v>
                </c:pt>
                <c:pt idx="188">
                  <c:v>188.72125744595908</c:v>
                </c:pt>
                <c:pt idx="189">
                  <c:v>79.395881709238651</c:v>
                </c:pt>
                <c:pt idx="190">
                  <c:v>-21.330134107783721</c:v>
                </c:pt>
                <c:pt idx="191">
                  <c:v>59.273918390961327</c:v>
                </c:pt>
                <c:pt idx="192">
                  <c:v>-67.118858320874182</c:v>
                </c:pt>
                <c:pt idx="193">
                  <c:v>4.8908741377202318</c:v>
                </c:pt>
                <c:pt idx="194">
                  <c:v>339.90014420296501</c:v>
                </c:pt>
                <c:pt idx="195">
                  <c:v>100.63498923056893</c:v>
                </c:pt>
                <c:pt idx="196">
                  <c:v>-63.570595827148608</c:v>
                </c:pt>
                <c:pt idx="197">
                  <c:v>169.04819670171008</c:v>
                </c:pt>
                <c:pt idx="198">
                  <c:v>75.418390879669161</c:v>
                </c:pt>
                <c:pt idx="199">
                  <c:v>3.5765850576281935</c:v>
                </c:pt>
                <c:pt idx="200">
                  <c:v>47.93860087465027</c:v>
                </c:pt>
                <c:pt idx="201">
                  <c:v>251.91251169418163</c:v>
                </c:pt>
                <c:pt idx="202">
                  <c:v>66.366475012458679</c:v>
                </c:pt>
                <c:pt idx="203">
                  <c:v>39.360207471052824</c:v>
                </c:pt>
                <c:pt idx="204">
                  <c:v>221.30313663144653</c:v>
                </c:pt>
                <c:pt idx="205">
                  <c:v>224.33341494219451</c:v>
                </c:pt>
                <c:pt idx="206">
                  <c:v>602.46438650597372</c:v>
                </c:pt>
                <c:pt idx="207">
                  <c:v>192.66055477155203</c:v>
                </c:pt>
                <c:pt idx="208">
                  <c:v>35.018413092338392</c:v>
                </c:pt>
                <c:pt idx="209">
                  <c:v>-423.41711441895308</c:v>
                </c:pt>
                <c:pt idx="210">
                  <c:v>493.4174048468347</c:v>
                </c:pt>
                <c:pt idx="211">
                  <c:v>1061.0574795582452</c:v>
                </c:pt>
                <c:pt idx="212">
                  <c:v>3012.0566927510481</c:v>
                </c:pt>
                <c:pt idx="213">
                  <c:v>4051.9062461747208</c:v>
                </c:pt>
                <c:pt idx="214">
                  <c:v>4490.7895010969296</c:v>
                </c:pt>
                <c:pt idx="215">
                  <c:v>3213.5394637412228</c:v>
                </c:pt>
                <c:pt idx="216">
                  <c:v>3044.1622455007378</c:v>
                </c:pt>
                <c:pt idx="217">
                  <c:v>3129.1955263353266</c:v>
                </c:pt>
                <c:pt idx="218">
                  <c:v>1890.9287647665283</c:v>
                </c:pt>
                <c:pt idx="219">
                  <c:v>1441.1267489495069</c:v>
                </c:pt>
                <c:pt idx="220">
                  <c:v>1337.3906439520183</c:v>
                </c:pt>
                <c:pt idx="221">
                  <c:v>461.14067995975944</c:v>
                </c:pt>
                <c:pt idx="222">
                  <c:v>503.0057925287694</c:v>
                </c:pt>
                <c:pt idx="223">
                  <c:v>271.13395002500619</c:v>
                </c:pt>
                <c:pt idx="224">
                  <c:v>229.36417583700901</c:v>
                </c:pt>
                <c:pt idx="225">
                  <c:v>51.374559145248071</c:v>
                </c:pt>
                <c:pt idx="226">
                  <c:v>11.309551573729294</c:v>
                </c:pt>
                <c:pt idx="227">
                  <c:v>10.311000000000035</c:v>
                </c:pt>
                <c:pt idx="228">
                  <c:v>122.32218088468829</c:v>
                </c:pt>
                <c:pt idx="229">
                  <c:v>165.52014420296535</c:v>
                </c:pt>
                <c:pt idx="230">
                  <c:v>-93.195173313346032</c:v>
                </c:pt>
                <c:pt idx="231">
                  <c:v>6.2921442029653605</c:v>
                </c:pt>
                <c:pt idx="232">
                  <c:v>8.8899291603051722</c:v>
                </c:pt>
                <c:pt idx="233">
                  <c:v>150.80940417285257</c:v>
                </c:pt>
                <c:pt idx="234">
                  <c:v>160.83704745097813</c:v>
                </c:pt>
                <c:pt idx="235">
                  <c:v>149.8598716138809</c:v>
                </c:pt>
                <c:pt idx="236">
                  <c:v>-33.800065118031455</c:v>
                </c:pt>
                <c:pt idx="237">
                  <c:v>125.69720562119835</c:v>
                </c:pt>
                <c:pt idx="238">
                  <c:v>-333.33175012556018</c:v>
                </c:pt>
                <c:pt idx="239">
                  <c:v>-97.166585057805236</c:v>
                </c:pt>
                <c:pt idx="240">
                  <c:v>50.682433283056696</c:v>
                </c:pt>
                <c:pt idx="241">
                  <c:v>-130.59874255404097</c:v>
                </c:pt>
                <c:pt idx="242">
                  <c:v>164.5478817092386</c:v>
                </c:pt>
                <c:pt idx="243">
                  <c:v>21.245865892216244</c:v>
                </c:pt>
                <c:pt idx="244">
                  <c:v>123.13791839096136</c:v>
                </c:pt>
                <c:pt idx="245">
                  <c:v>18.033141679125855</c:v>
                </c:pt>
                <c:pt idx="246">
                  <c:v>217.77087413772023</c:v>
                </c:pt>
                <c:pt idx="247">
                  <c:v>-0.70785579703503743</c:v>
                </c:pt>
                <c:pt idx="248">
                  <c:v>121.92298923056894</c:v>
                </c:pt>
                <c:pt idx="249">
                  <c:v>404.76540417285139</c:v>
                </c:pt>
                <c:pt idx="250">
                  <c:v>105.18419670171018</c:v>
                </c:pt>
                <c:pt idx="251">
                  <c:v>203.14639087966913</c:v>
                </c:pt>
                <c:pt idx="252">
                  <c:v>237.74458505762814</c:v>
                </c:pt>
                <c:pt idx="253">
                  <c:v>154.3786008746502</c:v>
                </c:pt>
                <c:pt idx="254">
                  <c:v>337.06451169418165</c:v>
                </c:pt>
                <c:pt idx="255">
                  <c:v>470.83847501245867</c:v>
                </c:pt>
                <c:pt idx="256">
                  <c:v>252.24020747105294</c:v>
                </c:pt>
                <c:pt idx="257">
                  <c:v>157.4391366314465</c:v>
                </c:pt>
                <c:pt idx="258">
                  <c:v>415.92541494219449</c:v>
                </c:pt>
                <c:pt idx="259">
                  <c:v>730.19238650597379</c:v>
                </c:pt>
                <c:pt idx="260">
                  <c:v>533.26855477155198</c:v>
                </c:pt>
                <c:pt idx="261">
                  <c:v>108.78288558104697</c:v>
                </c:pt>
                <c:pt idx="262">
                  <c:v>748.87340484683477</c:v>
                </c:pt>
                <c:pt idx="263">
                  <c:v>1699.697479558245</c:v>
                </c:pt>
                <c:pt idx="264">
                  <c:v>2799.176692751048</c:v>
                </c:pt>
                <c:pt idx="265">
                  <c:v>3264.2502461747208</c:v>
                </c:pt>
                <c:pt idx="266">
                  <c:v>2170.3975010969293</c:v>
                </c:pt>
                <c:pt idx="267">
                  <c:v>1553.0754637412228</c:v>
                </c:pt>
                <c:pt idx="268">
                  <c:v>1383.6982455007378</c:v>
                </c:pt>
                <c:pt idx="269">
                  <c:v>1128.1235263353269</c:v>
                </c:pt>
                <c:pt idx="270">
                  <c:v>911.68076476652823</c:v>
                </c:pt>
                <c:pt idx="271">
                  <c:v>845.06274894950695</c:v>
                </c:pt>
                <c:pt idx="272">
                  <c:v>272.99064395201816</c:v>
                </c:pt>
                <c:pt idx="273">
                  <c:v>290.83667995975941</c:v>
                </c:pt>
                <c:pt idx="274">
                  <c:v>226.26179252876938</c:v>
                </c:pt>
                <c:pt idx="275">
                  <c:v>58.253950025006134</c:v>
                </c:pt>
                <c:pt idx="276">
                  <c:v>80.348175837008995</c:v>
                </c:pt>
                <c:pt idx="277">
                  <c:v>328.11855914524813</c:v>
                </c:pt>
                <c:pt idx="278">
                  <c:v>415.78155157372942</c:v>
                </c:pt>
                <c:pt idx="279">
                  <c:v>10.311000000000035</c:v>
                </c:pt>
                <c:pt idx="280">
                  <c:v>-47.981819115311737</c:v>
                </c:pt>
                <c:pt idx="281">
                  <c:v>-132.51185579703457</c:v>
                </c:pt>
                <c:pt idx="282">
                  <c:v>-93.195173313346032</c:v>
                </c:pt>
                <c:pt idx="283">
                  <c:v>6.2921442029653605</c:v>
                </c:pt>
                <c:pt idx="284">
                  <c:v>51.465929160305194</c:v>
                </c:pt>
                <c:pt idx="285">
                  <c:v>1.7934041728525898</c:v>
                </c:pt>
                <c:pt idx="286">
                  <c:v>-179.77095254902181</c:v>
                </c:pt>
                <c:pt idx="287">
                  <c:v>85.995871613880979</c:v>
                </c:pt>
                <c:pt idx="288">
                  <c:v>-161.52806511803141</c:v>
                </c:pt>
                <c:pt idx="289">
                  <c:v>-2.0307943788017155</c:v>
                </c:pt>
                <c:pt idx="290">
                  <c:v>-184.3157501255601</c:v>
                </c:pt>
                <c:pt idx="291">
                  <c:v>30.56141494219483</c:v>
                </c:pt>
                <c:pt idx="292">
                  <c:v>284.8504332830567</c:v>
                </c:pt>
                <c:pt idx="293">
                  <c:v>-88.022742554040946</c:v>
                </c:pt>
                <c:pt idx="294">
                  <c:v>-90.908118290761379</c:v>
                </c:pt>
                <c:pt idx="295">
                  <c:v>127.6858658922163</c:v>
                </c:pt>
                <c:pt idx="296">
                  <c:v>-68.454081609038681</c:v>
                </c:pt>
                <c:pt idx="297">
                  <c:v>-67.118858320874182</c:v>
                </c:pt>
                <c:pt idx="298">
                  <c:v>-186.70112586227975</c:v>
                </c:pt>
                <c:pt idx="299">
                  <c:v>-107.14785579703504</c:v>
                </c:pt>
                <c:pt idx="300">
                  <c:v>-69.669010769431097</c:v>
                </c:pt>
                <c:pt idx="301">
                  <c:v>170.59740417285138</c:v>
                </c:pt>
                <c:pt idx="302">
                  <c:v>-171.55980329828986</c:v>
                </c:pt>
                <c:pt idx="303">
                  <c:v>54.13039087966915</c:v>
                </c:pt>
                <c:pt idx="304">
                  <c:v>24.864585057628148</c:v>
                </c:pt>
                <c:pt idx="305">
                  <c:v>-122.36539912534977</c:v>
                </c:pt>
                <c:pt idx="306">
                  <c:v>-216.42348830581838</c:v>
                </c:pt>
                <c:pt idx="307">
                  <c:v>2.5024750124586497</c:v>
                </c:pt>
                <c:pt idx="308">
                  <c:v>-67.07979252894711</c:v>
                </c:pt>
                <c:pt idx="309">
                  <c:v>200.01513663144652</c:v>
                </c:pt>
                <c:pt idx="310">
                  <c:v>543.65341494219456</c:v>
                </c:pt>
                <c:pt idx="311">
                  <c:v>964.36038650597368</c:v>
                </c:pt>
                <c:pt idx="312">
                  <c:v>1533.80455477155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B3D-4EC0-A8D6-5E64F831BF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627113808"/>
        <c:axId val="1626116352"/>
        <c:extLst>
          <c:ext xmlns:c15="http://schemas.microsoft.com/office/drawing/2012/chart" uri="{02D57815-91ED-43cb-92C2-25804820EDAC}">
            <c15:filteredLine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Sheet1!$B$1</c15:sqref>
                        </c15:formulaRef>
                      </c:ext>
                    </c:extLst>
                    <c:strCache>
                      <c:ptCount val="1"/>
                      <c:pt idx="0">
                        <c:v>発熱トリアージ件数</c:v>
                      </c:pt>
                    </c:strCache>
                  </c:strRef>
                </c:tx>
                <c:spPr>
                  <a:ln w="28575" cap="rnd">
                    <a:solidFill>
                      <a:schemeClr val="accent1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1"/>
                    </a:solidFill>
                    <a:ln w="9525">
                      <a:solidFill>
                        <a:schemeClr val="accent1"/>
                      </a:solidFill>
                    </a:ln>
                    <a:effectLst/>
                  </c:spPr>
                </c:marker>
                <c:cat>
                  <c:numRef>
                    <c:extLst>
                      <c:ext uri="{02D57815-91ED-43cb-92C2-25804820EDAC}">
                        <c15:formulaRef>
                          <c15:sqref>Sheet1!$A$2:$A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1</c:v>
                      </c:pt>
                      <c:pt idx="1">
                        <c:v>2</c:v>
                      </c:pt>
                      <c:pt idx="2">
                        <c:v>3</c:v>
                      </c:pt>
                      <c:pt idx="3">
                        <c:v>4</c:v>
                      </c:pt>
                      <c:pt idx="4">
                        <c:v>5</c:v>
                      </c:pt>
                      <c:pt idx="5">
                        <c:v>6</c:v>
                      </c:pt>
                      <c:pt idx="6">
                        <c:v>7</c:v>
                      </c:pt>
                      <c:pt idx="7">
                        <c:v>8</c:v>
                      </c:pt>
                      <c:pt idx="8">
                        <c:v>9</c:v>
                      </c:pt>
                      <c:pt idx="9">
                        <c:v>10</c:v>
                      </c:pt>
                      <c:pt idx="10">
                        <c:v>11</c:v>
                      </c:pt>
                      <c:pt idx="11">
                        <c:v>12</c:v>
                      </c:pt>
                      <c:pt idx="12">
                        <c:v>13</c:v>
                      </c:pt>
                      <c:pt idx="13">
                        <c:v>14</c:v>
                      </c:pt>
                      <c:pt idx="14">
                        <c:v>15</c:v>
                      </c:pt>
                      <c:pt idx="15">
                        <c:v>16</c:v>
                      </c:pt>
                      <c:pt idx="16">
                        <c:v>17</c:v>
                      </c:pt>
                      <c:pt idx="17">
                        <c:v>18</c:v>
                      </c:pt>
                      <c:pt idx="18">
                        <c:v>19</c:v>
                      </c:pt>
                      <c:pt idx="19">
                        <c:v>20</c:v>
                      </c:pt>
                      <c:pt idx="20">
                        <c:v>21</c:v>
                      </c:pt>
                      <c:pt idx="21">
                        <c:v>22</c:v>
                      </c:pt>
                      <c:pt idx="22">
                        <c:v>23</c:v>
                      </c:pt>
                      <c:pt idx="23">
                        <c:v>24</c:v>
                      </c:pt>
                      <c:pt idx="24">
                        <c:v>25</c:v>
                      </c:pt>
                      <c:pt idx="25">
                        <c:v>26</c:v>
                      </c:pt>
                      <c:pt idx="26">
                        <c:v>27</c:v>
                      </c:pt>
                      <c:pt idx="27">
                        <c:v>28</c:v>
                      </c:pt>
                      <c:pt idx="28">
                        <c:v>29</c:v>
                      </c:pt>
                      <c:pt idx="29">
                        <c:v>30</c:v>
                      </c:pt>
                      <c:pt idx="30">
                        <c:v>31</c:v>
                      </c:pt>
                      <c:pt idx="31">
                        <c:v>32</c:v>
                      </c:pt>
                      <c:pt idx="32">
                        <c:v>33</c:v>
                      </c:pt>
                      <c:pt idx="33">
                        <c:v>34</c:v>
                      </c:pt>
                      <c:pt idx="34">
                        <c:v>35</c:v>
                      </c:pt>
                      <c:pt idx="35">
                        <c:v>36</c:v>
                      </c:pt>
                      <c:pt idx="36">
                        <c:v>37</c:v>
                      </c:pt>
                      <c:pt idx="37">
                        <c:v>38</c:v>
                      </c:pt>
                      <c:pt idx="38">
                        <c:v>39</c:v>
                      </c:pt>
                      <c:pt idx="39">
                        <c:v>40</c:v>
                      </c:pt>
                      <c:pt idx="40">
                        <c:v>41</c:v>
                      </c:pt>
                      <c:pt idx="41">
                        <c:v>42</c:v>
                      </c:pt>
                      <c:pt idx="42">
                        <c:v>43</c:v>
                      </c:pt>
                      <c:pt idx="43">
                        <c:v>44</c:v>
                      </c:pt>
                      <c:pt idx="44">
                        <c:v>45</c:v>
                      </c:pt>
                      <c:pt idx="45">
                        <c:v>46</c:v>
                      </c:pt>
                      <c:pt idx="46">
                        <c:v>47</c:v>
                      </c:pt>
                      <c:pt idx="47">
                        <c:v>48</c:v>
                      </c:pt>
                      <c:pt idx="48">
                        <c:v>49</c:v>
                      </c:pt>
                      <c:pt idx="49">
                        <c:v>50</c:v>
                      </c:pt>
                      <c:pt idx="50">
                        <c:v>51</c:v>
                      </c:pt>
                      <c:pt idx="51">
                        <c:v>52</c:v>
                      </c:pt>
                      <c:pt idx="52">
                        <c:v>1</c:v>
                      </c:pt>
                      <c:pt idx="53">
                        <c:v>2</c:v>
                      </c:pt>
                      <c:pt idx="54">
                        <c:v>3</c:v>
                      </c:pt>
                      <c:pt idx="55">
                        <c:v>4</c:v>
                      </c:pt>
                      <c:pt idx="56">
                        <c:v>5</c:v>
                      </c:pt>
                      <c:pt idx="57">
                        <c:v>6</c:v>
                      </c:pt>
                      <c:pt idx="58">
                        <c:v>7</c:v>
                      </c:pt>
                      <c:pt idx="59">
                        <c:v>8</c:v>
                      </c:pt>
                      <c:pt idx="60">
                        <c:v>9</c:v>
                      </c:pt>
                      <c:pt idx="61">
                        <c:v>10</c:v>
                      </c:pt>
                      <c:pt idx="62">
                        <c:v>11</c:v>
                      </c:pt>
                      <c:pt idx="63">
                        <c:v>12</c:v>
                      </c:pt>
                      <c:pt idx="64">
                        <c:v>13</c:v>
                      </c:pt>
                      <c:pt idx="65">
                        <c:v>14</c:v>
                      </c:pt>
                      <c:pt idx="66">
                        <c:v>15</c:v>
                      </c:pt>
                      <c:pt idx="67">
                        <c:v>16</c:v>
                      </c:pt>
                      <c:pt idx="68">
                        <c:v>17</c:v>
                      </c:pt>
                      <c:pt idx="69">
                        <c:v>18</c:v>
                      </c:pt>
                      <c:pt idx="70">
                        <c:v>19</c:v>
                      </c:pt>
                      <c:pt idx="71">
                        <c:v>20</c:v>
                      </c:pt>
                      <c:pt idx="72">
                        <c:v>21</c:v>
                      </c:pt>
                      <c:pt idx="73">
                        <c:v>22</c:v>
                      </c:pt>
                      <c:pt idx="74">
                        <c:v>23</c:v>
                      </c:pt>
                      <c:pt idx="75">
                        <c:v>24</c:v>
                      </c:pt>
                      <c:pt idx="76">
                        <c:v>25</c:v>
                      </c:pt>
                      <c:pt idx="77">
                        <c:v>26</c:v>
                      </c:pt>
                      <c:pt idx="78">
                        <c:v>27</c:v>
                      </c:pt>
                      <c:pt idx="79">
                        <c:v>28</c:v>
                      </c:pt>
                      <c:pt idx="80">
                        <c:v>29</c:v>
                      </c:pt>
                      <c:pt idx="81">
                        <c:v>30</c:v>
                      </c:pt>
                      <c:pt idx="82">
                        <c:v>31</c:v>
                      </c:pt>
                      <c:pt idx="83">
                        <c:v>32</c:v>
                      </c:pt>
                      <c:pt idx="84">
                        <c:v>33</c:v>
                      </c:pt>
                      <c:pt idx="85">
                        <c:v>34</c:v>
                      </c:pt>
                      <c:pt idx="86">
                        <c:v>35</c:v>
                      </c:pt>
                      <c:pt idx="87">
                        <c:v>36</c:v>
                      </c:pt>
                      <c:pt idx="88">
                        <c:v>37</c:v>
                      </c:pt>
                      <c:pt idx="89">
                        <c:v>38</c:v>
                      </c:pt>
                      <c:pt idx="90">
                        <c:v>39</c:v>
                      </c:pt>
                      <c:pt idx="91">
                        <c:v>40</c:v>
                      </c:pt>
                      <c:pt idx="92">
                        <c:v>41</c:v>
                      </c:pt>
                      <c:pt idx="93">
                        <c:v>42</c:v>
                      </c:pt>
                      <c:pt idx="94">
                        <c:v>43</c:v>
                      </c:pt>
                      <c:pt idx="95">
                        <c:v>44</c:v>
                      </c:pt>
                      <c:pt idx="96">
                        <c:v>45</c:v>
                      </c:pt>
                      <c:pt idx="97">
                        <c:v>46</c:v>
                      </c:pt>
                      <c:pt idx="98">
                        <c:v>47</c:v>
                      </c:pt>
                      <c:pt idx="99">
                        <c:v>48</c:v>
                      </c:pt>
                      <c:pt idx="100">
                        <c:v>49</c:v>
                      </c:pt>
                      <c:pt idx="101">
                        <c:v>50</c:v>
                      </c:pt>
                      <c:pt idx="102">
                        <c:v>51</c:v>
                      </c:pt>
                      <c:pt idx="103">
                        <c:v>52</c:v>
                      </c:pt>
                      <c:pt idx="104">
                        <c:v>1</c:v>
                      </c:pt>
                      <c:pt idx="105">
                        <c:v>2</c:v>
                      </c:pt>
                      <c:pt idx="106">
                        <c:v>3</c:v>
                      </c:pt>
                      <c:pt idx="107">
                        <c:v>4</c:v>
                      </c:pt>
                      <c:pt idx="108">
                        <c:v>5</c:v>
                      </c:pt>
                      <c:pt idx="109">
                        <c:v>6</c:v>
                      </c:pt>
                      <c:pt idx="110">
                        <c:v>7</c:v>
                      </c:pt>
                      <c:pt idx="111">
                        <c:v>8</c:v>
                      </c:pt>
                      <c:pt idx="112">
                        <c:v>9</c:v>
                      </c:pt>
                      <c:pt idx="113">
                        <c:v>10</c:v>
                      </c:pt>
                      <c:pt idx="114">
                        <c:v>11</c:v>
                      </c:pt>
                      <c:pt idx="115">
                        <c:v>12</c:v>
                      </c:pt>
                      <c:pt idx="116">
                        <c:v>13</c:v>
                      </c:pt>
                      <c:pt idx="117">
                        <c:v>14</c:v>
                      </c:pt>
                      <c:pt idx="118">
                        <c:v>15</c:v>
                      </c:pt>
                      <c:pt idx="119">
                        <c:v>16</c:v>
                      </c:pt>
                      <c:pt idx="120">
                        <c:v>17</c:v>
                      </c:pt>
                      <c:pt idx="121">
                        <c:v>18</c:v>
                      </c:pt>
                      <c:pt idx="122">
                        <c:v>19</c:v>
                      </c:pt>
                      <c:pt idx="123">
                        <c:v>20</c:v>
                      </c:pt>
                      <c:pt idx="124">
                        <c:v>21</c:v>
                      </c:pt>
                      <c:pt idx="125">
                        <c:v>22</c:v>
                      </c:pt>
                      <c:pt idx="126">
                        <c:v>23</c:v>
                      </c:pt>
                      <c:pt idx="127">
                        <c:v>24</c:v>
                      </c:pt>
                      <c:pt idx="128">
                        <c:v>25</c:v>
                      </c:pt>
                      <c:pt idx="129">
                        <c:v>26</c:v>
                      </c:pt>
                      <c:pt idx="130">
                        <c:v>27</c:v>
                      </c:pt>
                      <c:pt idx="131">
                        <c:v>28</c:v>
                      </c:pt>
                      <c:pt idx="132">
                        <c:v>29</c:v>
                      </c:pt>
                      <c:pt idx="133">
                        <c:v>30</c:v>
                      </c:pt>
                      <c:pt idx="134">
                        <c:v>31</c:v>
                      </c:pt>
                      <c:pt idx="135">
                        <c:v>32</c:v>
                      </c:pt>
                      <c:pt idx="136">
                        <c:v>33</c:v>
                      </c:pt>
                      <c:pt idx="137">
                        <c:v>34</c:v>
                      </c:pt>
                      <c:pt idx="138">
                        <c:v>35</c:v>
                      </c:pt>
                      <c:pt idx="139">
                        <c:v>36</c:v>
                      </c:pt>
                      <c:pt idx="140">
                        <c:v>37</c:v>
                      </c:pt>
                      <c:pt idx="141">
                        <c:v>38</c:v>
                      </c:pt>
                      <c:pt idx="142">
                        <c:v>39</c:v>
                      </c:pt>
                      <c:pt idx="143">
                        <c:v>40</c:v>
                      </c:pt>
                      <c:pt idx="144">
                        <c:v>41</c:v>
                      </c:pt>
                      <c:pt idx="145">
                        <c:v>42</c:v>
                      </c:pt>
                      <c:pt idx="146">
                        <c:v>43</c:v>
                      </c:pt>
                      <c:pt idx="147">
                        <c:v>44</c:v>
                      </c:pt>
                      <c:pt idx="148">
                        <c:v>45</c:v>
                      </c:pt>
                      <c:pt idx="149">
                        <c:v>46</c:v>
                      </c:pt>
                      <c:pt idx="150">
                        <c:v>47</c:v>
                      </c:pt>
                      <c:pt idx="151">
                        <c:v>48</c:v>
                      </c:pt>
                      <c:pt idx="152">
                        <c:v>49</c:v>
                      </c:pt>
                      <c:pt idx="153">
                        <c:v>50</c:v>
                      </c:pt>
                      <c:pt idx="154">
                        <c:v>51</c:v>
                      </c:pt>
                      <c:pt idx="155">
                        <c:v>52</c:v>
                      </c:pt>
                      <c:pt idx="156">
                        <c:v>1</c:v>
                      </c:pt>
                      <c:pt idx="157">
                        <c:v>2</c:v>
                      </c:pt>
                      <c:pt idx="158">
                        <c:v>3</c:v>
                      </c:pt>
                      <c:pt idx="159">
                        <c:v>4</c:v>
                      </c:pt>
                      <c:pt idx="160">
                        <c:v>5</c:v>
                      </c:pt>
                      <c:pt idx="161">
                        <c:v>6</c:v>
                      </c:pt>
                      <c:pt idx="162">
                        <c:v>7</c:v>
                      </c:pt>
                      <c:pt idx="163">
                        <c:v>8</c:v>
                      </c:pt>
                      <c:pt idx="164">
                        <c:v>9</c:v>
                      </c:pt>
                      <c:pt idx="165">
                        <c:v>10</c:v>
                      </c:pt>
                      <c:pt idx="166">
                        <c:v>11</c:v>
                      </c:pt>
                      <c:pt idx="167">
                        <c:v>12</c:v>
                      </c:pt>
                      <c:pt idx="168">
                        <c:v>13</c:v>
                      </c:pt>
                      <c:pt idx="169">
                        <c:v>14</c:v>
                      </c:pt>
                      <c:pt idx="170">
                        <c:v>15</c:v>
                      </c:pt>
                      <c:pt idx="171">
                        <c:v>16</c:v>
                      </c:pt>
                      <c:pt idx="172">
                        <c:v>17</c:v>
                      </c:pt>
                      <c:pt idx="173">
                        <c:v>18</c:v>
                      </c:pt>
                      <c:pt idx="174">
                        <c:v>19</c:v>
                      </c:pt>
                      <c:pt idx="175">
                        <c:v>20</c:v>
                      </c:pt>
                      <c:pt idx="176">
                        <c:v>21</c:v>
                      </c:pt>
                      <c:pt idx="177">
                        <c:v>22</c:v>
                      </c:pt>
                      <c:pt idx="178">
                        <c:v>23</c:v>
                      </c:pt>
                      <c:pt idx="179">
                        <c:v>24</c:v>
                      </c:pt>
                      <c:pt idx="180">
                        <c:v>25</c:v>
                      </c:pt>
                      <c:pt idx="181">
                        <c:v>26</c:v>
                      </c:pt>
                      <c:pt idx="182">
                        <c:v>27</c:v>
                      </c:pt>
                      <c:pt idx="183">
                        <c:v>28</c:v>
                      </c:pt>
                      <c:pt idx="184">
                        <c:v>29</c:v>
                      </c:pt>
                      <c:pt idx="185">
                        <c:v>30</c:v>
                      </c:pt>
                      <c:pt idx="186">
                        <c:v>31</c:v>
                      </c:pt>
                      <c:pt idx="187">
                        <c:v>32</c:v>
                      </c:pt>
                      <c:pt idx="188">
                        <c:v>33</c:v>
                      </c:pt>
                      <c:pt idx="189">
                        <c:v>34</c:v>
                      </c:pt>
                      <c:pt idx="190">
                        <c:v>35</c:v>
                      </c:pt>
                      <c:pt idx="191">
                        <c:v>36</c:v>
                      </c:pt>
                      <c:pt idx="192">
                        <c:v>37</c:v>
                      </c:pt>
                      <c:pt idx="193">
                        <c:v>38</c:v>
                      </c:pt>
                      <c:pt idx="194">
                        <c:v>39</c:v>
                      </c:pt>
                      <c:pt idx="195">
                        <c:v>40</c:v>
                      </c:pt>
                      <c:pt idx="196">
                        <c:v>41</c:v>
                      </c:pt>
                      <c:pt idx="197">
                        <c:v>42</c:v>
                      </c:pt>
                      <c:pt idx="198">
                        <c:v>43</c:v>
                      </c:pt>
                      <c:pt idx="199">
                        <c:v>44</c:v>
                      </c:pt>
                      <c:pt idx="200">
                        <c:v>45</c:v>
                      </c:pt>
                      <c:pt idx="201">
                        <c:v>46</c:v>
                      </c:pt>
                      <c:pt idx="202">
                        <c:v>47</c:v>
                      </c:pt>
                      <c:pt idx="203">
                        <c:v>48</c:v>
                      </c:pt>
                      <c:pt idx="204">
                        <c:v>49</c:v>
                      </c:pt>
                      <c:pt idx="205">
                        <c:v>50</c:v>
                      </c:pt>
                      <c:pt idx="206">
                        <c:v>51</c:v>
                      </c:pt>
                      <c:pt idx="207">
                        <c:v>52</c:v>
                      </c:pt>
                      <c:pt idx="208">
                        <c:v>53</c:v>
                      </c:pt>
                      <c:pt idx="209">
                        <c:v>1</c:v>
                      </c:pt>
                      <c:pt idx="210">
                        <c:v>2</c:v>
                      </c:pt>
                      <c:pt idx="211">
                        <c:v>3</c:v>
                      </c:pt>
                      <c:pt idx="212">
                        <c:v>4</c:v>
                      </c:pt>
                      <c:pt idx="213">
                        <c:v>5</c:v>
                      </c:pt>
                      <c:pt idx="214">
                        <c:v>6</c:v>
                      </c:pt>
                      <c:pt idx="215">
                        <c:v>7</c:v>
                      </c:pt>
                      <c:pt idx="216">
                        <c:v>8</c:v>
                      </c:pt>
                      <c:pt idx="217">
                        <c:v>9</c:v>
                      </c:pt>
                      <c:pt idx="218">
                        <c:v>10</c:v>
                      </c:pt>
                      <c:pt idx="219">
                        <c:v>11</c:v>
                      </c:pt>
                      <c:pt idx="220">
                        <c:v>12</c:v>
                      </c:pt>
                      <c:pt idx="221">
                        <c:v>13</c:v>
                      </c:pt>
                      <c:pt idx="222">
                        <c:v>14</c:v>
                      </c:pt>
                      <c:pt idx="223">
                        <c:v>15</c:v>
                      </c:pt>
                      <c:pt idx="224">
                        <c:v>16</c:v>
                      </c:pt>
                      <c:pt idx="225">
                        <c:v>17</c:v>
                      </c:pt>
                      <c:pt idx="226">
                        <c:v>18</c:v>
                      </c:pt>
                      <c:pt idx="227">
                        <c:v>19</c:v>
                      </c:pt>
                      <c:pt idx="228">
                        <c:v>20</c:v>
                      </c:pt>
                      <c:pt idx="229">
                        <c:v>21</c:v>
                      </c:pt>
                      <c:pt idx="230">
                        <c:v>22</c:v>
                      </c:pt>
                      <c:pt idx="231">
                        <c:v>23</c:v>
                      </c:pt>
                      <c:pt idx="232">
                        <c:v>24</c:v>
                      </c:pt>
                      <c:pt idx="233">
                        <c:v>25</c:v>
                      </c:pt>
                      <c:pt idx="234">
                        <c:v>26</c:v>
                      </c:pt>
                      <c:pt idx="235">
                        <c:v>27</c:v>
                      </c:pt>
                      <c:pt idx="236">
                        <c:v>28</c:v>
                      </c:pt>
                      <c:pt idx="237">
                        <c:v>29</c:v>
                      </c:pt>
                      <c:pt idx="238">
                        <c:v>30</c:v>
                      </c:pt>
                      <c:pt idx="239">
                        <c:v>31</c:v>
                      </c:pt>
                      <c:pt idx="240">
                        <c:v>32</c:v>
                      </c:pt>
                      <c:pt idx="241">
                        <c:v>33</c:v>
                      </c:pt>
                      <c:pt idx="242">
                        <c:v>34</c:v>
                      </c:pt>
                      <c:pt idx="243">
                        <c:v>35</c:v>
                      </c:pt>
                      <c:pt idx="244">
                        <c:v>36</c:v>
                      </c:pt>
                      <c:pt idx="245">
                        <c:v>37</c:v>
                      </c:pt>
                      <c:pt idx="246">
                        <c:v>38</c:v>
                      </c:pt>
                      <c:pt idx="247">
                        <c:v>39</c:v>
                      </c:pt>
                      <c:pt idx="248">
                        <c:v>40</c:v>
                      </c:pt>
                      <c:pt idx="249">
                        <c:v>41</c:v>
                      </c:pt>
                      <c:pt idx="250">
                        <c:v>42</c:v>
                      </c:pt>
                      <c:pt idx="251">
                        <c:v>43</c:v>
                      </c:pt>
                      <c:pt idx="252">
                        <c:v>44</c:v>
                      </c:pt>
                      <c:pt idx="253">
                        <c:v>45</c:v>
                      </c:pt>
                      <c:pt idx="254">
                        <c:v>46</c:v>
                      </c:pt>
                      <c:pt idx="255">
                        <c:v>47</c:v>
                      </c:pt>
                      <c:pt idx="256">
                        <c:v>48</c:v>
                      </c:pt>
                      <c:pt idx="257">
                        <c:v>49</c:v>
                      </c:pt>
                      <c:pt idx="258">
                        <c:v>50</c:v>
                      </c:pt>
                      <c:pt idx="259">
                        <c:v>51</c:v>
                      </c:pt>
                      <c:pt idx="260">
                        <c:v>52</c:v>
                      </c:pt>
                      <c:pt idx="261">
                        <c:v>1</c:v>
                      </c:pt>
                      <c:pt idx="262">
                        <c:v>2</c:v>
                      </c:pt>
                      <c:pt idx="263">
                        <c:v>3</c:v>
                      </c:pt>
                      <c:pt idx="264">
                        <c:v>4</c:v>
                      </c:pt>
                      <c:pt idx="265">
                        <c:v>5</c:v>
                      </c:pt>
                      <c:pt idx="266">
                        <c:v>6</c:v>
                      </c:pt>
                      <c:pt idx="267">
                        <c:v>7</c:v>
                      </c:pt>
                      <c:pt idx="268">
                        <c:v>8</c:v>
                      </c:pt>
                      <c:pt idx="269">
                        <c:v>9</c:v>
                      </c:pt>
                      <c:pt idx="270">
                        <c:v>10</c:v>
                      </c:pt>
                      <c:pt idx="271">
                        <c:v>11</c:v>
                      </c:pt>
                      <c:pt idx="272">
                        <c:v>12</c:v>
                      </c:pt>
                      <c:pt idx="273">
                        <c:v>13</c:v>
                      </c:pt>
                      <c:pt idx="274">
                        <c:v>14</c:v>
                      </c:pt>
                      <c:pt idx="275">
                        <c:v>15</c:v>
                      </c:pt>
                      <c:pt idx="276">
                        <c:v>16</c:v>
                      </c:pt>
                      <c:pt idx="277">
                        <c:v>17</c:v>
                      </c:pt>
                      <c:pt idx="278">
                        <c:v>18</c:v>
                      </c:pt>
                      <c:pt idx="279">
                        <c:v>19</c:v>
                      </c:pt>
                      <c:pt idx="280">
                        <c:v>20</c:v>
                      </c:pt>
                      <c:pt idx="281">
                        <c:v>21</c:v>
                      </c:pt>
                      <c:pt idx="282">
                        <c:v>22</c:v>
                      </c:pt>
                      <c:pt idx="283">
                        <c:v>23</c:v>
                      </c:pt>
                      <c:pt idx="284">
                        <c:v>24</c:v>
                      </c:pt>
                      <c:pt idx="285">
                        <c:v>25</c:v>
                      </c:pt>
                      <c:pt idx="286">
                        <c:v>26</c:v>
                      </c:pt>
                      <c:pt idx="287">
                        <c:v>27</c:v>
                      </c:pt>
                      <c:pt idx="288">
                        <c:v>28</c:v>
                      </c:pt>
                      <c:pt idx="289">
                        <c:v>29</c:v>
                      </c:pt>
                      <c:pt idx="290">
                        <c:v>30</c:v>
                      </c:pt>
                      <c:pt idx="291">
                        <c:v>31</c:v>
                      </c:pt>
                      <c:pt idx="292">
                        <c:v>32</c:v>
                      </c:pt>
                      <c:pt idx="293">
                        <c:v>33</c:v>
                      </c:pt>
                      <c:pt idx="294">
                        <c:v>34</c:v>
                      </c:pt>
                      <c:pt idx="295">
                        <c:v>35</c:v>
                      </c:pt>
                      <c:pt idx="296">
                        <c:v>36</c:v>
                      </c:pt>
                      <c:pt idx="297">
                        <c:v>37</c:v>
                      </c:pt>
                      <c:pt idx="298">
                        <c:v>38</c:v>
                      </c:pt>
                      <c:pt idx="299">
                        <c:v>39</c:v>
                      </c:pt>
                      <c:pt idx="300">
                        <c:v>40</c:v>
                      </c:pt>
                      <c:pt idx="301">
                        <c:v>41</c:v>
                      </c:pt>
                      <c:pt idx="302">
                        <c:v>42</c:v>
                      </c:pt>
                      <c:pt idx="303">
                        <c:v>43</c:v>
                      </c:pt>
                      <c:pt idx="304">
                        <c:v>44</c:v>
                      </c:pt>
                      <c:pt idx="305">
                        <c:v>45</c:v>
                      </c:pt>
                      <c:pt idx="306">
                        <c:v>46</c:v>
                      </c:pt>
                      <c:pt idx="307">
                        <c:v>47</c:v>
                      </c:pt>
                      <c:pt idx="308">
                        <c:v>48</c:v>
                      </c:pt>
                      <c:pt idx="309">
                        <c:v>49</c:v>
                      </c:pt>
                      <c:pt idx="310">
                        <c:v>50</c:v>
                      </c:pt>
                      <c:pt idx="311">
                        <c:v>51</c:v>
                      </c:pt>
                      <c:pt idx="312">
                        <c:v>52</c:v>
                      </c:pt>
                    </c:numCache>
                  </c:numRef>
                </c:cat>
                <c:val>
                  <c:numRef>
                    <c:extLst>
                      <c:ext uri="{02D57815-91ED-43cb-92C2-25804820EDAC}">
                        <c15:formulaRef>
                          <c15:sqref>Sheet1!$B$2:$B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57</c:v>
                      </c:pt>
                      <c:pt idx="1">
                        <c:v>65</c:v>
                      </c:pt>
                      <c:pt idx="2">
                        <c:v>178</c:v>
                      </c:pt>
                      <c:pt idx="3">
                        <c:v>186</c:v>
                      </c:pt>
                      <c:pt idx="4">
                        <c:v>138</c:v>
                      </c:pt>
                      <c:pt idx="5">
                        <c:v>191</c:v>
                      </c:pt>
                      <c:pt idx="6">
                        <c:v>113</c:v>
                      </c:pt>
                      <c:pt idx="7">
                        <c:v>107</c:v>
                      </c:pt>
                      <c:pt idx="8">
                        <c:v>129</c:v>
                      </c:pt>
                      <c:pt idx="9">
                        <c:v>109</c:v>
                      </c:pt>
                      <c:pt idx="10">
                        <c:v>101</c:v>
                      </c:pt>
                      <c:pt idx="11">
                        <c:v>92</c:v>
                      </c:pt>
                      <c:pt idx="12">
                        <c:v>65</c:v>
                      </c:pt>
                      <c:pt idx="13">
                        <c:v>25</c:v>
                      </c:pt>
                      <c:pt idx="14">
                        <c:v>36</c:v>
                      </c:pt>
                      <c:pt idx="15">
                        <c:v>41</c:v>
                      </c:pt>
                      <c:pt idx="16">
                        <c:v>28</c:v>
                      </c:pt>
                      <c:pt idx="17">
                        <c:v>50</c:v>
                      </c:pt>
                      <c:pt idx="18">
                        <c:v>21</c:v>
                      </c:pt>
                      <c:pt idx="19">
                        <c:v>19</c:v>
                      </c:pt>
                      <c:pt idx="20">
                        <c:v>26</c:v>
                      </c:pt>
                      <c:pt idx="21">
                        <c:v>18</c:v>
                      </c:pt>
                      <c:pt idx="22">
                        <c:v>18</c:v>
                      </c:pt>
                      <c:pt idx="23">
                        <c:v>25</c:v>
                      </c:pt>
                      <c:pt idx="24">
                        <c:v>28</c:v>
                      </c:pt>
                      <c:pt idx="25">
                        <c:v>45</c:v>
                      </c:pt>
                      <c:pt idx="26">
                        <c:v>20</c:v>
                      </c:pt>
                      <c:pt idx="27">
                        <c:v>31</c:v>
                      </c:pt>
                      <c:pt idx="28">
                        <c:v>76</c:v>
                      </c:pt>
                      <c:pt idx="29">
                        <c:v>52</c:v>
                      </c:pt>
                      <c:pt idx="30">
                        <c:v>41</c:v>
                      </c:pt>
                      <c:pt idx="31">
                        <c:v>31</c:v>
                      </c:pt>
                      <c:pt idx="32">
                        <c:v>35</c:v>
                      </c:pt>
                      <c:pt idx="33">
                        <c:v>21</c:v>
                      </c:pt>
                      <c:pt idx="34">
                        <c:v>16</c:v>
                      </c:pt>
                      <c:pt idx="35">
                        <c:v>23</c:v>
                      </c:pt>
                      <c:pt idx="36">
                        <c:v>33</c:v>
                      </c:pt>
                      <c:pt idx="37">
                        <c:v>28</c:v>
                      </c:pt>
                      <c:pt idx="38">
                        <c:v>20</c:v>
                      </c:pt>
                      <c:pt idx="39">
                        <c:v>11</c:v>
                      </c:pt>
                      <c:pt idx="40">
                        <c:v>26</c:v>
                      </c:pt>
                      <c:pt idx="41">
                        <c:v>22</c:v>
                      </c:pt>
                      <c:pt idx="42">
                        <c:v>13</c:v>
                      </c:pt>
                      <c:pt idx="43">
                        <c:v>23</c:v>
                      </c:pt>
                      <c:pt idx="44">
                        <c:v>22</c:v>
                      </c:pt>
                      <c:pt idx="45">
                        <c:v>25</c:v>
                      </c:pt>
                      <c:pt idx="46">
                        <c:v>17</c:v>
                      </c:pt>
                      <c:pt idx="47">
                        <c:v>16</c:v>
                      </c:pt>
                      <c:pt idx="48">
                        <c:v>18</c:v>
                      </c:pt>
                      <c:pt idx="49">
                        <c:v>18</c:v>
                      </c:pt>
                      <c:pt idx="50">
                        <c:v>28</c:v>
                      </c:pt>
                      <c:pt idx="51">
                        <c:v>28</c:v>
                      </c:pt>
                      <c:pt idx="52">
                        <c:v>42</c:v>
                      </c:pt>
                      <c:pt idx="53">
                        <c:v>33</c:v>
                      </c:pt>
                      <c:pt idx="54">
                        <c:v>44</c:v>
                      </c:pt>
                      <c:pt idx="55">
                        <c:v>71</c:v>
                      </c:pt>
                      <c:pt idx="56">
                        <c:v>58</c:v>
                      </c:pt>
                      <c:pt idx="57">
                        <c:v>75</c:v>
                      </c:pt>
                      <c:pt idx="58">
                        <c:v>81</c:v>
                      </c:pt>
                      <c:pt idx="59">
                        <c:v>39</c:v>
                      </c:pt>
                      <c:pt idx="60">
                        <c:v>34</c:v>
                      </c:pt>
                      <c:pt idx="61">
                        <c:v>48</c:v>
                      </c:pt>
                      <c:pt idx="62">
                        <c:v>45</c:v>
                      </c:pt>
                      <c:pt idx="63">
                        <c:v>44</c:v>
                      </c:pt>
                      <c:pt idx="64">
                        <c:v>24</c:v>
                      </c:pt>
                      <c:pt idx="65">
                        <c:v>23</c:v>
                      </c:pt>
                      <c:pt idx="66">
                        <c:v>22</c:v>
                      </c:pt>
                      <c:pt idx="67">
                        <c:v>20</c:v>
                      </c:pt>
                      <c:pt idx="68">
                        <c:v>40</c:v>
                      </c:pt>
                      <c:pt idx="69">
                        <c:v>42</c:v>
                      </c:pt>
                      <c:pt idx="70">
                        <c:v>29</c:v>
                      </c:pt>
                      <c:pt idx="71">
                        <c:v>22</c:v>
                      </c:pt>
                      <c:pt idx="72">
                        <c:v>30</c:v>
                      </c:pt>
                      <c:pt idx="73">
                        <c:v>14</c:v>
                      </c:pt>
                      <c:pt idx="74">
                        <c:v>22</c:v>
                      </c:pt>
                      <c:pt idx="75">
                        <c:v>24</c:v>
                      </c:pt>
                      <c:pt idx="76">
                        <c:v>18</c:v>
                      </c:pt>
                      <c:pt idx="77">
                        <c:v>35</c:v>
                      </c:pt>
                      <c:pt idx="78">
                        <c:v>33</c:v>
                      </c:pt>
                      <c:pt idx="79">
                        <c:v>65</c:v>
                      </c:pt>
                      <c:pt idx="80">
                        <c:v>50</c:v>
                      </c:pt>
                      <c:pt idx="81">
                        <c:v>35</c:v>
                      </c:pt>
                      <c:pt idx="82">
                        <c:v>34</c:v>
                      </c:pt>
                      <c:pt idx="83">
                        <c:v>23</c:v>
                      </c:pt>
                      <c:pt idx="84">
                        <c:v>45</c:v>
                      </c:pt>
                      <c:pt idx="85">
                        <c:v>17</c:v>
                      </c:pt>
                      <c:pt idx="86">
                        <c:v>15</c:v>
                      </c:pt>
                      <c:pt idx="87">
                        <c:v>13</c:v>
                      </c:pt>
                      <c:pt idx="88">
                        <c:v>12</c:v>
                      </c:pt>
                      <c:pt idx="89">
                        <c:v>36</c:v>
                      </c:pt>
                      <c:pt idx="90">
                        <c:v>13</c:v>
                      </c:pt>
                      <c:pt idx="91">
                        <c:v>18</c:v>
                      </c:pt>
                      <c:pt idx="92">
                        <c:v>11</c:v>
                      </c:pt>
                      <c:pt idx="93">
                        <c:v>12</c:v>
                      </c:pt>
                      <c:pt idx="94">
                        <c:v>16</c:v>
                      </c:pt>
                      <c:pt idx="95">
                        <c:v>6</c:v>
                      </c:pt>
                      <c:pt idx="96">
                        <c:v>17</c:v>
                      </c:pt>
                      <c:pt idx="97">
                        <c:v>10</c:v>
                      </c:pt>
                      <c:pt idx="98">
                        <c:v>12</c:v>
                      </c:pt>
                      <c:pt idx="99">
                        <c:v>32</c:v>
                      </c:pt>
                      <c:pt idx="100">
                        <c:v>28</c:v>
                      </c:pt>
                      <c:pt idx="101">
                        <c:v>20</c:v>
                      </c:pt>
                      <c:pt idx="102">
                        <c:v>24</c:v>
                      </c:pt>
                      <c:pt idx="103">
                        <c:v>24</c:v>
                      </c:pt>
                      <c:pt idx="104">
                        <c:v>41</c:v>
                      </c:pt>
                      <c:pt idx="105">
                        <c:v>34</c:v>
                      </c:pt>
                      <c:pt idx="106">
                        <c:v>59</c:v>
                      </c:pt>
                      <c:pt idx="107">
                        <c:v>97</c:v>
                      </c:pt>
                      <c:pt idx="108">
                        <c:v>85</c:v>
                      </c:pt>
                      <c:pt idx="109">
                        <c:v>54</c:v>
                      </c:pt>
                      <c:pt idx="110">
                        <c:v>76</c:v>
                      </c:pt>
                      <c:pt idx="111">
                        <c:v>63</c:v>
                      </c:pt>
                      <c:pt idx="112">
                        <c:v>70</c:v>
                      </c:pt>
                      <c:pt idx="113">
                        <c:v>70</c:v>
                      </c:pt>
                      <c:pt idx="114">
                        <c:v>77</c:v>
                      </c:pt>
                      <c:pt idx="115">
                        <c:v>68</c:v>
                      </c:pt>
                      <c:pt idx="116">
                        <c:v>32</c:v>
                      </c:pt>
                      <c:pt idx="117">
                        <c:v>18</c:v>
                      </c:pt>
                      <c:pt idx="118">
                        <c:v>22</c:v>
                      </c:pt>
                      <c:pt idx="119">
                        <c:v>33</c:v>
                      </c:pt>
                      <c:pt idx="120">
                        <c:v>23</c:v>
                      </c:pt>
                      <c:pt idx="121">
                        <c:v>23</c:v>
                      </c:pt>
                      <c:pt idx="122">
                        <c:v>29</c:v>
                      </c:pt>
                      <c:pt idx="123">
                        <c:v>18</c:v>
                      </c:pt>
                      <c:pt idx="124">
                        <c:v>15</c:v>
                      </c:pt>
                      <c:pt idx="125">
                        <c:v>36</c:v>
                      </c:pt>
                      <c:pt idx="126">
                        <c:v>22</c:v>
                      </c:pt>
                      <c:pt idx="127">
                        <c:v>28</c:v>
                      </c:pt>
                      <c:pt idx="128">
                        <c:v>30</c:v>
                      </c:pt>
                      <c:pt idx="129">
                        <c:v>26</c:v>
                      </c:pt>
                      <c:pt idx="130">
                        <c:v>40</c:v>
                      </c:pt>
                      <c:pt idx="131">
                        <c:v>36</c:v>
                      </c:pt>
                      <c:pt idx="132">
                        <c:v>46</c:v>
                      </c:pt>
                      <c:pt idx="133">
                        <c:v>46</c:v>
                      </c:pt>
                      <c:pt idx="134">
                        <c:v>25</c:v>
                      </c:pt>
                      <c:pt idx="135">
                        <c:v>28</c:v>
                      </c:pt>
                      <c:pt idx="136">
                        <c:v>21</c:v>
                      </c:pt>
                      <c:pt idx="137">
                        <c:v>16</c:v>
                      </c:pt>
                      <c:pt idx="138">
                        <c:v>18</c:v>
                      </c:pt>
                      <c:pt idx="139">
                        <c:v>14</c:v>
                      </c:pt>
                      <c:pt idx="140">
                        <c:v>34</c:v>
                      </c:pt>
                      <c:pt idx="141">
                        <c:v>24</c:v>
                      </c:pt>
                      <c:pt idx="142">
                        <c:v>20</c:v>
                      </c:pt>
                      <c:pt idx="143">
                        <c:v>17</c:v>
                      </c:pt>
                      <c:pt idx="144">
                        <c:v>15</c:v>
                      </c:pt>
                      <c:pt idx="145">
                        <c:v>26</c:v>
                      </c:pt>
                      <c:pt idx="146">
                        <c:v>16</c:v>
                      </c:pt>
                      <c:pt idx="147">
                        <c:v>15</c:v>
                      </c:pt>
                      <c:pt idx="148">
                        <c:v>21</c:v>
                      </c:pt>
                      <c:pt idx="149">
                        <c:v>18</c:v>
                      </c:pt>
                      <c:pt idx="150">
                        <c:v>26</c:v>
                      </c:pt>
                      <c:pt idx="151">
                        <c:v>45</c:v>
                      </c:pt>
                      <c:pt idx="152">
                        <c:v>40</c:v>
                      </c:pt>
                      <c:pt idx="153">
                        <c:v>53</c:v>
                      </c:pt>
                      <c:pt idx="154">
                        <c:v>71</c:v>
                      </c:pt>
                      <c:pt idx="155">
                        <c:v>132</c:v>
                      </c:pt>
                      <c:pt idx="156">
                        <c:v>142</c:v>
                      </c:pt>
                      <c:pt idx="157">
                        <c:v>64</c:v>
                      </c:pt>
                      <c:pt idx="158">
                        <c:v>105</c:v>
                      </c:pt>
                      <c:pt idx="159">
                        <c:v>90</c:v>
                      </c:pt>
                      <c:pt idx="160">
                        <c:v>62</c:v>
                      </c:pt>
                      <c:pt idx="161">
                        <c:v>33</c:v>
                      </c:pt>
                      <c:pt idx="162">
                        <c:v>43</c:v>
                      </c:pt>
                      <c:pt idx="163">
                        <c:v>48</c:v>
                      </c:pt>
                      <c:pt idx="164">
                        <c:v>31</c:v>
                      </c:pt>
                      <c:pt idx="165">
                        <c:v>21</c:v>
                      </c:pt>
                      <c:pt idx="166">
                        <c:v>12</c:v>
                      </c:pt>
                      <c:pt idx="167">
                        <c:v>29</c:v>
                      </c:pt>
                      <c:pt idx="168">
                        <c:v>23</c:v>
                      </c:pt>
                      <c:pt idx="169">
                        <c:v>16</c:v>
                      </c:pt>
                      <c:pt idx="170">
                        <c:v>14</c:v>
                      </c:pt>
                      <c:pt idx="171">
                        <c:v>16</c:v>
                      </c:pt>
                      <c:pt idx="172">
                        <c:v>25</c:v>
                      </c:pt>
                      <c:pt idx="173">
                        <c:v>30</c:v>
                      </c:pt>
                      <c:pt idx="174">
                        <c:v>31</c:v>
                      </c:pt>
                      <c:pt idx="175">
                        <c:v>20</c:v>
                      </c:pt>
                      <c:pt idx="176">
                        <c:v>16</c:v>
                      </c:pt>
                      <c:pt idx="177">
                        <c:v>36</c:v>
                      </c:pt>
                      <c:pt idx="178">
                        <c:v>23</c:v>
                      </c:pt>
                      <c:pt idx="179">
                        <c:v>28</c:v>
                      </c:pt>
                      <c:pt idx="180">
                        <c:v>18</c:v>
                      </c:pt>
                      <c:pt idx="181">
                        <c:v>25</c:v>
                      </c:pt>
                      <c:pt idx="182">
                        <c:v>28</c:v>
                      </c:pt>
                      <c:pt idx="183">
                        <c:v>44</c:v>
                      </c:pt>
                      <c:pt idx="184">
                        <c:v>39</c:v>
                      </c:pt>
                      <c:pt idx="185">
                        <c:v>62</c:v>
                      </c:pt>
                      <c:pt idx="186">
                        <c:v>38</c:v>
                      </c:pt>
                      <c:pt idx="187">
                        <c:v>33</c:v>
                      </c:pt>
                      <c:pt idx="188">
                        <c:v>42</c:v>
                      </c:pt>
                      <c:pt idx="189">
                        <c:v>24</c:v>
                      </c:pt>
                      <c:pt idx="190">
                        <c:v>17</c:v>
                      </c:pt>
                      <c:pt idx="191">
                        <c:v>21</c:v>
                      </c:pt>
                      <c:pt idx="192">
                        <c:v>21</c:v>
                      </c:pt>
                      <c:pt idx="193">
                        <c:v>30</c:v>
                      </c:pt>
                      <c:pt idx="194">
                        <c:v>37</c:v>
                      </c:pt>
                      <c:pt idx="195">
                        <c:v>22</c:v>
                      </c:pt>
                      <c:pt idx="196">
                        <c:v>22</c:v>
                      </c:pt>
                      <c:pt idx="197">
                        <c:v>29</c:v>
                      </c:pt>
                      <c:pt idx="198">
                        <c:v>23</c:v>
                      </c:pt>
                      <c:pt idx="199">
                        <c:v>18</c:v>
                      </c:pt>
                      <c:pt idx="200">
                        <c:v>22</c:v>
                      </c:pt>
                      <c:pt idx="201">
                        <c:v>33</c:v>
                      </c:pt>
                      <c:pt idx="202">
                        <c:v>25</c:v>
                      </c:pt>
                      <c:pt idx="203">
                        <c:v>27</c:v>
                      </c:pt>
                      <c:pt idx="204">
                        <c:v>34</c:v>
                      </c:pt>
                      <c:pt idx="205">
                        <c:v>29</c:v>
                      </c:pt>
                      <c:pt idx="206">
                        <c:v>46</c:v>
                      </c:pt>
                      <c:pt idx="207">
                        <c:v>25</c:v>
                      </c:pt>
                      <c:pt idx="208">
                        <c:v>58</c:v>
                      </c:pt>
                      <c:pt idx="209">
                        <c:v>25</c:v>
                      </c:pt>
                      <c:pt idx="210">
                        <c:v>35</c:v>
                      </c:pt>
                      <c:pt idx="211">
                        <c:v>46</c:v>
                      </c:pt>
                      <c:pt idx="212">
                        <c:v>93</c:v>
                      </c:pt>
                      <c:pt idx="213">
                        <c:v>121</c:v>
                      </c:pt>
                      <c:pt idx="214">
                        <c:v>183</c:v>
                      </c:pt>
                      <c:pt idx="215">
                        <c:v>130</c:v>
                      </c:pt>
                      <c:pt idx="216">
                        <c:v>121</c:v>
                      </c:pt>
                      <c:pt idx="217">
                        <c:v>125</c:v>
                      </c:pt>
                      <c:pt idx="218">
                        <c:v>70</c:v>
                      </c:pt>
                      <c:pt idx="219">
                        <c:v>61</c:v>
                      </c:pt>
                      <c:pt idx="220">
                        <c:v>72</c:v>
                      </c:pt>
                      <c:pt idx="221">
                        <c:v>26</c:v>
                      </c:pt>
                      <c:pt idx="222">
                        <c:v>32</c:v>
                      </c:pt>
                      <c:pt idx="223">
                        <c:v>26</c:v>
                      </c:pt>
                      <c:pt idx="224">
                        <c:v>25</c:v>
                      </c:pt>
                      <c:pt idx="225">
                        <c:v>22</c:v>
                      </c:pt>
                      <c:pt idx="226">
                        <c:v>33</c:v>
                      </c:pt>
                      <c:pt idx="227">
                        <c:v>23</c:v>
                      </c:pt>
                      <c:pt idx="228">
                        <c:v>22</c:v>
                      </c:pt>
                      <c:pt idx="229">
                        <c:v>27</c:v>
                      </c:pt>
                      <c:pt idx="230">
                        <c:v>18</c:v>
                      </c:pt>
                      <c:pt idx="231">
                        <c:v>21</c:v>
                      </c:pt>
                      <c:pt idx="232">
                        <c:v>27</c:v>
                      </c:pt>
                      <c:pt idx="233">
                        <c:v>32</c:v>
                      </c:pt>
                      <c:pt idx="234">
                        <c:v>40</c:v>
                      </c:pt>
                      <c:pt idx="235">
                        <c:v>40</c:v>
                      </c:pt>
                      <c:pt idx="236">
                        <c:v>40</c:v>
                      </c:pt>
                      <c:pt idx="237">
                        <c:v>60</c:v>
                      </c:pt>
                      <c:pt idx="238">
                        <c:v>27</c:v>
                      </c:pt>
                      <c:pt idx="239">
                        <c:v>29</c:v>
                      </c:pt>
                      <c:pt idx="240">
                        <c:v>35</c:v>
                      </c:pt>
                      <c:pt idx="241">
                        <c:v>27</c:v>
                      </c:pt>
                      <c:pt idx="242">
                        <c:v>28</c:v>
                      </c:pt>
                      <c:pt idx="243">
                        <c:v>19</c:v>
                      </c:pt>
                      <c:pt idx="244">
                        <c:v>24</c:v>
                      </c:pt>
                      <c:pt idx="245">
                        <c:v>25</c:v>
                      </c:pt>
                      <c:pt idx="246">
                        <c:v>40</c:v>
                      </c:pt>
                      <c:pt idx="247">
                        <c:v>21</c:v>
                      </c:pt>
                      <c:pt idx="248">
                        <c:v>23</c:v>
                      </c:pt>
                      <c:pt idx="249">
                        <c:v>44</c:v>
                      </c:pt>
                      <c:pt idx="250">
                        <c:v>26</c:v>
                      </c:pt>
                      <c:pt idx="251">
                        <c:v>29</c:v>
                      </c:pt>
                      <c:pt idx="252">
                        <c:v>29</c:v>
                      </c:pt>
                      <c:pt idx="253">
                        <c:v>27</c:v>
                      </c:pt>
                      <c:pt idx="254">
                        <c:v>37</c:v>
                      </c:pt>
                      <c:pt idx="255">
                        <c:v>44</c:v>
                      </c:pt>
                      <c:pt idx="256">
                        <c:v>37</c:v>
                      </c:pt>
                      <c:pt idx="257">
                        <c:v>31</c:v>
                      </c:pt>
                      <c:pt idx="258">
                        <c:v>38</c:v>
                      </c:pt>
                      <c:pt idx="259">
                        <c:v>52</c:v>
                      </c:pt>
                      <c:pt idx="260">
                        <c:v>41</c:v>
                      </c:pt>
                      <c:pt idx="261">
                        <c:v>50</c:v>
                      </c:pt>
                      <c:pt idx="262">
                        <c:v>47</c:v>
                      </c:pt>
                      <c:pt idx="263">
                        <c:v>76</c:v>
                      </c:pt>
                      <c:pt idx="264">
                        <c:v>83</c:v>
                      </c:pt>
                      <c:pt idx="265">
                        <c:v>84</c:v>
                      </c:pt>
                      <c:pt idx="266">
                        <c:v>74</c:v>
                      </c:pt>
                      <c:pt idx="267">
                        <c:v>52</c:v>
                      </c:pt>
                      <c:pt idx="268">
                        <c:v>43</c:v>
                      </c:pt>
                      <c:pt idx="269">
                        <c:v>31</c:v>
                      </c:pt>
                      <c:pt idx="270">
                        <c:v>24</c:v>
                      </c:pt>
                      <c:pt idx="271">
                        <c:v>33</c:v>
                      </c:pt>
                      <c:pt idx="272">
                        <c:v>22</c:v>
                      </c:pt>
                      <c:pt idx="273">
                        <c:v>18</c:v>
                      </c:pt>
                      <c:pt idx="274">
                        <c:v>19</c:v>
                      </c:pt>
                      <c:pt idx="275">
                        <c:v>16</c:v>
                      </c:pt>
                      <c:pt idx="276">
                        <c:v>18</c:v>
                      </c:pt>
                      <c:pt idx="277">
                        <c:v>35</c:v>
                      </c:pt>
                      <c:pt idx="278">
                        <c:v>52</c:v>
                      </c:pt>
                      <c:pt idx="279">
                        <c:v>23</c:v>
                      </c:pt>
                      <c:pt idx="280">
                        <c:v>14</c:v>
                      </c:pt>
                      <c:pt idx="281">
                        <c:v>13</c:v>
                      </c:pt>
                      <c:pt idx="282">
                        <c:v>18</c:v>
                      </c:pt>
                      <c:pt idx="283">
                        <c:v>21</c:v>
                      </c:pt>
                      <c:pt idx="284">
                        <c:v>29</c:v>
                      </c:pt>
                      <c:pt idx="285">
                        <c:v>25</c:v>
                      </c:pt>
                      <c:pt idx="286">
                        <c:v>24</c:v>
                      </c:pt>
                      <c:pt idx="287">
                        <c:v>37</c:v>
                      </c:pt>
                      <c:pt idx="288">
                        <c:v>34</c:v>
                      </c:pt>
                      <c:pt idx="289">
                        <c:v>54</c:v>
                      </c:pt>
                      <c:pt idx="290">
                        <c:v>34</c:v>
                      </c:pt>
                      <c:pt idx="291">
                        <c:v>35</c:v>
                      </c:pt>
                      <c:pt idx="292">
                        <c:v>46</c:v>
                      </c:pt>
                      <c:pt idx="293">
                        <c:v>29</c:v>
                      </c:pt>
                      <c:pt idx="294">
                        <c:v>16</c:v>
                      </c:pt>
                      <c:pt idx="295">
                        <c:v>24</c:v>
                      </c:pt>
                      <c:pt idx="296">
                        <c:v>15</c:v>
                      </c:pt>
                      <c:pt idx="297">
                        <c:v>21</c:v>
                      </c:pt>
                      <c:pt idx="298">
                        <c:v>21</c:v>
                      </c:pt>
                      <c:pt idx="299">
                        <c:v>16</c:v>
                      </c:pt>
                      <c:pt idx="300">
                        <c:v>14</c:v>
                      </c:pt>
                      <c:pt idx="301">
                        <c:v>33</c:v>
                      </c:pt>
                      <c:pt idx="302">
                        <c:v>13</c:v>
                      </c:pt>
                      <c:pt idx="303">
                        <c:v>22</c:v>
                      </c:pt>
                      <c:pt idx="304">
                        <c:v>19</c:v>
                      </c:pt>
                      <c:pt idx="305">
                        <c:v>14</c:v>
                      </c:pt>
                      <c:pt idx="306">
                        <c:v>11</c:v>
                      </c:pt>
                      <c:pt idx="307">
                        <c:v>22</c:v>
                      </c:pt>
                      <c:pt idx="308">
                        <c:v>22</c:v>
                      </c:pt>
                      <c:pt idx="309">
                        <c:v>33</c:v>
                      </c:pt>
                      <c:pt idx="310">
                        <c:v>44</c:v>
                      </c:pt>
                      <c:pt idx="311">
                        <c:v>63</c:v>
                      </c:pt>
                      <c:pt idx="312">
                        <c:v>88</c:v>
                      </c:pt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0-1B3D-4EC0-A8D6-5E64F831BF17}"/>
                  </c:ext>
                </c:extLst>
              </c15:ser>
            </c15:filteredLineSeries>
            <c15:filteredLine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1</c15:sqref>
                        </c15:formulaRef>
                      </c:ext>
                    </c:extLst>
                    <c:strCache>
                      <c:ptCount val="1"/>
                      <c:pt idx="0">
                        <c:v>Week係数</c:v>
                      </c:pt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/>
                    </a:solidFill>
                    <a:ln w="9525">
                      <a:solidFill>
                        <a:schemeClr val="accent3"/>
                      </a:solidFill>
                    </a:ln>
                    <a:effectLst/>
                  </c:spPr>
                </c:marker>
                <c:cat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A$2:$A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1</c:v>
                      </c:pt>
                      <c:pt idx="1">
                        <c:v>2</c:v>
                      </c:pt>
                      <c:pt idx="2">
                        <c:v>3</c:v>
                      </c:pt>
                      <c:pt idx="3">
                        <c:v>4</c:v>
                      </c:pt>
                      <c:pt idx="4">
                        <c:v>5</c:v>
                      </c:pt>
                      <c:pt idx="5">
                        <c:v>6</c:v>
                      </c:pt>
                      <c:pt idx="6">
                        <c:v>7</c:v>
                      </c:pt>
                      <c:pt idx="7">
                        <c:v>8</c:v>
                      </c:pt>
                      <c:pt idx="8">
                        <c:v>9</c:v>
                      </c:pt>
                      <c:pt idx="9">
                        <c:v>10</c:v>
                      </c:pt>
                      <c:pt idx="10">
                        <c:v>11</c:v>
                      </c:pt>
                      <c:pt idx="11">
                        <c:v>12</c:v>
                      </c:pt>
                      <c:pt idx="12">
                        <c:v>13</c:v>
                      </c:pt>
                      <c:pt idx="13">
                        <c:v>14</c:v>
                      </c:pt>
                      <c:pt idx="14">
                        <c:v>15</c:v>
                      </c:pt>
                      <c:pt idx="15">
                        <c:v>16</c:v>
                      </c:pt>
                      <c:pt idx="16">
                        <c:v>17</c:v>
                      </c:pt>
                      <c:pt idx="17">
                        <c:v>18</c:v>
                      </c:pt>
                      <c:pt idx="18">
                        <c:v>19</c:v>
                      </c:pt>
                      <c:pt idx="19">
                        <c:v>20</c:v>
                      </c:pt>
                      <c:pt idx="20">
                        <c:v>21</c:v>
                      </c:pt>
                      <c:pt idx="21">
                        <c:v>22</c:v>
                      </c:pt>
                      <c:pt idx="22">
                        <c:v>23</c:v>
                      </c:pt>
                      <c:pt idx="23">
                        <c:v>24</c:v>
                      </c:pt>
                      <c:pt idx="24">
                        <c:v>25</c:v>
                      </c:pt>
                      <c:pt idx="25">
                        <c:v>26</c:v>
                      </c:pt>
                      <c:pt idx="26">
                        <c:v>27</c:v>
                      </c:pt>
                      <c:pt idx="27">
                        <c:v>28</c:v>
                      </c:pt>
                      <c:pt idx="28">
                        <c:v>29</c:v>
                      </c:pt>
                      <c:pt idx="29">
                        <c:v>30</c:v>
                      </c:pt>
                      <c:pt idx="30">
                        <c:v>31</c:v>
                      </c:pt>
                      <c:pt idx="31">
                        <c:v>32</c:v>
                      </c:pt>
                      <c:pt idx="32">
                        <c:v>33</c:v>
                      </c:pt>
                      <c:pt idx="33">
                        <c:v>34</c:v>
                      </c:pt>
                      <c:pt idx="34">
                        <c:v>35</c:v>
                      </c:pt>
                      <c:pt idx="35">
                        <c:v>36</c:v>
                      </c:pt>
                      <c:pt idx="36">
                        <c:v>37</c:v>
                      </c:pt>
                      <c:pt idx="37">
                        <c:v>38</c:v>
                      </c:pt>
                      <c:pt idx="38">
                        <c:v>39</c:v>
                      </c:pt>
                      <c:pt idx="39">
                        <c:v>40</c:v>
                      </c:pt>
                      <c:pt idx="40">
                        <c:v>41</c:v>
                      </c:pt>
                      <c:pt idx="41">
                        <c:v>42</c:v>
                      </c:pt>
                      <c:pt idx="42">
                        <c:v>43</c:v>
                      </c:pt>
                      <c:pt idx="43">
                        <c:v>44</c:v>
                      </c:pt>
                      <c:pt idx="44">
                        <c:v>45</c:v>
                      </c:pt>
                      <c:pt idx="45">
                        <c:v>46</c:v>
                      </c:pt>
                      <c:pt idx="46">
                        <c:v>47</c:v>
                      </c:pt>
                      <c:pt idx="47">
                        <c:v>48</c:v>
                      </c:pt>
                      <c:pt idx="48">
                        <c:v>49</c:v>
                      </c:pt>
                      <c:pt idx="49">
                        <c:v>50</c:v>
                      </c:pt>
                      <c:pt idx="50">
                        <c:v>51</c:v>
                      </c:pt>
                      <c:pt idx="51">
                        <c:v>52</c:v>
                      </c:pt>
                      <c:pt idx="52">
                        <c:v>1</c:v>
                      </c:pt>
                      <c:pt idx="53">
                        <c:v>2</c:v>
                      </c:pt>
                      <c:pt idx="54">
                        <c:v>3</c:v>
                      </c:pt>
                      <c:pt idx="55">
                        <c:v>4</c:v>
                      </c:pt>
                      <c:pt idx="56">
                        <c:v>5</c:v>
                      </c:pt>
                      <c:pt idx="57">
                        <c:v>6</c:v>
                      </c:pt>
                      <c:pt idx="58">
                        <c:v>7</c:v>
                      </c:pt>
                      <c:pt idx="59">
                        <c:v>8</c:v>
                      </c:pt>
                      <c:pt idx="60">
                        <c:v>9</c:v>
                      </c:pt>
                      <c:pt idx="61">
                        <c:v>10</c:v>
                      </c:pt>
                      <c:pt idx="62">
                        <c:v>11</c:v>
                      </c:pt>
                      <c:pt idx="63">
                        <c:v>12</c:v>
                      </c:pt>
                      <c:pt idx="64">
                        <c:v>13</c:v>
                      </c:pt>
                      <c:pt idx="65">
                        <c:v>14</c:v>
                      </c:pt>
                      <c:pt idx="66">
                        <c:v>15</c:v>
                      </c:pt>
                      <c:pt idx="67">
                        <c:v>16</c:v>
                      </c:pt>
                      <c:pt idx="68">
                        <c:v>17</c:v>
                      </c:pt>
                      <c:pt idx="69">
                        <c:v>18</c:v>
                      </c:pt>
                      <c:pt idx="70">
                        <c:v>19</c:v>
                      </c:pt>
                      <c:pt idx="71">
                        <c:v>20</c:v>
                      </c:pt>
                      <c:pt idx="72">
                        <c:v>21</c:v>
                      </c:pt>
                      <c:pt idx="73">
                        <c:v>22</c:v>
                      </c:pt>
                      <c:pt idx="74">
                        <c:v>23</c:v>
                      </c:pt>
                      <c:pt idx="75">
                        <c:v>24</c:v>
                      </c:pt>
                      <c:pt idx="76">
                        <c:v>25</c:v>
                      </c:pt>
                      <c:pt idx="77">
                        <c:v>26</c:v>
                      </c:pt>
                      <c:pt idx="78">
                        <c:v>27</c:v>
                      </c:pt>
                      <c:pt idx="79">
                        <c:v>28</c:v>
                      </c:pt>
                      <c:pt idx="80">
                        <c:v>29</c:v>
                      </c:pt>
                      <c:pt idx="81">
                        <c:v>30</c:v>
                      </c:pt>
                      <c:pt idx="82">
                        <c:v>31</c:v>
                      </c:pt>
                      <c:pt idx="83">
                        <c:v>32</c:v>
                      </c:pt>
                      <c:pt idx="84">
                        <c:v>33</c:v>
                      </c:pt>
                      <c:pt idx="85">
                        <c:v>34</c:v>
                      </c:pt>
                      <c:pt idx="86">
                        <c:v>35</c:v>
                      </c:pt>
                      <c:pt idx="87">
                        <c:v>36</c:v>
                      </c:pt>
                      <c:pt idx="88">
                        <c:v>37</c:v>
                      </c:pt>
                      <c:pt idx="89">
                        <c:v>38</c:v>
                      </c:pt>
                      <c:pt idx="90">
                        <c:v>39</c:v>
                      </c:pt>
                      <c:pt idx="91">
                        <c:v>40</c:v>
                      </c:pt>
                      <c:pt idx="92">
                        <c:v>41</c:v>
                      </c:pt>
                      <c:pt idx="93">
                        <c:v>42</c:v>
                      </c:pt>
                      <c:pt idx="94">
                        <c:v>43</c:v>
                      </c:pt>
                      <c:pt idx="95">
                        <c:v>44</c:v>
                      </c:pt>
                      <c:pt idx="96">
                        <c:v>45</c:v>
                      </c:pt>
                      <c:pt idx="97">
                        <c:v>46</c:v>
                      </c:pt>
                      <c:pt idx="98">
                        <c:v>47</c:v>
                      </c:pt>
                      <c:pt idx="99">
                        <c:v>48</c:v>
                      </c:pt>
                      <c:pt idx="100">
                        <c:v>49</c:v>
                      </c:pt>
                      <c:pt idx="101">
                        <c:v>50</c:v>
                      </c:pt>
                      <c:pt idx="102">
                        <c:v>51</c:v>
                      </c:pt>
                      <c:pt idx="103">
                        <c:v>52</c:v>
                      </c:pt>
                      <c:pt idx="104">
                        <c:v>1</c:v>
                      </c:pt>
                      <c:pt idx="105">
                        <c:v>2</c:v>
                      </c:pt>
                      <c:pt idx="106">
                        <c:v>3</c:v>
                      </c:pt>
                      <c:pt idx="107">
                        <c:v>4</c:v>
                      </c:pt>
                      <c:pt idx="108">
                        <c:v>5</c:v>
                      </c:pt>
                      <c:pt idx="109">
                        <c:v>6</c:v>
                      </c:pt>
                      <c:pt idx="110">
                        <c:v>7</c:v>
                      </c:pt>
                      <c:pt idx="111">
                        <c:v>8</c:v>
                      </c:pt>
                      <c:pt idx="112">
                        <c:v>9</c:v>
                      </c:pt>
                      <c:pt idx="113">
                        <c:v>10</c:v>
                      </c:pt>
                      <c:pt idx="114">
                        <c:v>11</c:v>
                      </c:pt>
                      <c:pt idx="115">
                        <c:v>12</c:v>
                      </c:pt>
                      <c:pt idx="116">
                        <c:v>13</c:v>
                      </c:pt>
                      <c:pt idx="117">
                        <c:v>14</c:v>
                      </c:pt>
                      <c:pt idx="118">
                        <c:v>15</c:v>
                      </c:pt>
                      <c:pt idx="119">
                        <c:v>16</c:v>
                      </c:pt>
                      <c:pt idx="120">
                        <c:v>17</c:v>
                      </c:pt>
                      <c:pt idx="121">
                        <c:v>18</c:v>
                      </c:pt>
                      <c:pt idx="122">
                        <c:v>19</c:v>
                      </c:pt>
                      <c:pt idx="123">
                        <c:v>20</c:v>
                      </c:pt>
                      <c:pt idx="124">
                        <c:v>21</c:v>
                      </c:pt>
                      <c:pt idx="125">
                        <c:v>22</c:v>
                      </c:pt>
                      <c:pt idx="126">
                        <c:v>23</c:v>
                      </c:pt>
                      <c:pt idx="127">
                        <c:v>24</c:v>
                      </c:pt>
                      <c:pt idx="128">
                        <c:v>25</c:v>
                      </c:pt>
                      <c:pt idx="129">
                        <c:v>26</c:v>
                      </c:pt>
                      <c:pt idx="130">
                        <c:v>27</c:v>
                      </c:pt>
                      <c:pt idx="131">
                        <c:v>28</c:v>
                      </c:pt>
                      <c:pt idx="132">
                        <c:v>29</c:v>
                      </c:pt>
                      <c:pt idx="133">
                        <c:v>30</c:v>
                      </c:pt>
                      <c:pt idx="134">
                        <c:v>31</c:v>
                      </c:pt>
                      <c:pt idx="135">
                        <c:v>32</c:v>
                      </c:pt>
                      <c:pt idx="136">
                        <c:v>33</c:v>
                      </c:pt>
                      <c:pt idx="137">
                        <c:v>34</c:v>
                      </c:pt>
                      <c:pt idx="138">
                        <c:v>35</c:v>
                      </c:pt>
                      <c:pt idx="139">
                        <c:v>36</c:v>
                      </c:pt>
                      <c:pt idx="140">
                        <c:v>37</c:v>
                      </c:pt>
                      <c:pt idx="141">
                        <c:v>38</c:v>
                      </c:pt>
                      <c:pt idx="142">
                        <c:v>39</c:v>
                      </c:pt>
                      <c:pt idx="143">
                        <c:v>40</c:v>
                      </c:pt>
                      <c:pt idx="144">
                        <c:v>41</c:v>
                      </c:pt>
                      <c:pt idx="145">
                        <c:v>42</c:v>
                      </c:pt>
                      <c:pt idx="146">
                        <c:v>43</c:v>
                      </c:pt>
                      <c:pt idx="147">
                        <c:v>44</c:v>
                      </c:pt>
                      <c:pt idx="148">
                        <c:v>45</c:v>
                      </c:pt>
                      <c:pt idx="149">
                        <c:v>46</c:v>
                      </c:pt>
                      <c:pt idx="150">
                        <c:v>47</c:v>
                      </c:pt>
                      <c:pt idx="151">
                        <c:v>48</c:v>
                      </c:pt>
                      <c:pt idx="152">
                        <c:v>49</c:v>
                      </c:pt>
                      <c:pt idx="153">
                        <c:v>50</c:v>
                      </c:pt>
                      <c:pt idx="154">
                        <c:v>51</c:v>
                      </c:pt>
                      <c:pt idx="155">
                        <c:v>52</c:v>
                      </c:pt>
                      <c:pt idx="156">
                        <c:v>1</c:v>
                      </c:pt>
                      <c:pt idx="157">
                        <c:v>2</c:v>
                      </c:pt>
                      <c:pt idx="158">
                        <c:v>3</c:v>
                      </c:pt>
                      <c:pt idx="159">
                        <c:v>4</c:v>
                      </c:pt>
                      <c:pt idx="160">
                        <c:v>5</c:v>
                      </c:pt>
                      <c:pt idx="161">
                        <c:v>6</c:v>
                      </c:pt>
                      <c:pt idx="162">
                        <c:v>7</c:v>
                      </c:pt>
                      <c:pt idx="163">
                        <c:v>8</c:v>
                      </c:pt>
                      <c:pt idx="164">
                        <c:v>9</c:v>
                      </c:pt>
                      <c:pt idx="165">
                        <c:v>10</c:v>
                      </c:pt>
                      <c:pt idx="166">
                        <c:v>11</c:v>
                      </c:pt>
                      <c:pt idx="167">
                        <c:v>12</c:v>
                      </c:pt>
                      <c:pt idx="168">
                        <c:v>13</c:v>
                      </c:pt>
                      <c:pt idx="169">
                        <c:v>14</c:v>
                      </c:pt>
                      <c:pt idx="170">
                        <c:v>15</c:v>
                      </c:pt>
                      <c:pt idx="171">
                        <c:v>16</c:v>
                      </c:pt>
                      <c:pt idx="172">
                        <c:v>17</c:v>
                      </c:pt>
                      <c:pt idx="173">
                        <c:v>18</c:v>
                      </c:pt>
                      <c:pt idx="174">
                        <c:v>19</c:v>
                      </c:pt>
                      <c:pt idx="175">
                        <c:v>20</c:v>
                      </c:pt>
                      <c:pt idx="176">
                        <c:v>21</c:v>
                      </c:pt>
                      <c:pt idx="177">
                        <c:v>22</c:v>
                      </c:pt>
                      <c:pt idx="178">
                        <c:v>23</c:v>
                      </c:pt>
                      <c:pt idx="179">
                        <c:v>24</c:v>
                      </c:pt>
                      <c:pt idx="180">
                        <c:v>25</c:v>
                      </c:pt>
                      <c:pt idx="181">
                        <c:v>26</c:v>
                      </c:pt>
                      <c:pt idx="182">
                        <c:v>27</c:v>
                      </c:pt>
                      <c:pt idx="183">
                        <c:v>28</c:v>
                      </c:pt>
                      <c:pt idx="184">
                        <c:v>29</c:v>
                      </c:pt>
                      <c:pt idx="185">
                        <c:v>30</c:v>
                      </c:pt>
                      <c:pt idx="186">
                        <c:v>31</c:v>
                      </c:pt>
                      <c:pt idx="187">
                        <c:v>32</c:v>
                      </c:pt>
                      <c:pt idx="188">
                        <c:v>33</c:v>
                      </c:pt>
                      <c:pt idx="189">
                        <c:v>34</c:v>
                      </c:pt>
                      <c:pt idx="190">
                        <c:v>35</c:v>
                      </c:pt>
                      <c:pt idx="191">
                        <c:v>36</c:v>
                      </c:pt>
                      <c:pt idx="192">
                        <c:v>37</c:v>
                      </c:pt>
                      <c:pt idx="193">
                        <c:v>38</c:v>
                      </c:pt>
                      <c:pt idx="194">
                        <c:v>39</c:v>
                      </c:pt>
                      <c:pt idx="195">
                        <c:v>40</c:v>
                      </c:pt>
                      <c:pt idx="196">
                        <c:v>41</c:v>
                      </c:pt>
                      <c:pt idx="197">
                        <c:v>42</c:v>
                      </c:pt>
                      <c:pt idx="198">
                        <c:v>43</c:v>
                      </c:pt>
                      <c:pt idx="199">
                        <c:v>44</c:v>
                      </c:pt>
                      <c:pt idx="200">
                        <c:v>45</c:v>
                      </c:pt>
                      <c:pt idx="201">
                        <c:v>46</c:v>
                      </c:pt>
                      <c:pt idx="202">
                        <c:v>47</c:v>
                      </c:pt>
                      <c:pt idx="203">
                        <c:v>48</c:v>
                      </c:pt>
                      <c:pt idx="204">
                        <c:v>49</c:v>
                      </c:pt>
                      <c:pt idx="205">
                        <c:v>50</c:v>
                      </c:pt>
                      <c:pt idx="206">
                        <c:v>51</c:v>
                      </c:pt>
                      <c:pt idx="207">
                        <c:v>52</c:v>
                      </c:pt>
                      <c:pt idx="208">
                        <c:v>53</c:v>
                      </c:pt>
                      <c:pt idx="209">
                        <c:v>1</c:v>
                      </c:pt>
                      <c:pt idx="210">
                        <c:v>2</c:v>
                      </c:pt>
                      <c:pt idx="211">
                        <c:v>3</c:v>
                      </c:pt>
                      <c:pt idx="212">
                        <c:v>4</c:v>
                      </c:pt>
                      <c:pt idx="213">
                        <c:v>5</c:v>
                      </c:pt>
                      <c:pt idx="214">
                        <c:v>6</c:v>
                      </c:pt>
                      <c:pt idx="215">
                        <c:v>7</c:v>
                      </c:pt>
                      <c:pt idx="216">
                        <c:v>8</c:v>
                      </c:pt>
                      <c:pt idx="217">
                        <c:v>9</c:v>
                      </c:pt>
                      <c:pt idx="218">
                        <c:v>10</c:v>
                      </c:pt>
                      <c:pt idx="219">
                        <c:v>11</c:v>
                      </c:pt>
                      <c:pt idx="220">
                        <c:v>12</c:v>
                      </c:pt>
                      <c:pt idx="221">
                        <c:v>13</c:v>
                      </c:pt>
                      <c:pt idx="222">
                        <c:v>14</c:v>
                      </c:pt>
                      <c:pt idx="223">
                        <c:v>15</c:v>
                      </c:pt>
                      <c:pt idx="224">
                        <c:v>16</c:v>
                      </c:pt>
                      <c:pt idx="225">
                        <c:v>17</c:v>
                      </c:pt>
                      <c:pt idx="226">
                        <c:v>18</c:v>
                      </c:pt>
                      <c:pt idx="227">
                        <c:v>19</c:v>
                      </c:pt>
                      <c:pt idx="228">
                        <c:v>20</c:v>
                      </c:pt>
                      <c:pt idx="229">
                        <c:v>21</c:v>
                      </c:pt>
                      <c:pt idx="230">
                        <c:v>22</c:v>
                      </c:pt>
                      <c:pt idx="231">
                        <c:v>23</c:v>
                      </c:pt>
                      <c:pt idx="232">
                        <c:v>24</c:v>
                      </c:pt>
                      <c:pt idx="233">
                        <c:v>25</c:v>
                      </c:pt>
                      <c:pt idx="234">
                        <c:v>26</c:v>
                      </c:pt>
                      <c:pt idx="235">
                        <c:v>27</c:v>
                      </c:pt>
                      <c:pt idx="236">
                        <c:v>28</c:v>
                      </c:pt>
                      <c:pt idx="237">
                        <c:v>29</c:v>
                      </c:pt>
                      <c:pt idx="238">
                        <c:v>30</c:v>
                      </c:pt>
                      <c:pt idx="239">
                        <c:v>31</c:v>
                      </c:pt>
                      <c:pt idx="240">
                        <c:v>32</c:v>
                      </c:pt>
                      <c:pt idx="241">
                        <c:v>33</c:v>
                      </c:pt>
                      <c:pt idx="242">
                        <c:v>34</c:v>
                      </c:pt>
                      <c:pt idx="243">
                        <c:v>35</c:v>
                      </c:pt>
                      <c:pt idx="244">
                        <c:v>36</c:v>
                      </c:pt>
                      <c:pt idx="245">
                        <c:v>37</c:v>
                      </c:pt>
                      <c:pt idx="246">
                        <c:v>38</c:v>
                      </c:pt>
                      <c:pt idx="247">
                        <c:v>39</c:v>
                      </c:pt>
                      <c:pt idx="248">
                        <c:v>40</c:v>
                      </c:pt>
                      <c:pt idx="249">
                        <c:v>41</c:v>
                      </c:pt>
                      <c:pt idx="250">
                        <c:v>42</c:v>
                      </c:pt>
                      <c:pt idx="251">
                        <c:v>43</c:v>
                      </c:pt>
                      <c:pt idx="252">
                        <c:v>44</c:v>
                      </c:pt>
                      <c:pt idx="253">
                        <c:v>45</c:v>
                      </c:pt>
                      <c:pt idx="254">
                        <c:v>46</c:v>
                      </c:pt>
                      <c:pt idx="255">
                        <c:v>47</c:v>
                      </c:pt>
                      <c:pt idx="256">
                        <c:v>48</c:v>
                      </c:pt>
                      <c:pt idx="257">
                        <c:v>49</c:v>
                      </c:pt>
                      <c:pt idx="258">
                        <c:v>50</c:v>
                      </c:pt>
                      <c:pt idx="259">
                        <c:v>51</c:v>
                      </c:pt>
                      <c:pt idx="260">
                        <c:v>52</c:v>
                      </c:pt>
                      <c:pt idx="261">
                        <c:v>1</c:v>
                      </c:pt>
                      <c:pt idx="262">
                        <c:v>2</c:v>
                      </c:pt>
                      <c:pt idx="263">
                        <c:v>3</c:v>
                      </c:pt>
                      <c:pt idx="264">
                        <c:v>4</c:v>
                      </c:pt>
                      <c:pt idx="265">
                        <c:v>5</c:v>
                      </c:pt>
                      <c:pt idx="266">
                        <c:v>6</c:v>
                      </c:pt>
                      <c:pt idx="267">
                        <c:v>7</c:v>
                      </c:pt>
                      <c:pt idx="268">
                        <c:v>8</c:v>
                      </c:pt>
                      <c:pt idx="269">
                        <c:v>9</c:v>
                      </c:pt>
                      <c:pt idx="270">
                        <c:v>10</c:v>
                      </c:pt>
                      <c:pt idx="271">
                        <c:v>11</c:v>
                      </c:pt>
                      <c:pt idx="272">
                        <c:v>12</c:v>
                      </c:pt>
                      <c:pt idx="273">
                        <c:v>13</c:v>
                      </c:pt>
                      <c:pt idx="274">
                        <c:v>14</c:v>
                      </c:pt>
                      <c:pt idx="275">
                        <c:v>15</c:v>
                      </c:pt>
                      <c:pt idx="276">
                        <c:v>16</c:v>
                      </c:pt>
                      <c:pt idx="277">
                        <c:v>17</c:v>
                      </c:pt>
                      <c:pt idx="278">
                        <c:v>18</c:v>
                      </c:pt>
                      <c:pt idx="279">
                        <c:v>19</c:v>
                      </c:pt>
                      <c:pt idx="280">
                        <c:v>20</c:v>
                      </c:pt>
                      <c:pt idx="281">
                        <c:v>21</c:v>
                      </c:pt>
                      <c:pt idx="282">
                        <c:v>22</c:v>
                      </c:pt>
                      <c:pt idx="283">
                        <c:v>23</c:v>
                      </c:pt>
                      <c:pt idx="284">
                        <c:v>24</c:v>
                      </c:pt>
                      <c:pt idx="285">
                        <c:v>25</c:v>
                      </c:pt>
                      <c:pt idx="286">
                        <c:v>26</c:v>
                      </c:pt>
                      <c:pt idx="287">
                        <c:v>27</c:v>
                      </c:pt>
                      <c:pt idx="288">
                        <c:v>28</c:v>
                      </c:pt>
                      <c:pt idx="289">
                        <c:v>29</c:v>
                      </c:pt>
                      <c:pt idx="290">
                        <c:v>30</c:v>
                      </c:pt>
                      <c:pt idx="291">
                        <c:v>31</c:v>
                      </c:pt>
                      <c:pt idx="292">
                        <c:v>32</c:v>
                      </c:pt>
                      <c:pt idx="293">
                        <c:v>33</c:v>
                      </c:pt>
                      <c:pt idx="294">
                        <c:v>34</c:v>
                      </c:pt>
                      <c:pt idx="295">
                        <c:v>35</c:v>
                      </c:pt>
                      <c:pt idx="296">
                        <c:v>36</c:v>
                      </c:pt>
                      <c:pt idx="297">
                        <c:v>37</c:v>
                      </c:pt>
                      <c:pt idx="298">
                        <c:v>38</c:v>
                      </c:pt>
                      <c:pt idx="299">
                        <c:v>39</c:v>
                      </c:pt>
                      <c:pt idx="300">
                        <c:v>40</c:v>
                      </c:pt>
                      <c:pt idx="301">
                        <c:v>41</c:v>
                      </c:pt>
                      <c:pt idx="302">
                        <c:v>42</c:v>
                      </c:pt>
                      <c:pt idx="303">
                        <c:v>43</c:v>
                      </c:pt>
                      <c:pt idx="304">
                        <c:v>44</c:v>
                      </c:pt>
                      <c:pt idx="305">
                        <c:v>45</c:v>
                      </c:pt>
                      <c:pt idx="306">
                        <c:v>46</c:v>
                      </c:pt>
                      <c:pt idx="307">
                        <c:v>47</c:v>
                      </c:pt>
                      <c:pt idx="308">
                        <c:v>48</c:v>
                      </c:pt>
                      <c:pt idx="309">
                        <c:v>49</c:v>
                      </c:pt>
                      <c:pt idx="310">
                        <c:v>50</c:v>
                      </c:pt>
                      <c:pt idx="311">
                        <c:v>51</c:v>
                      </c:pt>
                      <c:pt idx="312">
                        <c:v>52</c:v>
                      </c:pt>
                    </c:numCache>
                  </c:num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Sheet1!$D$2:$D$314</c15:sqref>
                        </c15:formulaRef>
                      </c:ext>
                    </c:extLst>
                    <c:numCache>
                      <c:formatCode>General</c:formatCode>
                      <c:ptCount val="313"/>
                      <c:pt idx="0">
                        <c:v>-476.30411441895313</c:v>
                      </c:pt>
                      <c:pt idx="1">
                        <c:v>227.65040484683465</c:v>
                      </c:pt>
                      <c:pt idx="2">
                        <c:v>561.12247955824523</c:v>
                      </c:pt>
                      <c:pt idx="3">
                        <c:v>1511.5856927510479</c:v>
                      </c:pt>
                      <c:pt idx="4">
                        <c:v>1955.3712461747207</c:v>
                      </c:pt>
                      <c:pt idx="5">
                        <c:v>1074.3985010969291</c:v>
                      </c:pt>
                      <c:pt idx="6">
                        <c:v>925.41246374122272</c:v>
                      </c:pt>
                      <c:pt idx="7">
                        <c:v>947.62724550073779</c:v>
                      </c:pt>
                      <c:pt idx="8">
                        <c:v>947.50852633532691</c:v>
                      </c:pt>
                      <c:pt idx="9">
                        <c:v>880.08176476652818</c:v>
                      </c:pt>
                      <c:pt idx="10">
                        <c:v>621.87174894950692</c:v>
                      </c:pt>
                      <c:pt idx="11">
                        <c:v>283.96764395201814</c:v>
                      </c:pt>
                      <c:pt idx="12">
                        <c:v>386.96567995975937</c:v>
                      </c:pt>
                      <c:pt idx="13">
                        <c:v>301.10279252876938</c:v>
                      </c:pt>
                      <c:pt idx="14">
                        <c:v>196.95895002500612</c:v>
                      </c:pt>
                      <c:pt idx="15">
                        <c:v>176.47717583700896</c:v>
                      </c:pt>
                      <c:pt idx="16">
                        <c:v>62.351559145248046</c:v>
                      </c:pt>
                      <c:pt idx="17">
                        <c:v>-211.88144842627074</c:v>
                      </c:pt>
                      <c:pt idx="18">
                        <c:v>0</c:v>
                      </c:pt>
                      <c:pt idx="19">
                        <c:v>133.29918088468827</c:v>
                      </c:pt>
                      <c:pt idx="20">
                        <c:v>70.057144202965389</c:v>
                      </c:pt>
                      <c:pt idx="21">
                        <c:v>2.9338266866539371</c:v>
                      </c:pt>
                      <c:pt idx="22">
                        <c:v>38.557144202965347</c:v>
                      </c:pt>
                      <c:pt idx="23">
                        <c:v>-86.573070839694793</c:v>
                      </c:pt>
                      <c:pt idx="24">
                        <c:v>-51.093595827147468</c:v>
                      </c:pt>
                      <c:pt idx="25">
                        <c:v>-211.36995254902186</c:v>
                      </c:pt>
                      <c:pt idx="26">
                        <c:v>-222.3471283861191</c:v>
                      </c:pt>
                      <c:pt idx="27">
                        <c:v>-406.00706511803145</c:v>
                      </c:pt>
                      <c:pt idx="28">
                        <c:v>-672.26979437880163</c:v>
                      </c:pt>
                      <c:pt idx="29">
                        <c:v>-428.79475012556014</c:v>
                      </c:pt>
                      <c:pt idx="30">
                        <c:v>-235.20558505780522</c:v>
                      </c:pt>
                      <c:pt idx="31">
                        <c:v>-215.08456671694336</c:v>
                      </c:pt>
                      <c:pt idx="32">
                        <c:v>-226.06174255404093</c:v>
                      </c:pt>
                      <c:pt idx="33">
                        <c:v>47.796881709238605</c:v>
                      </c:pt>
                      <c:pt idx="34">
                        <c:v>96.086865892216252</c:v>
                      </c:pt>
                      <c:pt idx="35">
                        <c:v>91.538918390961314</c:v>
                      </c:pt>
                      <c:pt idx="36">
                        <c:v>-34.853858320874203</c:v>
                      </c:pt>
                      <c:pt idx="37">
                        <c:v>-154.43612586227977</c:v>
                      </c:pt>
                      <c:pt idx="38">
                        <c:v>31.557144202964949</c:v>
                      </c:pt>
                      <c:pt idx="39">
                        <c:v>111.61198923056891</c:v>
                      </c:pt>
                      <c:pt idx="40">
                        <c:v>-52.593595827148633</c:v>
                      </c:pt>
                      <c:pt idx="41">
                        <c:v>31.00919670171011</c:v>
                      </c:pt>
                      <c:pt idx="42">
                        <c:v>65.107390879669126</c:v>
                      </c:pt>
                      <c:pt idx="43">
                        <c:v>99.705585057628156</c:v>
                      </c:pt>
                      <c:pt idx="44">
                        <c:v>58.915600874650245</c:v>
                      </c:pt>
                      <c:pt idx="45">
                        <c:v>28.72151169418159</c:v>
                      </c:pt>
                      <c:pt idx="46">
                        <c:v>13.479475012458625</c:v>
                      </c:pt>
                      <c:pt idx="47">
                        <c:v>-56.102792528947141</c:v>
                      </c:pt>
                      <c:pt idx="48">
                        <c:v>-23.175863368553497</c:v>
                      </c:pt>
                      <c:pt idx="49">
                        <c:v>86.294414942194521</c:v>
                      </c:pt>
                      <c:pt idx="50">
                        <c:v>102.52938650597363</c:v>
                      </c:pt>
                      <c:pt idx="51">
                        <c:v>139.77355477155197</c:v>
                      </c:pt>
                      <c:pt idx="52">
                        <c:v>-476.30411441895313</c:v>
                      </c:pt>
                      <c:pt idx="53">
                        <c:v>227.65040484683465</c:v>
                      </c:pt>
                      <c:pt idx="54">
                        <c:v>561.12247955824523</c:v>
                      </c:pt>
                      <c:pt idx="55">
                        <c:v>1511.5856927510479</c:v>
                      </c:pt>
                      <c:pt idx="56">
                        <c:v>1955.3712461747207</c:v>
                      </c:pt>
                      <c:pt idx="57">
                        <c:v>1074.3985010969291</c:v>
                      </c:pt>
                      <c:pt idx="58">
                        <c:v>925.41246374122272</c:v>
                      </c:pt>
                      <c:pt idx="59">
                        <c:v>947.62724550073779</c:v>
                      </c:pt>
                      <c:pt idx="60">
                        <c:v>947.50852633532691</c:v>
                      </c:pt>
                      <c:pt idx="61">
                        <c:v>880.08176476652818</c:v>
                      </c:pt>
                      <c:pt idx="62">
                        <c:v>621.87174894950692</c:v>
                      </c:pt>
                      <c:pt idx="63">
                        <c:v>283.96764395201814</c:v>
                      </c:pt>
                      <c:pt idx="64">
                        <c:v>386.96567995975937</c:v>
                      </c:pt>
                      <c:pt idx="65">
                        <c:v>301.10279252876938</c:v>
                      </c:pt>
                      <c:pt idx="66">
                        <c:v>196.95895002500612</c:v>
                      </c:pt>
                      <c:pt idx="67">
                        <c:v>176.47717583700896</c:v>
                      </c:pt>
                      <c:pt idx="68">
                        <c:v>62.351559145248046</c:v>
                      </c:pt>
                      <c:pt idx="69">
                        <c:v>-211.88144842627074</c:v>
                      </c:pt>
                      <c:pt idx="70">
                        <c:v>0</c:v>
                      </c:pt>
                      <c:pt idx="71">
                        <c:v>133.29918088468827</c:v>
                      </c:pt>
                      <c:pt idx="72">
                        <c:v>70.057144202965389</c:v>
                      </c:pt>
                      <c:pt idx="73">
                        <c:v>2.9338266866539371</c:v>
                      </c:pt>
                      <c:pt idx="74">
                        <c:v>38.557144202965347</c:v>
                      </c:pt>
                      <c:pt idx="75">
                        <c:v>-86.573070839694793</c:v>
                      </c:pt>
                      <c:pt idx="76">
                        <c:v>-51.093595827147468</c:v>
                      </c:pt>
                      <c:pt idx="77">
                        <c:v>-211.36995254902186</c:v>
                      </c:pt>
                      <c:pt idx="78">
                        <c:v>-222.3471283861191</c:v>
                      </c:pt>
                      <c:pt idx="79">
                        <c:v>-406.00706511803145</c:v>
                      </c:pt>
                      <c:pt idx="80">
                        <c:v>-672.26979437880163</c:v>
                      </c:pt>
                      <c:pt idx="81">
                        <c:v>-428.79475012556014</c:v>
                      </c:pt>
                      <c:pt idx="82">
                        <c:v>-235.20558505780522</c:v>
                      </c:pt>
                      <c:pt idx="83">
                        <c:v>-215.08456671694336</c:v>
                      </c:pt>
                      <c:pt idx="84">
                        <c:v>-226.06174255404093</c:v>
                      </c:pt>
                      <c:pt idx="85">
                        <c:v>47.796881709238605</c:v>
                      </c:pt>
                      <c:pt idx="86">
                        <c:v>96.086865892216252</c:v>
                      </c:pt>
                      <c:pt idx="87">
                        <c:v>91.538918390961314</c:v>
                      </c:pt>
                      <c:pt idx="88">
                        <c:v>-34.853858320874203</c:v>
                      </c:pt>
                      <c:pt idx="89">
                        <c:v>-154.43612586227977</c:v>
                      </c:pt>
                      <c:pt idx="90">
                        <c:v>31.557144202964949</c:v>
                      </c:pt>
                      <c:pt idx="91">
                        <c:v>111.61198923056891</c:v>
                      </c:pt>
                      <c:pt idx="92">
                        <c:v>-52.593595827148633</c:v>
                      </c:pt>
                      <c:pt idx="93">
                        <c:v>31.00919670171011</c:v>
                      </c:pt>
                      <c:pt idx="94">
                        <c:v>65.107390879669126</c:v>
                      </c:pt>
                      <c:pt idx="95">
                        <c:v>99.705585057628156</c:v>
                      </c:pt>
                      <c:pt idx="96">
                        <c:v>58.915600874650245</c:v>
                      </c:pt>
                      <c:pt idx="97">
                        <c:v>28.72151169418159</c:v>
                      </c:pt>
                      <c:pt idx="98">
                        <c:v>13.479475012458625</c:v>
                      </c:pt>
                      <c:pt idx="99">
                        <c:v>-56.102792528947141</c:v>
                      </c:pt>
                      <c:pt idx="100">
                        <c:v>-23.175863368553497</c:v>
                      </c:pt>
                      <c:pt idx="101">
                        <c:v>86.294414942194521</c:v>
                      </c:pt>
                      <c:pt idx="102">
                        <c:v>102.52938650597363</c:v>
                      </c:pt>
                      <c:pt idx="103">
                        <c:v>139.77355477155197</c:v>
                      </c:pt>
                      <c:pt idx="104">
                        <c:v>-476.30411441895313</c:v>
                      </c:pt>
                      <c:pt idx="105">
                        <c:v>227.65040484683465</c:v>
                      </c:pt>
                      <c:pt idx="106">
                        <c:v>561.12247955824523</c:v>
                      </c:pt>
                      <c:pt idx="107">
                        <c:v>1511.5856927510479</c:v>
                      </c:pt>
                      <c:pt idx="108">
                        <c:v>1955.3712461747207</c:v>
                      </c:pt>
                      <c:pt idx="109">
                        <c:v>1074.3985010969291</c:v>
                      </c:pt>
                      <c:pt idx="110">
                        <c:v>925.41246374122272</c:v>
                      </c:pt>
                      <c:pt idx="111">
                        <c:v>947.62724550073779</c:v>
                      </c:pt>
                      <c:pt idx="112">
                        <c:v>947.50852633532691</c:v>
                      </c:pt>
                      <c:pt idx="113">
                        <c:v>880.08176476652818</c:v>
                      </c:pt>
                      <c:pt idx="114">
                        <c:v>621.87174894950692</c:v>
                      </c:pt>
                      <c:pt idx="115">
                        <c:v>283.96764395201814</c:v>
                      </c:pt>
                      <c:pt idx="116">
                        <c:v>386.96567995975937</c:v>
                      </c:pt>
                      <c:pt idx="117">
                        <c:v>301.10279252876938</c:v>
                      </c:pt>
                      <c:pt idx="118">
                        <c:v>196.95895002500612</c:v>
                      </c:pt>
                      <c:pt idx="119">
                        <c:v>176.47717583700896</c:v>
                      </c:pt>
                      <c:pt idx="120">
                        <c:v>62.351559145248046</c:v>
                      </c:pt>
                      <c:pt idx="121">
                        <c:v>-211.88144842627074</c:v>
                      </c:pt>
                      <c:pt idx="122">
                        <c:v>0</c:v>
                      </c:pt>
                      <c:pt idx="123">
                        <c:v>133.29918088468827</c:v>
                      </c:pt>
                      <c:pt idx="124">
                        <c:v>70.057144202965389</c:v>
                      </c:pt>
                      <c:pt idx="125">
                        <c:v>2.9338266866539371</c:v>
                      </c:pt>
                      <c:pt idx="126">
                        <c:v>38.557144202965347</c:v>
                      </c:pt>
                      <c:pt idx="127">
                        <c:v>-86.573070839694793</c:v>
                      </c:pt>
                      <c:pt idx="128">
                        <c:v>-51.093595827147468</c:v>
                      </c:pt>
                      <c:pt idx="129">
                        <c:v>-211.36995254902186</c:v>
                      </c:pt>
                      <c:pt idx="130">
                        <c:v>-222.3471283861191</c:v>
                      </c:pt>
                      <c:pt idx="131">
                        <c:v>-406.00706511803145</c:v>
                      </c:pt>
                      <c:pt idx="132">
                        <c:v>-672.26979437880163</c:v>
                      </c:pt>
                      <c:pt idx="133">
                        <c:v>-428.79475012556014</c:v>
                      </c:pt>
                      <c:pt idx="134">
                        <c:v>-235.20558505780522</c:v>
                      </c:pt>
                      <c:pt idx="135">
                        <c:v>-215.08456671694336</c:v>
                      </c:pt>
                      <c:pt idx="136">
                        <c:v>-226.06174255404093</c:v>
                      </c:pt>
                      <c:pt idx="137">
                        <c:v>47.796881709238605</c:v>
                      </c:pt>
                      <c:pt idx="138">
                        <c:v>96.086865892216252</c:v>
                      </c:pt>
                      <c:pt idx="139">
                        <c:v>91.538918390961314</c:v>
                      </c:pt>
                      <c:pt idx="140">
                        <c:v>-34.853858320874203</c:v>
                      </c:pt>
                      <c:pt idx="141">
                        <c:v>-154.43612586227977</c:v>
                      </c:pt>
                      <c:pt idx="142">
                        <c:v>31.557144202964949</c:v>
                      </c:pt>
                      <c:pt idx="143">
                        <c:v>111.61198923056891</c:v>
                      </c:pt>
                      <c:pt idx="144">
                        <c:v>-52.593595827148633</c:v>
                      </c:pt>
                      <c:pt idx="145">
                        <c:v>31.00919670171011</c:v>
                      </c:pt>
                      <c:pt idx="146">
                        <c:v>65.107390879669126</c:v>
                      </c:pt>
                      <c:pt idx="147">
                        <c:v>99.705585057628156</c:v>
                      </c:pt>
                      <c:pt idx="148">
                        <c:v>58.915600874650245</c:v>
                      </c:pt>
                      <c:pt idx="149">
                        <c:v>28.72151169418159</c:v>
                      </c:pt>
                      <c:pt idx="150">
                        <c:v>13.479475012458625</c:v>
                      </c:pt>
                      <c:pt idx="151">
                        <c:v>-56.102792528947141</c:v>
                      </c:pt>
                      <c:pt idx="152">
                        <c:v>-23.175863368553497</c:v>
                      </c:pt>
                      <c:pt idx="153">
                        <c:v>86.294414942194521</c:v>
                      </c:pt>
                      <c:pt idx="154">
                        <c:v>102.52938650597363</c:v>
                      </c:pt>
                      <c:pt idx="155">
                        <c:v>139.77355477155197</c:v>
                      </c:pt>
                      <c:pt idx="156">
                        <c:v>-476.30411441895313</c:v>
                      </c:pt>
                      <c:pt idx="157">
                        <c:v>227.65040484683465</c:v>
                      </c:pt>
                      <c:pt idx="158">
                        <c:v>561.12247955824523</c:v>
                      </c:pt>
                      <c:pt idx="159">
                        <c:v>1511.5856927510479</c:v>
                      </c:pt>
                      <c:pt idx="160">
                        <c:v>1955.3712461747207</c:v>
                      </c:pt>
                      <c:pt idx="161">
                        <c:v>1074.3985010969291</c:v>
                      </c:pt>
                      <c:pt idx="162">
                        <c:v>925.41246374122272</c:v>
                      </c:pt>
                      <c:pt idx="163">
                        <c:v>947.62724550073779</c:v>
                      </c:pt>
                      <c:pt idx="164">
                        <c:v>947.50852633532691</c:v>
                      </c:pt>
                      <c:pt idx="165">
                        <c:v>880.08176476652818</c:v>
                      </c:pt>
                      <c:pt idx="166">
                        <c:v>621.87174894950692</c:v>
                      </c:pt>
                      <c:pt idx="167">
                        <c:v>283.96764395201814</c:v>
                      </c:pt>
                      <c:pt idx="168">
                        <c:v>386.96567995975937</c:v>
                      </c:pt>
                      <c:pt idx="169">
                        <c:v>301.10279252876938</c:v>
                      </c:pt>
                      <c:pt idx="170">
                        <c:v>196.95895002500612</c:v>
                      </c:pt>
                      <c:pt idx="171">
                        <c:v>176.47717583700896</c:v>
                      </c:pt>
                      <c:pt idx="172">
                        <c:v>62.351559145248046</c:v>
                      </c:pt>
                      <c:pt idx="173">
                        <c:v>-211.88144842627074</c:v>
                      </c:pt>
                      <c:pt idx="174">
                        <c:v>0</c:v>
                      </c:pt>
                      <c:pt idx="175">
                        <c:v>133.29918088468827</c:v>
                      </c:pt>
                      <c:pt idx="176">
                        <c:v>70.057144202965389</c:v>
                      </c:pt>
                      <c:pt idx="177">
                        <c:v>2.9338266866539371</c:v>
                      </c:pt>
                      <c:pt idx="178">
                        <c:v>38.557144202965347</c:v>
                      </c:pt>
                      <c:pt idx="179">
                        <c:v>-86.573070839694793</c:v>
                      </c:pt>
                      <c:pt idx="180">
                        <c:v>-51.093595827147468</c:v>
                      </c:pt>
                      <c:pt idx="181">
                        <c:v>-211.36995254902186</c:v>
                      </c:pt>
                      <c:pt idx="182">
                        <c:v>-222.3471283861191</c:v>
                      </c:pt>
                      <c:pt idx="183">
                        <c:v>-406.00706511803145</c:v>
                      </c:pt>
                      <c:pt idx="184">
                        <c:v>-672.26979437880163</c:v>
                      </c:pt>
                      <c:pt idx="185">
                        <c:v>-428.79475012556014</c:v>
                      </c:pt>
                      <c:pt idx="186">
                        <c:v>-235.20558505780522</c:v>
                      </c:pt>
                      <c:pt idx="187">
                        <c:v>-215.08456671694336</c:v>
                      </c:pt>
                      <c:pt idx="188">
                        <c:v>-226.06174255404093</c:v>
                      </c:pt>
                      <c:pt idx="189">
                        <c:v>47.796881709238605</c:v>
                      </c:pt>
                      <c:pt idx="190">
                        <c:v>96.086865892216252</c:v>
                      </c:pt>
                      <c:pt idx="191">
                        <c:v>91.538918390961314</c:v>
                      </c:pt>
                      <c:pt idx="192">
                        <c:v>-34.853858320874203</c:v>
                      </c:pt>
                      <c:pt idx="193">
                        <c:v>-154.43612586227977</c:v>
                      </c:pt>
                      <c:pt idx="194">
                        <c:v>31.557144202964949</c:v>
                      </c:pt>
                      <c:pt idx="195">
                        <c:v>111.61198923056891</c:v>
                      </c:pt>
                      <c:pt idx="196">
                        <c:v>-52.593595827148633</c:v>
                      </c:pt>
                      <c:pt idx="197">
                        <c:v>31.00919670171011</c:v>
                      </c:pt>
                      <c:pt idx="198">
                        <c:v>65.107390879669126</c:v>
                      </c:pt>
                      <c:pt idx="199">
                        <c:v>99.705585057628156</c:v>
                      </c:pt>
                      <c:pt idx="200">
                        <c:v>58.915600874650245</c:v>
                      </c:pt>
                      <c:pt idx="201">
                        <c:v>28.72151169418159</c:v>
                      </c:pt>
                      <c:pt idx="202">
                        <c:v>13.479475012458625</c:v>
                      </c:pt>
                      <c:pt idx="203">
                        <c:v>-56.102792528947141</c:v>
                      </c:pt>
                      <c:pt idx="204">
                        <c:v>-23.175863368553497</c:v>
                      </c:pt>
                      <c:pt idx="205">
                        <c:v>86.294414942194521</c:v>
                      </c:pt>
                      <c:pt idx="206">
                        <c:v>102.52938650597363</c:v>
                      </c:pt>
                      <c:pt idx="207">
                        <c:v>139.77355477155197</c:v>
                      </c:pt>
                      <c:pt idx="208">
                        <c:v>-720.37258690766157</c:v>
                      </c:pt>
                      <c:pt idx="209">
                        <c:v>-476.30411441895313</c:v>
                      </c:pt>
                      <c:pt idx="210">
                        <c:v>227.65040484683465</c:v>
                      </c:pt>
                      <c:pt idx="211">
                        <c:v>561.12247955824523</c:v>
                      </c:pt>
                      <c:pt idx="212">
                        <c:v>1511.5856927510479</c:v>
                      </c:pt>
                      <c:pt idx="213">
                        <c:v>1955.3712461747207</c:v>
                      </c:pt>
                      <c:pt idx="214">
                        <c:v>1074.3985010969291</c:v>
                      </c:pt>
                      <c:pt idx="215">
                        <c:v>925.41246374122272</c:v>
                      </c:pt>
                      <c:pt idx="216">
                        <c:v>947.62724550073779</c:v>
                      </c:pt>
                      <c:pt idx="217">
                        <c:v>947.50852633532691</c:v>
                      </c:pt>
                      <c:pt idx="218">
                        <c:v>880.08176476652818</c:v>
                      </c:pt>
                      <c:pt idx="219">
                        <c:v>621.87174894950692</c:v>
                      </c:pt>
                      <c:pt idx="220">
                        <c:v>283.96764395201814</c:v>
                      </c:pt>
                      <c:pt idx="221">
                        <c:v>386.96567995975937</c:v>
                      </c:pt>
                      <c:pt idx="222">
                        <c:v>301.10279252876938</c:v>
                      </c:pt>
                      <c:pt idx="223">
                        <c:v>196.95895002500612</c:v>
                      </c:pt>
                      <c:pt idx="224">
                        <c:v>176.47717583700896</c:v>
                      </c:pt>
                      <c:pt idx="225">
                        <c:v>62.351559145248046</c:v>
                      </c:pt>
                      <c:pt idx="226">
                        <c:v>-211.88144842627074</c:v>
                      </c:pt>
                      <c:pt idx="227">
                        <c:v>0</c:v>
                      </c:pt>
                      <c:pt idx="228">
                        <c:v>133.29918088468827</c:v>
                      </c:pt>
                      <c:pt idx="229">
                        <c:v>70.057144202965389</c:v>
                      </c:pt>
                      <c:pt idx="230">
                        <c:v>2.9338266866539371</c:v>
                      </c:pt>
                      <c:pt idx="231">
                        <c:v>38.557144202965347</c:v>
                      </c:pt>
                      <c:pt idx="232">
                        <c:v>-86.573070839694793</c:v>
                      </c:pt>
                      <c:pt idx="233">
                        <c:v>-51.093595827147468</c:v>
                      </c:pt>
                      <c:pt idx="234">
                        <c:v>-211.36995254902186</c:v>
                      </c:pt>
                      <c:pt idx="235">
                        <c:v>-222.3471283861191</c:v>
                      </c:pt>
                      <c:pt idx="236">
                        <c:v>-406.00706511803145</c:v>
                      </c:pt>
                      <c:pt idx="237">
                        <c:v>-672.26979437880163</c:v>
                      </c:pt>
                      <c:pt idx="238">
                        <c:v>-428.79475012556014</c:v>
                      </c:pt>
                      <c:pt idx="239">
                        <c:v>-235.20558505780522</c:v>
                      </c:pt>
                      <c:pt idx="240">
                        <c:v>-215.08456671694336</c:v>
                      </c:pt>
                      <c:pt idx="241">
                        <c:v>-226.06174255404093</c:v>
                      </c:pt>
                      <c:pt idx="242">
                        <c:v>47.796881709238605</c:v>
                      </c:pt>
                      <c:pt idx="243">
                        <c:v>96.086865892216252</c:v>
                      </c:pt>
                      <c:pt idx="244">
                        <c:v>91.538918390961314</c:v>
                      </c:pt>
                      <c:pt idx="245">
                        <c:v>-34.853858320874203</c:v>
                      </c:pt>
                      <c:pt idx="246">
                        <c:v>-154.43612586227977</c:v>
                      </c:pt>
                      <c:pt idx="247">
                        <c:v>31.557144202964949</c:v>
                      </c:pt>
                      <c:pt idx="248">
                        <c:v>111.61198923056891</c:v>
                      </c:pt>
                      <c:pt idx="249">
                        <c:v>-52.593595827148633</c:v>
                      </c:pt>
                      <c:pt idx="250">
                        <c:v>31.00919670171011</c:v>
                      </c:pt>
                      <c:pt idx="251">
                        <c:v>65.107390879669126</c:v>
                      </c:pt>
                      <c:pt idx="252">
                        <c:v>99.705585057628156</c:v>
                      </c:pt>
                      <c:pt idx="253">
                        <c:v>58.915600874650245</c:v>
                      </c:pt>
                      <c:pt idx="254">
                        <c:v>28.72151169418159</c:v>
                      </c:pt>
                      <c:pt idx="255">
                        <c:v>13.479475012458625</c:v>
                      </c:pt>
                      <c:pt idx="256">
                        <c:v>-56.102792528947141</c:v>
                      </c:pt>
                      <c:pt idx="257">
                        <c:v>-23.175863368553497</c:v>
                      </c:pt>
                      <c:pt idx="258">
                        <c:v>86.294414942194521</c:v>
                      </c:pt>
                      <c:pt idx="259">
                        <c:v>102.52938650597363</c:v>
                      </c:pt>
                      <c:pt idx="260">
                        <c:v>139.77355477155197</c:v>
                      </c:pt>
                      <c:pt idx="261">
                        <c:v>-476.30411441895313</c:v>
                      </c:pt>
                      <c:pt idx="262">
                        <c:v>227.65040484683465</c:v>
                      </c:pt>
                      <c:pt idx="263">
                        <c:v>561.12247955824523</c:v>
                      </c:pt>
                      <c:pt idx="264">
                        <c:v>1511.5856927510479</c:v>
                      </c:pt>
                      <c:pt idx="265">
                        <c:v>1955.3712461747207</c:v>
                      </c:pt>
                      <c:pt idx="266">
                        <c:v>1074.3985010969291</c:v>
                      </c:pt>
                      <c:pt idx="267">
                        <c:v>925.41246374122272</c:v>
                      </c:pt>
                      <c:pt idx="268">
                        <c:v>947.62724550073779</c:v>
                      </c:pt>
                      <c:pt idx="269">
                        <c:v>947.50852633532691</c:v>
                      </c:pt>
                      <c:pt idx="270">
                        <c:v>880.08176476652818</c:v>
                      </c:pt>
                      <c:pt idx="271">
                        <c:v>621.87174894950692</c:v>
                      </c:pt>
                      <c:pt idx="272">
                        <c:v>283.96764395201814</c:v>
                      </c:pt>
                      <c:pt idx="273">
                        <c:v>386.96567995975937</c:v>
                      </c:pt>
                      <c:pt idx="274">
                        <c:v>301.10279252876938</c:v>
                      </c:pt>
                      <c:pt idx="275">
                        <c:v>196.95895002500612</c:v>
                      </c:pt>
                      <c:pt idx="276">
                        <c:v>176.47717583700896</c:v>
                      </c:pt>
                      <c:pt idx="277">
                        <c:v>62.351559145248046</c:v>
                      </c:pt>
                      <c:pt idx="278">
                        <c:v>-211.88144842627074</c:v>
                      </c:pt>
                      <c:pt idx="279">
                        <c:v>0</c:v>
                      </c:pt>
                      <c:pt idx="280">
                        <c:v>133.29918088468827</c:v>
                      </c:pt>
                      <c:pt idx="281">
                        <c:v>70.057144202965389</c:v>
                      </c:pt>
                      <c:pt idx="282">
                        <c:v>2.9338266866539371</c:v>
                      </c:pt>
                      <c:pt idx="283">
                        <c:v>38.557144202965347</c:v>
                      </c:pt>
                      <c:pt idx="284">
                        <c:v>-86.573070839694793</c:v>
                      </c:pt>
                      <c:pt idx="285">
                        <c:v>-51.093595827147468</c:v>
                      </c:pt>
                      <c:pt idx="286">
                        <c:v>-211.36995254902186</c:v>
                      </c:pt>
                      <c:pt idx="287">
                        <c:v>-222.3471283861191</c:v>
                      </c:pt>
                      <c:pt idx="288">
                        <c:v>-406.00706511803145</c:v>
                      </c:pt>
                      <c:pt idx="289">
                        <c:v>-672.26979437880163</c:v>
                      </c:pt>
                      <c:pt idx="290">
                        <c:v>-428.79475012556014</c:v>
                      </c:pt>
                      <c:pt idx="291">
                        <c:v>-235.20558505780522</c:v>
                      </c:pt>
                      <c:pt idx="292">
                        <c:v>-215.08456671694336</c:v>
                      </c:pt>
                      <c:pt idx="293">
                        <c:v>-226.06174255404093</c:v>
                      </c:pt>
                      <c:pt idx="294">
                        <c:v>47.796881709238605</c:v>
                      </c:pt>
                      <c:pt idx="295">
                        <c:v>96.086865892216252</c:v>
                      </c:pt>
                      <c:pt idx="296">
                        <c:v>91.538918390961314</c:v>
                      </c:pt>
                      <c:pt idx="297">
                        <c:v>-34.853858320874203</c:v>
                      </c:pt>
                      <c:pt idx="298">
                        <c:v>-154.43612586227977</c:v>
                      </c:pt>
                      <c:pt idx="299">
                        <c:v>31.557144202964949</c:v>
                      </c:pt>
                      <c:pt idx="300">
                        <c:v>111.61198923056891</c:v>
                      </c:pt>
                      <c:pt idx="301">
                        <c:v>-52.593595827148633</c:v>
                      </c:pt>
                      <c:pt idx="302">
                        <c:v>31.00919670171011</c:v>
                      </c:pt>
                      <c:pt idx="303">
                        <c:v>65.107390879669126</c:v>
                      </c:pt>
                      <c:pt idx="304">
                        <c:v>99.705585057628156</c:v>
                      </c:pt>
                      <c:pt idx="305">
                        <c:v>58.915600874650245</c:v>
                      </c:pt>
                      <c:pt idx="306">
                        <c:v>28.72151169418159</c:v>
                      </c:pt>
                      <c:pt idx="307">
                        <c:v>13.479475012458625</c:v>
                      </c:pt>
                      <c:pt idx="308">
                        <c:v>-56.102792528947141</c:v>
                      </c:pt>
                      <c:pt idx="309">
                        <c:v>-23.175863368553497</c:v>
                      </c:pt>
                      <c:pt idx="310">
                        <c:v>86.294414942194521</c:v>
                      </c:pt>
                      <c:pt idx="311">
                        <c:v>102.52938650597363</c:v>
                      </c:pt>
                      <c:pt idx="312">
                        <c:v>139.77355477155197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2-1B3D-4EC0-A8D6-5E64F831BF17}"/>
                  </c:ext>
                </c:extLst>
              </c15:ser>
            </c15:filteredLineSeries>
          </c:ext>
        </c:extLst>
      </c:lineChart>
      <c:catAx>
        <c:axId val="1627113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26116352"/>
        <c:crosses val="autoZero"/>
        <c:auto val="1"/>
        <c:lblAlgn val="ctr"/>
        <c:lblOffset val="100"/>
        <c:noMultiLvlLbl val="0"/>
      </c:catAx>
      <c:valAx>
        <c:axId val="16261163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Number of influenza cases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6271138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64405946173085094"/>
          <c:y val="0.87306911636045492"/>
          <c:w val="0.3543453786150203"/>
          <c:h val="0.1176716243802858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7701</cdr:x>
      <cdr:y>0.01822</cdr:y>
    </cdr:from>
    <cdr:to>
      <cdr:x>0.9879</cdr:x>
      <cdr:y>0.07407</cdr:y>
    </cdr:to>
    <cdr:sp macro="" textlink="">
      <cdr:nvSpPr>
        <cdr:cNvPr id="2" name="タイトル 2"/>
        <cdr:cNvSpPr>
          <a:spLocks xmlns:a="http://schemas.openxmlformats.org/drawingml/2006/main" noGrp="1"/>
        </cdr:cNvSpPr>
      </cdr:nvSpPr>
      <cdr:spPr>
        <a:xfrm xmlns:a="http://schemas.openxmlformats.org/drawingml/2006/main">
          <a:off x="889000" y="124980"/>
          <a:ext cx="10515600" cy="38302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="horz" lIns="91440" tIns="45720" rIns="91440" bIns="45720" rtlCol="0" anchor="ctr">
          <a:normAutofit fontScale="90000"/>
        </a:bodyPr>
        <a:lstStyle xmlns:a="http://schemas.openxmlformats.org/drawingml/2006/main">
          <a:lvl1pPr algn="l" defTabSz="914400" rtl="0" eaLnBrk="1" latinLnBrk="0" hangingPunct="1">
            <a:lnSpc>
              <a:spcPct val="90000"/>
            </a:lnSpc>
            <a:spcBef>
              <a:spcPct val="0"/>
            </a:spcBef>
            <a:buNone/>
            <a:defRPr kumimoji="1" sz="4400" kern="1200">
              <a:solidFill>
                <a:schemeClr val="tx1"/>
              </a:solidFill>
              <a:latin typeface="+mj-lt"/>
              <a:ea typeface="+mj-ea"/>
              <a:cs typeface="+mj-cs"/>
            </a:defRPr>
          </a:lvl1pPr>
        </a:lstStyle>
        <a:p xmlns:a="http://schemas.openxmlformats.org/drawingml/2006/main">
          <a:r>
            <a:rPr kumimoji="1" lang="en-US" altLang="ja-JP" smtClean="0">
              <a:latin typeface="Times New Roman" panose="02020603050405020304" pitchFamily="18" charset="0"/>
              <a:cs typeface="Times New Roman" panose="02020603050405020304" pitchFamily="18" charset="0"/>
            </a:rPr>
            <a:t>Sample Figure </a:t>
          </a:r>
          <a:r>
            <a:rPr kumimoji="1" lang="en-US" altLang="ja-JP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4</a:t>
          </a:r>
          <a:endParaRPr kumimoji="1" lang="ja-JP" altLang="en-US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172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3780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1738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74631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94660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7264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2367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8519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730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81842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8099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F659E-72B5-4085-BF8A-9C270345272E}" type="datetimeFigureOut">
              <a:rPr kumimoji="1" lang="ja-JP" altLang="en-US" smtClean="0"/>
              <a:t>2020/3/3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3C91EA-7BF7-4227-9012-E17BF64063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87615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/>
          <p:cNvGraphicFramePr/>
          <p:nvPr>
            <p:extLst>
              <p:ext uri="{D42A27DB-BD31-4B8C-83A1-F6EECF244321}">
                <p14:modId xmlns:p14="http://schemas.microsoft.com/office/powerpoint/2010/main" val="2710733042"/>
              </p:ext>
            </p:extLst>
          </p:nvPr>
        </p:nvGraphicFramePr>
        <p:xfrm>
          <a:off x="333375" y="0"/>
          <a:ext cx="11544299" cy="685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35122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0</Words>
  <Application>Microsoft Office PowerPoint</Application>
  <PresentationFormat>ワイド画面</PresentationFormat>
  <Paragraphs>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atayama Yusuke</dc:creator>
  <cp:lastModifiedBy>Katayama Yusuke</cp:lastModifiedBy>
  <cp:revision>8</cp:revision>
  <dcterms:created xsi:type="dcterms:W3CDTF">2020-03-26T05:47:16Z</dcterms:created>
  <dcterms:modified xsi:type="dcterms:W3CDTF">2020-03-31T06:41:54Z</dcterms:modified>
</cp:coreProperties>
</file>